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13"/>
  </p:notesMasterIdLst>
  <p:sldIdLst>
    <p:sldId id="256" r:id="rId5"/>
    <p:sldId id="288" r:id="rId6"/>
    <p:sldId id="289" r:id="rId7"/>
    <p:sldId id="270" r:id="rId8"/>
    <p:sldId id="273" r:id="rId9"/>
    <p:sldId id="274" r:id="rId10"/>
    <p:sldId id="263" r:id="rId11"/>
    <p:sldId id="287" r:id="rId12"/>
  </p:sldIdLst>
  <p:sldSz cx="12192000" cy="6858000"/>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73" d="100"/>
          <a:sy n="73" d="100"/>
        </p:scale>
        <p:origin x="66" y="34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notesMaster" Target="notesMasters/notesMaster1.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theme" Target="theme/theme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viewProps" Target="viewProps.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de-DE"/>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7FEDC02-EA22-4A5E-BE2E-63A8F66071C3}" type="datetimeFigureOut">
              <a:rPr lang="de-DE" smtClean="0"/>
              <a:t>11.11.2024</a:t>
            </a:fld>
            <a:endParaRPr lang="de-DE"/>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de-DE"/>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de-DE"/>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9314A3D-DBA8-495A-B69A-10E65B75F6BE}" type="slidenum">
              <a:rPr lang="de-DE" smtClean="0"/>
              <a:t>‹Nr.›</a:t>
            </a:fld>
            <a:endParaRPr lang="de-DE"/>
          </a:p>
        </p:txBody>
      </p:sp>
    </p:spTree>
    <p:extLst>
      <p:ext uri="{BB962C8B-B14F-4D97-AF65-F5344CB8AC3E}">
        <p14:creationId xmlns:p14="http://schemas.microsoft.com/office/powerpoint/2010/main" val="113360677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de-DE" dirty="0"/>
          </a:p>
        </p:txBody>
      </p:sp>
      <p:sp>
        <p:nvSpPr>
          <p:cNvPr id="4" name="Slide Number Placeholder 3"/>
          <p:cNvSpPr>
            <a:spLocks noGrp="1"/>
          </p:cNvSpPr>
          <p:nvPr>
            <p:ph type="sldNum" sz="quarter" idx="5"/>
          </p:nvPr>
        </p:nvSpPr>
        <p:spPr/>
        <p:txBody>
          <a:bodyPr/>
          <a:lstStyle/>
          <a:p>
            <a:fld id="{2AE9A6AC-DF24-2443-A2E7-9D030BF12946}" type="slidenum">
              <a:rPr lang="de-DE" smtClean="0"/>
              <a:t>4</a:t>
            </a:fld>
            <a:endParaRPr lang="de-DE"/>
          </a:p>
        </p:txBody>
      </p:sp>
    </p:spTree>
    <p:extLst>
      <p:ext uri="{BB962C8B-B14F-4D97-AF65-F5344CB8AC3E}">
        <p14:creationId xmlns:p14="http://schemas.microsoft.com/office/powerpoint/2010/main" val="233749000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de-CH" dirty="0"/>
          </a:p>
        </p:txBody>
      </p:sp>
      <p:sp>
        <p:nvSpPr>
          <p:cNvPr id="4" name="Foliennummernplatzhalter 3"/>
          <p:cNvSpPr>
            <a:spLocks noGrp="1"/>
          </p:cNvSpPr>
          <p:nvPr>
            <p:ph type="sldNum" sz="quarter" idx="5"/>
          </p:nvPr>
        </p:nvSpPr>
        <p:spPr/>
        <p:txBody>
          <a:bodyPr/>
          <a:lstStyle/>
          <a:p>
            <a:fld id="{2AE9A6AC-DF24-2443-A2E7-9D030BF12946}" type="slidenum">
              <a:rPr lang="de-DE" smtClean="0"/>
              <a:t>8</a:t>
            </a:fld>
            <a:endParaRPr lang="de-DE"/>
          </a:p>
        </p:txBody>
      </p:sp>
    </p:spTree>
    <p:extLst>
      <p:ext uri="{BB962C8B-B14F-4D97-AF65-F5344CB8AC3E}">
        <p14:creationId xmlns:p14="http://schemas.microsoft.com/office/powerpoint/2010/main" val="34920618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0B7CAF-885D-422F-8F22-ECAAD994754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de-DE"/>
          </a:p>
        </p:txBody>
      </p:sp>
      <p:sp>
        <p:nvSpPr>
          <p:cNvPr id="3" name="Subtitle 2">
            <a:extLst>
              <a:ext uri="{FF2B5EF4-FFF2-40B4-BE49-F238E27FC236}">
                <a16:creationId xmlns:a16="http://schemas.microsoft.com/office/drawing/2014/main" id="{B7006FCB-3631-464F-BE08-93DC933AC71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de-DE"/>
          </a:p>
        </p:txBody>
      </p:sp>
      <p:sp>
        <p:nvSpPr>
          <p:cNvPr id="4" name="Date Placeholder 3">
            <a:extLst>
              <a:ext uri="{FF2B5EF4-FFF2-40B4-BE49-F238E27FC236}">
                <a16:creationId xmlns:a16="http://schemas.microsoft.com/office/drawing/2014/main" id="{DE0E47F1-DB6A-4034-B17D-4A07FA7BE646}"/>
              </a:ext>
            </a:extLst>
          </p:cNvPr>
          <p:cNvSpPr>
            <a:spLocks noGrp="1"/>
          </p:cNvSpPr>
          <p:nvPr>
            <p:ph type="dt" sz="half" idx="10"/>
          </p:nvPr>
        </p:nvSpPr>
        <p:spPr/>
        <p:txBody>
          <a:bodyPr/>
          <a:lstStyle/>
          <a:p>
            <a:fld id="{AE08E161-E9B9-4625-A775-C63924A68DD0}" type="datetimeFigureOut">
              <a:rPr lang="de-DE" smtClean="0"/>
              <a:t>11.11.2024</a:t>
            </a:fld>
            <a:endParaRPr lang="de-DE"/>
          </a:p>
        </p:txBody>
      </p:sp>
      <p:sp>
        <p:nvSpPr>
          <p:cNvPr id="5" name="Footer Placeholder 4">
            <a:extLst>
              <a:ext uri="{FF2B5EF4-FFF2-40B4-BE49-F238E27FC236}">
                <a16:creationId xmlns:a16="http://schemas.microsoft.com/office/drawing/2014/main" id="{4D1A0A50-91F4-49C5-BB01-9889E8257D44}"/>
              </a:ext>
            </a:extLst>
          </p:cNvPr>
          <p:cNvSpPr>
            <a:spLocks noGrp="1"/>
          </p:cNvSpPr>
          <p:nvPr>
            <p:ph type="ftr" sz="quarter" idx="11"/>
          </p:nvPr>
        </p:nvSpPr>
        <p:spPr/>
        <p:txBody>
          <a:bodyPr/>
          <a:lstStyle/>
          <a:p>
            <a:endParaRPr lang="de-DE"/>
          </a:p>
        </p:txBody>
      </p:sp>
      <p:sp>
        <p:nvSpPr>
          <p:cNvPr id="6" name="Slide Number Placeholder 5">
            <a:extLst>
              <a:ext uri="{FF2B5EF4-FFF2-40B4-BE49-F238E27FC236}">
                <a16:creationId xmlns:a16="http://schemas.microsoft.com/office/drawing/2014/main" id="{4AA1FDEE-55A8-44A2-B5CD-96C81426CBF1}"/>
              </a:ext>
            </a:extLst>
          </p:cNvPr>
          <p:cNvSpPr>
            <a:spLocks noGrp="1"/>
          </p:cNvSpPr>
          <p:nvPr>
            <p:ph type="sldNum" sz="quarter" idx="12"/>
          </p:nvPr>
        </p:nvSpPr>
        <p:spPr/>
        <p:txBody>
          <a:bodyPr/>
          <a:lstStyle/>
          <a:p>
            <a:fld id="{BD2F98E1-A9A7-436C-BABF-4DD4C4C5C0A0}" type="slidenum">
              <a:rPr lang="de-DE" smtClean="0"/>
              <a:t>‹Nr.›</a:t>
            </a:fld>
            <a:endParaRPr lang="de-DE"/>
          </a:p>
        </p:txBody>
      </p:sp>
    </p:spTree>
    <p:extLst>
      <p:ext uri="{BB962C8B-B14F-4D97-AF65-F5344CB8AC3E}">
        <p14:creationId xmlns:p14="http://schemas.microsoft.com/office/powerpoint/2010/main" val="23586688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D15BCB-5239-4D30-837F-79D80025D4EB}"/>
              </a:ext>
            </a:extLst>
          </p:cNvPr>
          <p:cNvSpPr>
            <a:spLocks noGrp="1"/>
          </p:cNvSpPr>
          <p:nvPr>
            <p:ph type="title"/>
          </p:nvPr>
        </p:nvSpPr>
        <p:spPr/>
        <p:txBody>
          <a:bodyPr/>
          <a:lstStyle/>
          <a:p>
            <a:r>
              <a:rPr lang="en-US"/>
              <a:t>Click to edit Master title style</a:t>
            </a:r>
            <a:endParaRPr lang="de-DE"/>
          </a:p>
        </p:txBody>
      </p:sp>
      <p:sp>
        <p:nvSpPr>
          <p:cNvPr id="3" name="Vertical Text Placeholder 2">
            <a:extLst>
              <a:ext uri="{FF2B5EF4-FFF2-40B4-BE49-F238E27FC236}">
                <a16:creationId xmlns:a16="http://schemas.microsoft.com/office/drawing/2014/main" id="{EAD3429B-404D-4317-AAE2-E4E63F39188D}"/>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4" name="Date Placeholder 3">
            <a:extLst>
              <a:ext uri="{FF2B5EF4-FFF2-40B4-BE49-F238E27FC236}">
                <a16:creationId xmlns:a16="http://schemas.microsoft.com/office/drawing/2014/main" id="{95D4D776-A86A-4246-8C1D-5228489E4F78}"/>
              </a:ext>
            </a:extLst>
          </p:cNvPr>
          <p:cNvSpPr>
            <a:spLocks noGrp="1"/>
          </p:cNvSpPr>
          <p:nvPr>
            <p:ph type="dt" sz="half" idx="10"/>
          </p:nvPr>
        </p:nvSpPr>
        <p:spPr/>
        <p:txBody>
          <a:bodyPr/>
          <a:lstStyle/>
          <a:p>
            <a:fld id="{AE08E161-E9B9-4625-A775-C63924A68DD0}" type="datetimeFigureOut">
              <a:rPr lang="de-DE" smtClean="0"/>
              <a:t>11.11.2024</a:t>
            </a:fld>
            <a:endParaRPr lang="de-DE"/>
          </a:p>
        </p:txBody>
      </p:sp>
      <p:sp>
        <p:nvSpPr>
          <p:cNvPr id="5" name="Footer Placeholder 4">
            <a:extLst>
              <a:ext uri="{FF2B5EF4-FFF2-40B4-BE49-F238E27FC236}">
                <a16:creationId xmlns:a16="http://schemas.microsoft.com/office/drawing/2014/main" id="{CE369E79-9182-4BBB-8C1F-A9A4F6256141}"/>
              </a:ext>
            </a:extLst>
          </p:cNvPr>
          <p:cNvSpPr>
            <a:spLocks noGrp="1"/>
          </p:cNvSpPr>
          <p:nvPr>
            <p:ph type="ftr" sz="quarter" idx="11"/>
          </p:nvPr>
        </p:nvSpPr>
        <p:spPr/>
        <p:txBody>
          <a:bodyPr/>
          <a:lstStyle/>
          <a:p>
            <a:endParaRPr lang="de-DE"/>
          </a:p>
        </p:txBody>
      </p:sp>
      <p:sp>
        <p:nvSpPr>
          <p:cNvPr id="6" name="Slide Number Placeholder 5">
            <a:extLst>
              <a:ext uri="{FF2B5EF4-FFF2-40B4-BE49-F238E27FC236}">
                <a16:creationId xmlns:a16="http://schemas.microsoft.com/office/drawing/2014/main" id="{E3F7A12B-0BCD-4711-A8CB-19E054051457}"/>
              </a:ext>
            </a:extLst>
          </p:cNvPr>
          <p:cNvSpPr>
            <a:spLocks noGrp="1"/>
          </p:cNvSpPr>
          <p:nvPr>
            <p:ph type="sldNum" sz="quarter" idx="12"/>
          </p:nvPr>
        </p:nvSpPr>
        <p:spPr/>
        <p:txBody>
          <a:bodyPr/>
          <a:lstStyle/>
          <a:p>
            <a:fld id="{BD2F98E1-A9A7-436C-BABF-4DD4C4C5C0A0}" type="slidenum">
              <a:rPr lang="de-DE" smtClean="0"/>
              <a:t>‹Nr.›</a:t>
            </a:fld>
            <a:endParaRPr lang="de-DE"/>
          </a:p>
        </p:txBody>
      </p:sp>
    </p:spTree>
    <p:extLst>
      <p:ext uri="{BB962C8B-B14F-4D97-AF65-F5344CB8AC3E}">
        <p14:creationId xmlns:p14="http://schemas.microsoft.com/office/powerpoint/2010/main" val="62783918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A3ABF4E-C3AC-4DA1-9610-735A5DF9B4B4}"/>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de-DE"/>
          </a:p>
        </p:txBody>
      </p:sp>
      <p:sp>
        <p:nvSpPr>
          <p:cNvPr id="3" name="Vertical Text Placeholder 2">
            <a:extLst>
              <a:ext uri="{FF2B5EF4-FFF2-40B4-BE49-F238E27FC236}">
                <a16:creationId xmlns:a16="http://schemas.microsoft.com/office/drawing/2014/main" id="{56E5BDFC-9D3D-47DE-89D0-D3B8795EDCF5}"/>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4" name="Date Placeholder 3">
            <a:extLst>
              <a:ext uri="{FF2B5EF4-FFF2-40B4-BE49-F238E27FC236}">
                <a16:creationId xmlns:a16="http://schemas.microsoft.com/office/drawing/2014/main" id="{B9DF4CC8-B99D-442B-A112-D3E8903EA47E}"/>
              </a:ext>
            </a:extLst>
          </p:cNvPr>
          <p:cNvSpPr>
            <a:spLocks noGrp="1"/>
          </p:cNvSpPr>
          <p:nvPr>
            <p:ph type="dt" sz="half" idx="10"/>
          </p:nvPr>
        </p:nvSpPr>
        <p:spPr/>
        <p:txBody>
          <a:bodyPr/>
          <a:lstStyle/>
          <a:p>
            <a:fld id="{AE08E161-E9B9-4625-A775-C63924A68DD0}" type="datetimeFigureOut">
              <a:rPr lang="de-DE" smtClean="0"/>
              <a:t>11.11.2024</a:t>
            </a:fld>
            <a:endParaRPr lang="de-DE"/>
          </a:p>
        </p:txBody>
      </p:sp>
      <p:sp>
        <p:nvSpPr>
          <p:cNvPr id="5" name="Footer Placeholder 4">
            <a:extLst>
              <a:ext uri="{FF2B5EF4-FFF2-40B4-BE49-F238E27FC236}">
                <a16:creationId xmlns:a16="http://schemas.microsoft.com/office/drawing/2014/main" id="{DA237069-FE2C-41FF-8ABB-E81937D2491A}"/>
              </a:ext>
            </a:extLst>
          </p:cNvPr>
          <p:cNvSpPr>
            <a:spLocks noGrp="1"/>
          </p:cNvSpPr>
          <p:nvPr>
            <p:ph type="ftr" sz="quarter" idx="11"/>
          </p:nvPr>
        </p:nvSpPr>
        <p:spPr/>
        <p:txBody>
          <a:bodyPr/>
          <a:lstStyle/>
          <a:p>
            <a:endParaRPr lang="de-DE"/>
          </a:p>
        </p:txBody>
      </p:sp>
      <p:sp>
        <p:nvSpPr>
          <p:cNvPr id="6" name="Slide Number Placeholder 5">
            <a:extLst>
              <a:ext uri="{FF2B5EF4-FFF2-40B4-BE49-F238E27FC236}">
                <a16:creationId xmlns:a16="http://schemas.microsoft.com/office/drawing/2014/main" id="{2B1E210A-B291-4C83-91B1-833A2421F06A}"/>
              </a:ext>
            </a:extLst>
          </p:cNvPr>
          <p:cNvSpPr>
            <a:spLocks noGrp="1"/>
          </p:cNvSpPr>
          <p:nvPr>
            <p:ph type="sldNum" sz="quarter" idx="12"/>
          </p:nvPr>
        </p:nvSpPr>
        <p:spPr/>
        <p:txBody>
          <a:bodyPr/>
          <a:lstStyle/>
          <a:p>
            <a:fld id="{BD2F98E1-A9A7-436C-BABF-4DD4C4C5C0A0}" type="slidenum">
              <a:rPr lang="de-DE" smtClean="0"/>
              <a:t>‹Nr.›</a:t>
            </a:fld>
            <a:endParaRPr lang="de-DE"/>
          </a:p>
        </p:txBody>
      </p:sp>
    </p:spTree>
    <p:extLst>
      <p:ext uri="{BB962C8B-B14F-4D97-AF65-F5344CB8AC3E}">
        <p14:creationId xmlns:p14="http://schemas.microsoft.com/office/powerpoint/2010/main" val="32416792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492CD9-1DF4-4046-9EF4-C409C0148BE8}"/>
              </a:ext>
            </a:extLst>
          </p:cNvPr>
          <p:cNvSpPr>
            <a:spLocks noGrp="1"/>
          </p:cNvSpPr>
          <p:nvPr>
            <p:ph type="title"/>
          </p:nvPr>
        </p:nvSpPr>
        <p:spPr/>
        <p:txBody>
          <a:bodyPr/>
          <a:lstStyle/>
          <a:p>
            <a:r>
              <a:rPr lang="en-US"/>
              <a:t>Click to edit Master title style</a:t>
            </a:r>
            <a:endParaRPr lang="de-DE"/>
          </a:p>
        </p:txBody>
      </p:sp>
      <p:sp>
        <p:nvSpPr>
          <p:cNvPr id="3" name="Content Placeholder 2">
            <a:extLst>
              <a:ext uri="{FF2B5EF4-FFF2-40B4-BE49-F238E27FC236}">
                <a16:creationId xmlns:a16="http://schemas.microsoft.com/office/drawing/2014/main" id="{2DC400DD-C196-469A-B49A-F8ADE293BFE9}"/>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4" name="Date Placeholder 3">
            <a:extLst>
              <a:ext uri="{FF2B5EF4-FFF2-40B4-BE49-F238E27FC236}">
                <a16:creationId xmlns:a16="http://schemas.microsoft.com/office/drawing/2014/main" id="{8056AEA5-03FF-43F3-8CEF-611AF5402944}"/>
              </a:ext>
            </a:extLst>
          </p:cNvPr>
          <p:cNvSpPr>
            <a:spLocks noGrp="1"/>
          </p:cNvSpPr>
          <p:nvPr>
            <p:ph type="dt" sz="half" idx="10"/>
          </p:nvPr>
        </p:nvSpPr>
        <p:spPr/>
        <p:txBody>
          <a:bodyPr/>
          <a:lstStyle/>
          <a:p>
            <a:fld id="{AE08E161-E9B9-4625-A775-C63924A68DD0}" type="datetimeFigureOut">
              <a:rPr lang="de-DE" smtClean="0"/>
              <a:t>11.11.2024</a:t>
            </a:fld>
            <a:endParaRPr lang="de-DE"/>
          </a:p>
        </p:txBody>
      </p:sp>
      <p:sp>
        <p:nvSpPr>
          <p:cNvPr id="5" name="Footer Placeholder 4">
            <a:extLst>
              <a:ext uri="{FF2B5EF4-FFF2-40B4-BE49-F238E27FC236}">
                <a16:creationId xmlns:a16="http://schemas.microsoft.com/office/drawing/2014/main" id="{1E4695D2-7E98-4716-8872-F011BB59772D}"/>
              </a:ext>
            </a:extLst>
          </p:cNvPr>
          <p:cNvSpPr>
            <a:spLocks noGrp="1"/>
          </p:cNvSpPr>
          <p:nvPr>
            <p:ph type="ftr" sz="quarter" idx="11"/>
          </p:nvPr>
        </p:nvSpPr>
        <p:spPr/>
        <p:txBody>
          <a:bodyPr/>
          <a:lstStyle/>
          <a:p>
            <a:endParaRPr lang="de-DE"/>
          </a:p>
        </p:txBody>
      </p:sp>
      <p:sp>
        <p:nvSpPr>
          <p:cNvPr id="6" name="Slide Number Placeholder 5">
            <a:extLst>
              <a:ext uri="{FF2B5EF4-FFF2-40B4-BE49-F238E27FC236}">
                <a16:creationId xmlns:a16="http://schemas.microsoft.com/office/drawing/2014/main" id="{274A5CD3-81C4-4338-8F23-1CA9389FB6E2}"/>
              </a:ext>
            </a:extLst>
          </p:cNvPr>
          <p:cNvSpPr>
            <a:spLocks noGrp="1"/>
          </p:cNvSpPr>
          <p:nvPr>
            <p:ph type="sldNum" sz="quarter" idx="12"/>
          </p:nvPr>
        </p:nvSpPr>
        <p:spPr/>
        <p:txBody>
          <a:bodyPr/>
          <a:lstStyle/>
          <a:p>
            <a:fld id="{BD2F98E1-A9A7-436C-BABF-4DD4C4C5C0A0}" type="slidenum">
              <a:rPr lang="de-DE" smtClean="0"/>
              <a:t>‹Nr.›</a:t>
            </a:fld>
            <a:endParaRPr lang="de-DE"/>
          </a:p>
        </p:txBody>
      </p:sp>
    </p:spTree>
    <p:extLst>
      <p:ext uri="{BB962C8B-B14F-4D97-AF65-F5344CB8AC3E}">
        <p14:creationId xmlns:p14="http://schemas.microsoft.com/office/powerpoint/2010/main" val="271576072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82CD7DA-114B-4A49-9CE9-56F170E64E1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de-DE"/>
          </a:p>
        </p:txBody>
      </p:sp>
      <p:sp>
        <p:nvSpPr>
          <p:cNvPr id="3" name="Text Placeholder 2">
            <a:extLst>
              <a:ext uri="{FF2B5EF4-FFF2-40B4-BE49-F238E27FC236}">
                <a16:creationId xmlns:a16="http://schemas.microsoft.com/office/drawing/2014/main" id="{53030F78-5BB7-4DA9-A054-A8E667B980A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B3FF9CB-D5B2-4DFB-96EB-2BFE12703E49}"/>
              </a:ext>
            </a:extLst>
          </p:cNvPr>
          <p:cNvSpPr>
            <a:spLocks noGrp="1"/>
          </p:cNvSpPr>
          <p:nvPr>
            <p:ph type="dt" sz="half" idx="10"/>
          </p:nvPr>
        </p:nvSpPr>
        <p:spPr/>
        <p:txBody>
          <a:bodyPr/>
          <a:lstStyle/>
          <a:p>
            <a:fld id="{AE08E161-E9B9-4625-A775-C63924A68DD0}" type="datetimeFigureOut">
              <a:rPr lang="de-DE" smtClean="0"/>
              <a:t>11.11.2024</a:t>
            </a:fld>
            <a:endParaRPr lang="de-DE"/>
          </a:p>
        </p:txBody>
      </p:sp>
      <p:sp>
        <p:nvSpPr>
          <p:cNvPr id="5" name="Footer Placeholder 4">
            <a:extLst>
              <a:ext uri="{FF2B5EF4-FFF2-40B4-BE49-F238E27FC236}">
                <a16:creationId xmlns:a16="http://schemas.microsoft.com/office/drawing/2014/main" id="{F3B0849E-9E7D-4E33-B3BB-4F6C55858BFC}"/>
              </a:ext>
            </a:extLst>
          </p:cNvPr>
          <p:cNvSpPr>
            <a:spLocks noGrp="1"/>
          </p:cNvSpPr>
          <p:nvPr>
            <p:ph type="ftr" sz="quarter" idx="11"/>
          </p:nvPr>
        </p:nvSpPr>
        <p:spPr/>
        <p:txBody>
          <a:bodyPr/>
          <a:lstStyle/>
          <a:p>
            <a:endParaRPr lang="de-DE"/>
          </a:p>
        </p:txBody>
      </p:sp>
      <p:sp>
        <p:nvSpPr>
          <p:cNvPr id="6" name="Slide Number Placeholder 5">
            <a:extLst>
              <a:ext uri="{FF2B5EF4-FFF2-40B4-BE49-F238E27FC236}">
                <a16:creationId xmlns:a16="http://schemas.microsoft.com/office/drawing/2014/main" id="{DA0DC6EC-68C7-4AB8-A434-3EB1448CD9D6}"/>
              </a:ext>
            </a:extLst>
          </p:cNvPr>
          <p:cNvSpPr>
            <a:spLocks noGrp="1"/>
          </p:cNvSpPr>
          <p:nvPr>
            <p:ph type="sldNum" sz="quarter" idx="12"/>
          </p:nvPr>
        </p:nvSpPr>
        <p:spPr/>
        <p:txBody>
          <a:bodyPr/>
          <a:lstStyle/>
          <a:p>
            <a:fld id="{BD2F98E1-A9A7-436C-BABF-4DD4C4C5C0A0}" type="slidenum">
              <a:rPr lang="de-DE" smtClean="0"/>
              <a:t>‹Nr.›</a:t>
            </a:fld>
            <a:endParaRPr lang="de-DE"/>
          </a:p>
        </p:txBody>
      </p:sp>
    </p:spTree>
    <p:extLst>
      <p:ext uri="{BB962C8B-B14F-4D97-AF65-F5344CB8AC3E}">
        <p14:creationId xmlns:p14="http://schemas.microsoft.com/office/powerpoint/2010/main" val="361850382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BEF242-32E1-4E0B-9E3F-227ED6544AE2}"/>
              </a:ext>
            </a:extLst>
          </p:cNvPr>
          <p:cNvSpPr>
            <a:spLocks noGrp="1"/>
          </p:cNvSpPr>
          <p:nvPr>
            <p:ph type="title"/>
          </p:nvPr>
        </p:nvSpPr>
        <p:spPr/>
        <p:txBody>
          <a:bodyPr/>
          <a:lstStyle/>
          <a:p>
            <a:r>
              <a:rPr lang="en-US"/>
              <a:t>Click to edit Master title style</a:t>
            </a:r>
            <a:endParaRPr lang="de-DE"/>
          </a:p>
        </p:txBody>
      </p:sp>
      <p:sp>
        <p:nvSpPr>
          <p:cNvPr id="3" name="Content Placeholder 2">
            <a:extLst>
              <a:ext uri="{FF2B5EF4-FFF2-40B4-BE49-F238E27FC236}">
                <a16:creationId xmlns:a16="http://schemas.microsoft.com/office/drawing/2014/main" id="{75411EF7-5DFA-4505-8DED-09E4B5CE9F48}"/>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4" name="Content Placeholder 3">
            <a:extLst>
              <a:ext uri="{FF2B5EF4-FFF2-40B4-BE49-F238E27FC236}">
                <a16:creationId xmlns:a16="http://schemas.microsoft.com/office/drawing/2014/main" id="{7404A9C4-42D9-4763-B0B7-4D66348E0F14}"/>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5" name="Date Placeholder 4">
            <a:extLst>
              <a:ext uri="{FF2B5EF4-FFF2-40B4-BE49-F238E27FC236}">
                <a16:creationId xmlns:a16="http://schemas.microsoft.com/office/drawing/2014/main" id="{1F2833E1-1563-445E-A1ED-A7029CDEC9CE}"/>
              </a:ext>
            </a:extLst>
          </p:cNvPr>
          <p:cNvSpPr>
            <a:spLocks noGrp="1"/>
          </p:cNvSpPr>
          <p:nvPr>
            <p:ph type="dt" sz="half" idx="10"/>
          </p:nvPr>
        </p:nvSpPr>
        <p:spPr/>
        <p:txBody>
          <a:bodyPr/>
          <a:lstStyle/>
          <a:p>
            <a:fld id="{AE08E161-E9B9-4625-A775-C63924A68DD0}" type="datetimeFigureOut">
              <a:rPr lang="de-DE" smtClean="0"/>
              <a:t>11.11.2024</a:t>
            </a:fld>
            <a:endParaRPr lang="de-DE"/>
          </a:p>
        </p:txBody>
      </p:sp>
      <p:sp>
        <p:nvSpPr>
          <p:cNvPr id="6" name="Footer Placeholder 5">
            <a:extLst>
              <a:ext uri="{FF2B5EF4-FFF2-40B4-BE49-F238E27FC236}">
                <a16:creationId xmlns:a16="http://schemas.microsoft.com/office/drawing/2014/main" id="{284F23E7-2BBA-4727-A571-7195DB5215B8}"/>
              </a:ext>
            </a:extLst>
          </p:cNvPr>
          <p:cNvSpPr>
            <a:spLocks noGrp="1"/>
          </p:cNvSpPr>
          <p:nvPr>
            <p:ph type="ftr" sz="quarter" idx="11"/>
          </p:nvPr>
        </p:nvSpPr>
        <p:spPr/>
        <p:txBody>
          <a:bodyPr/>
          <a:lstStyle/>
          <a:p>
            <a:endParaRPr lang="de-DE"/>
          </a:p>
        </p:txBody>
      </p:sp>
      <p:sp>
        <p:nvSpPr>
          <p:cNvPr id="7" name="Slide Number Placeholder 6">
            <a:extLst>
              <a:ext uri="{FF2B5EF4-FFF2-40B4-BE49-F238E27FC236}">
                <a16:creationId xmlns:a16="http://schemas.microsoft.com/office/drawing/2014/main" id="{1756353D-CEED-411A-A361-1603C3BF52E6}"/>
              </a:ext>
            </a:extLst>
          </p:cNvPr>
          <p:cNvSpPr>
            <a:spLocks noGrp="1"/>
          </p:cNvSpPr>
          <p:nvPr>
            <p:ph type="sldNum" sz="quarter" idx="12"/>
          </p:nvPr>
        </p:nvSpPr>
        <p:spPr/>
        <p:txBody>
          <a:bodyPr/>
          <a:lstStyle/>
          <a:p>
            <a:fld id="{BD2F98E1-A9A7-436C-BABF-4DD4C4C5C0A0}" type="slidenum">
              <a:rPr lang="de-DE" smtClean="0"/>
              <a:t>‹Nr.›</a:t>
            </a:fld>
            <a:endParaRPr lang="de-DE"/>
          </a:p>
        </p:txBody>
      </p:sp>
    </p:spTree>
    <p:extLst>
      <p:ext uri="{BB962C8B-B14F-4D97-AF65-F5344CB8AC3E}">
        <p14:creationId xmlns:p14="http://schemas.microsoft.com/office/powerpoint/2010/main" val="229386346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62B7A61-3721-4A2F-A800-4AC7DC568340}"/>
              </a:ext>
            </a:extLst>
          </p:cNvPr>
          <p:cNvSpPr>
            <a:spLocks noGrp="1"/>
          </p:cNvSpPr>
          <p:nvPr>
            <p:ph type="title"/>
          </p:nvPr>
        </p:nvSpPr>
        <p:spPr>
          <a:xfrm>
            <a:off x="839788" y="365125"/>
            <a:ext cx="10515600" cy="1325563"/>
          </a:xfrm>
        </p:spPr>
        <p:txBody>
          <a:bodyPr/>
          <a:lstStyle/>
          <a:p>
            <a:r>
              <a:rPr lang="en-US"/>
              <a:t>Click to edit Master title style</a:t>
            </a:r>
            <a:endParaRPr lang="de-DE"/>
          </a:p>
        </p:txBody>
      </p:sp>
      <p:sp>
        <p:nvSpPr>
          <p:cNvPr id="3" name="Text Placeholder 2">
            <a:extLst>
              <a:ext uri="{FF2B5EF4-FFF2-40B4-BE49-F238E27FC236}">
                <a16:creationId xmlns:a16="http://schemas.microsoft.com/office/drawing/2014/main" id="{E71AEB3D-E5B8-4D65-A64C-939AC9608D9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F220C91-A2C6-48AC-A0F9-0E95FE54594E}"/>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5" name="Text Placeholder 4">
            <a:extLst>
              <a:ext uri="{FF2B5EF4-FFF2-40B4-BE49-F238E27FC236}">
                <a16:creationId xmlns:a16="http://schemas.microsoft.com/office/drawing/2014/main" id="{B4865A6A-9875-4C2E-877A-CA9DE4CCD35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25DA859-B2DD-4256-9AA9-4C7D6CED768C}"/>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7" name="Date Placeholder 6">
            <a:extLst>
              <a:ext uri="{FF2B5EF4-FFF2-40B4-BE49-F238E27FC236}">
                <a16:creationId xmlns:a16="http://schemas.microsoft.com/office/drawing/2014/main" id="{64693E85-F029-45AE-BA5D-DB82A62B224E}"/>
              </a:ext>
            </a:extLst>
          </p:cNvPr>
          <p:cNvSpPr>
            <a:spLocks noGrp="1"/>
          </p:cNvSpPr>
          <p:nvPr>
            <p:ph type="dt" sz="half" idx="10"/>
          </p:nvPr>
        </p:nvSpPr>
        <p:spPr/>
        <p:txBody>
          <a:bodyPr/>
          <a:lstStyle/>
          <a:p>
            <a:fld id="{AE08E161-E9B9-4625-A775-C63924A68DD0}" type="datetimeFigureOut">
              <a:rPr lang="de-DE" smtClean="0"/>
              <a:t>11.11.2024</a:t>
            </a:fld>
            <a:endParaRPr lang="de-DE"/>
          </a:p>
        </p:txBody>
      </p:sp>
      <p:sp>
        <p:nvSpPr>
          <p:cNvPr id="8" name="Footer Placeholder 7">
            <a:extLst>
              <a:ext uri="{FF2B5EF4-FFF2-40B4-BE49-F238E27FC236}">
                <a16:creationId xmlns:a16="http://schemas.microsoft.com/office/drawing/2014/main" id="{B1373035-AD7D-43A2-BE5B-6BE4EAAC506D}"/>
              </a:ext>
            </a:extLst>
          </p:cNvPr>
          <p:cNvSpPr>
            <a:spLocks noGrp="1"/>
          </p:cNvSpPr>
          <p:nvPr>
            <p:ph type="ftr" sz="quarter" idx="11"/>
          </p:nvPr>
        </p:nvSpPr>
        <p:spPr/>
        <p:txBody>
          <a:bodyPr/>
          <a:lstStyle/>
          <a:p>
            <a:endParaRPr lang="de-DE"/>
          </a:p>
        </p:txBody>
      </p:sp>
      <p:sp>
        <p:nvSpPr>
          <p:cNvPr id="9" name="Slide Number Placeholder 8">
            <a:extLst>
              <a:ext uri="{FF2B5EF4-FFF2-40B4-BE49-F238E27FC236}">
                <a16:creationId xmlns:a16="http://schemas.microsoft.com/office/drawing/2014/main" id="{EA4D46B0-D596-4C7E-8CDA-B6E96A5A11EC}"/>
              </a:ext>
            </a:extLst>
          </p:cNvPr>
          <p:cNvSpPr>
            <a:spLocks noGrp="1"/>
          </p:cNvSpPr>
          <p:nvPr>
            <p:ph type="sldNum" sz="quarter" idx="12"/>
          </p:nvPr>
        </p:nvSpPr>
        <p:spPr/>
        <p:txBody>
          <a:bodyPr/>
          <a:lstStyle/>
          <a:p>
            <a:fld id="{BD2F98E1-A9A7-436C-BABF-4DD4C4C5C0A0}" type="slidenum">
              <a:rPr lang="de-DE" smtClean="0"/>
              <a:t>‹Nr.›</a:t>
            </a:fld>
            <a:endParaRPr lang="de-DE"/>
          </a:p>
        </p:txBody>
      </p:sp>
    </p:spTree>
    <p:extLst>
      <p:ext uri="{BB962C8B-B14F-4D97-AF65-F5344CB8AC3E}">
        <p14:creationId xmlns:p14="http://schemas.microsoft.com/office/powerpoint/2010/main" val="141221012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20C57B-4ACC-4F35-B6A9-82EA5027D923}"/>
              </a:ext>
            </a:extLst>
          </p:cNvPr>
          <p:cNvSpPr>
            <a:spLocks noGrp="1"/>
          </p:cNvSpPr>
          <p:nvPr>
            <p:ph type="title"/>
          </p:nvPr>
        </p:nvSpPr>
        <p:spPr/>
        <p:txBody>
          <a:bodyPr/>
          <a:lstStyle/>
          <a:p>
            <a:r>
              <a:rPr lang="en-US"/>
              <a:t>Click to edit Master title style</a:t>
            </a:r>
            <a:endParaRPr lang="de-DE"/>
          </a:p>
        </p:txBody>
      </p:sp>
      <p:sp>
        <p:nvSpPr>
          <p:cNvPr id="3" name="Date Placeholder 2">
            <a:extLst>
              <a:ext uri="{FF2B5EF4-FFF2-40B4-BE49-F238E27FC236}">
                <a16:creationId xmlns:a16="http://schemas.microsoft.com/office/drawing/2014/main" id="{7380B6F8-CC0B-42BD-8809-54CB6DEE4606}"/>
              </a:ext>
            </a:extLst>
          </p:cNvPr>
          <p:cNvSpPr>
            <a:spLocks noGrp="1"/>
          </p:cNvSpPr>
          <p:nvPr>
            <p:ph type="dt" sz="half" idx="10"/>
          </p:nvPr>
        </p:nvSpPr>
        <p:spPr/>
        <p:txBody>
          <a:bodyPr/>
          <a:lstStyle/>
          <a:p>
            <a:fld id="{AE08E161-E9B9-4625-A775-C63924A68DD0}" type="datetimeFigureOut">
              <a:rPr lang="de-DE" smtClean="0"/>
              <a:t>11.11.2024</a:t>
            </a:fld>
            <a:endParaRPr lang="de-DE"/>
          </a:p>
        </p:txBody>
      </p:sp>
      <p:sp>
        <p:nvSpPr>
          <p:cNvPr id="4" name="Footer Placeholder 3">
            <a:extLst>
              <a:ext uri="{FF2B5EF4-FFF2-40B4-BE49-F238E27FC236}">
                <a16:creationId xmlns:a16="http://schemas.microsoft.com/office/drawing/2014/main" id="{FA9AD727-D3D6-4D75-8373-4489F614A15D}"/>
              </a:ext>
            </a:extLst>
          </p:cNvPr>
          <p:cNvSpPr>
            <a:spLocks noGrp="1"/>
          </p:cNvSpPr>
          <p:nvPr>
            <p:ph type="ftr" sz="quarter" idx="11"/>
          </p:nvPr>
        </p:nvSpPr>
        <p:spPr/>
        <p:txBody>
          <a:bodyPr/>
          <a:lstStyle/>
          <a:p>
            <a:endParaRPr lang="de-DE"/>
          </a:p>
        </p:txBody>
      </p:sp>
      <p:sp>
        <p:nvSpPr>
          <p:cNvPr id="5" name="Slide Number Placeholder 4">
            <a:extLst>
              <a:ext uri="{FF2B5EF4-FFF2-40B4-BE49-F238E27FC236}">
                <a16:creationId xmlns:a16="http://schemas.microsoft.com/office/drawing/2014/main" id="{88DBCA42-44BB-45DF-93DC-85A30D1E5D25}"/>
              </a:ext>
            </a:extLst>
          </p:cNvPr>
          <p:cNvSpPr>
            <a:spLocks noGrp="1"/>
          </p:cNvSpPr>
          <p:nvPr>
            <p:ph type="sldNum" sz="quarter" idx="12"/>
          </p:nvPr>
        </p:nvSpPr>
        <p:spPr/>
        <p:txBody>
          <a:bodyPr/>
          <a:lstStyle/>
          <a:p>
            <a:fld id="{BD2F98E1-A9A7-436C-BABF-4DD4C4C5C0A0}" type="slidenum">
              <a:rPr lang="de-DE" smtClean="0"/>
              <a:t>‹Nr.›</a:t>
            </a:fld>
            <a:endParaRPr lang="de-DE"/>
          </a:p>
        </p:txBody>
      </p:sp>
    </p:spTree>
    <p:extLst>
      <p:ext uri="{BB962C8B-B14F-4D97-AF65-F5344CB8AC3E}">
        <p14:creationId xmlns:p14="http://schemas.microsoft.com/office/powerpoint/2010/main" val="415123972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6E51E05-5FD3-4611-974D-77E67FD4A181}"/>
              </a:ext>
            </a:extLst>
          </p:cNvPr>
          <p:cNvSpPr>
            <a:spLocks noGrp="1"/>
          </p:cNvSpPr>
          <p:nvPr>
            <p:ph type="dt" sz="half" idx="10"/>
          </p:nvPr>
        </p:nvSpPr>
        <p:spPr/>
        <p:txBody>
          <a:bodyPr/>
          <a:lstStyle/>
          <a:p>
            <a:fld id="{AE08E161-E9B9-4625-A775-C63924A68DD0}" type="datetimeFigureOut">
              <a:rPr lang="de-DE" smtClean="0"/>
              <a:t>11.11.2024</a:t>
            </a:fld>
            <a:endParaRPr lang="de-DE"/>
          </a:p>
        </p:txBody>
      </p:sp>
      <p:sp>
        <p:nvSpPr>
          <p:cNvPr id="3" name="Footer Placeholder 2">
            <a:extLst>
              <a:ext uri="{FF2B5EF4-FFF2-40B4-BE49-F238E27FC236}">
                <a16:creationId xmlns:a16="http://schemas.microsoft.com/office/drawing/2014/main" id="{03DE573C-722D-4181-856F-E0471680767B}"/>
              </a:ext>
            </a:extLst>
          </p:cNvPr>
          <p:cNvSpPr>
            <a:spLocks noGrp="1"/>
          </p:cNvSpPr>
          <p:nvPr>
            <p:ph type="ftr" sz="quarter" idx="11"/>
          </p:nvPr>
        </p:nvSpPr>
        <p:spPr/>
        <p:txBody>
          <a:bodyPr/>
          <a:lstStyle/>
          <a:p>
            <a:endParaRPr lang="de-DE"/>
          </a:p>
        </p:txBody>
      </p:sp>
      <p:sp>
        <p:nvSpPr>
          <p:cNvPr id="4" name="Slide Number Placeholder 3">
            <a:extLst>
              <a:ext uri="{FF2B5EF4-FFF2-40B4-BE49-F238E27FC236}">
                <a16:creationId xmlns:a16="http://schemas.microsoft.com/office/drawing/2014/main" id="{EE179D1F-39A3-4618-B162-E7867D0DB1A9}"/>
              </a:ext>
            </a:extLst>
          </p:cNvPr>
          <p:cNvSpPr>
            <a:spLocks noGrp="1"/>
          </p:cNvSpPr>
          <p:nvPr>
            <p:ph type="sldNum" sz="quarter" idx="12"/>
          </p:nvPr>
        </p:nvSpPr>
        <p:spPr/>
        <p:txBody>
          <a:bodyPr/>
          <a:lstStyle/>
          <a:p>
            <a:fld id="{BD2F98E1-A9A7-436C-BABF-4DD4C4C5C0A0}" type="slidenum">
              <a:rPr lang="de-DE" smtClean="0"/>
              <a:t>‹Nr.›</a:t>
            </a:fld>
            <a:endParaRPr lang="de-DE"/>
          </a:p>
        </p:txBody>
      </p:sp>
    </p:spTree>
    <p:extLst>
      <p:ext uri="{BB962C8B-B14F-4D97-AF65-F5344CB8AC3E}">
        <p14:creationId xmlns:p14="http://schemas.microsoft.com/office/powerpoint/2010/main" val="29341620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CAA60D-6053-4303-8E0D-493B550BC74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de-DE"/>
          </a:p>
        </p:txBody>
      </p:sp>
      <p:sp>
        <p:nvSpPr>
          <p:cNvPr id="3" name="Content Placeholder 2">
            <a:extLst>
              <a:ext uri="{FF2B5EF4-FFF2-40B4-BE49-F238E27FC236}">
                <a16:creationId xmlns:a16="http://schemas.microsoft.com/office/drawing/2014/main" id="{A5EF6ECC-B768-4B03-B590-E6FD94D1863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4" name="Text Placeholder 3">
            <a:extLst>
              <a:ext uri="{FF2B5EF4-FFF2-40B4-BE49-F238E27FC236}">
                <a16:creationId xmlns:a16="http://schemas.microsoft.com/office/drawing/2014/main" id="{DEDFBB18-433C-45DD-AEFD-A9316F63AA3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D39B1A3-6287-4E68-B681-CB312F843722}"/>
              </a:ext>
            </a:extLst>
          </p:cNvPr>
          <p:cNvSpPr>
            <a:spLocks noGrp="1"/>
          </p:cNvSpPr>
          <p:nvPr>
            <p:ph type="dt" sz="half" idx="10"/>
          </p:nvPr>
        </p:nvSpPr>
        <p:spPr/>
        <p:txBody>
          <a:bodyPr/>
          <a:lstStyle/>
          <a:p>
            <a:fld id="{AE08E161-E9B9-4625-A775-C63924A68DD0}" type="datetimeFigureOut">
              <a:rPr lang="de-DE" smtClean="0"/>
              <a:t>11.11.2024</a:t>
            </a:fld>
            <a:endParaRPr lang="de-DE"/>
          </a:p>
        </p:txBody>
      </p:sp>
      <p:sp>
        <p:nvSpPr>
          <p:cNvPr id="6" name="Footer Placeholder 5">
            <a:extLst>
              <a:ext uri="{FF2B5EF4-FFF2-40B4-BE49-F238E27FC236}">
                <a16:creationId xmlns:a16="http://schemas.microsoft.com/office/drawing/2014/main" id="{C306A6E3-9738-490D-A7A1-90ABF259DCDA}"/>
              </a:ext>
            </a:extLst>
          </p:cNvPr>
          <p:cNvSpPr>
            <a:spLocks noGrp="1"/>
          </p:cNvSpPr>
          <p:nvPr>
            <p:ph type="ftr" sz="quarter" idx="11"/>
          </p:nvPr>
        </p:nvSpPr>
        <p:spPr/>
        <p:txBody>
          <a:bodyPr/>
          <a:lstStyle/>
          <a:p>
            <a:endParaRPr lang="de-DE"/>
          </a:p>
        </p:txBody>
      </p:sp>
      <p:sp>
        <p:nvSpPr>
          <p:cNvPr id="7" name="Slide Number Placeholder 6">
            <a:extLst>
              <a:ext uri="{FF2B5EF4-FFF2-40B4-BE49-F238E27FC236}">
                <a16:creationId xmlns:a16="http://schemas.microsoft.com/office/drawing/2014/main" id="{DA783D52-7CE6-426F-AA49-CDA2752F00F0}"/>
              </a:ext>
            </a:extLst>
          </p:cNvPr>
          <p:cNvSpPr>
            <a:spLocks noGrp="1"/>
          </p:cNvSpPr>
          <p:nvPr>
            <p:ph type="sldNum" sz="quarter" idx="12"/>
          </p:nvPr>
        </p:nvSpPr>
        <p:spPr/>
        <p:txBody>
          <a:bodyPr/>
          <a:lstStyle/>
          <a:p>
            <a:fld id="{BD2F98E1-A9A7-436C-BABF-4DD4C4C5C0A0}" type="slidenum">
              <a:rPr lang="de-DE" smtClean="0"/>
              <a:t>‹Nr.›</a:t>
            </a:fld>
            <a:endParaRPr lang="de-DE"/>
          </a:p>
        </p:txBody>
      </p:sp>
    </p:spTree>
    <p:extLst>
      <p:ext uri="{BB962C8B-B14F-4D97-AF65-F5344CB8AC3E}">
        <p14:creationId xmlns:p14="http://schemas.microsoft.com/office/powerpoint/2010/main" val="265551059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39B376-2159-4B8B-B4CA-408E969329A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de-DE"/>
          </a:p>
        </p:txBody>
      </p:sp>
      <p:sp>
        <p:nvSpPr>
          <p:cNvPr id="3" name="Picture Placeholder 2">
            <a:extLst>
              <a:ext uri="{FF2B5EF4-FFF2-40B4-BE49-F238E27FC236}">
                <a16:creationId xmlns:a16="http://schemas.microsoft.com/office/drawing/2014/main" id="{01F08E2F-7333-43D3-B2A6-F7726FC1D88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 Placeholder 3">
            <a:extLst>
              <a:ext uri="{FF2B5EF4-FFF2-40B4-BE49-F238E27FC236}">
                <a16:creationId xmlns:a16="http://schemas.microsoft.com/office/drawing/2014/main" id="{807C1ABF-F27B-429D-82CE-59DF073E16F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2E72AEA-FBB1-488E-A42E-28CDE7D529DA}"/>
              </a:ext>
            </a:extLst>
          </p:cNvPr>
          <p:cNvSpPr>
            <a:spLocks noGrp="1"/>
          </p:cNvSpPr>
          <p:nvPr>
            <p:ph type="dt" sz="half" idx="10"/>
          </p:nvPr>
        </p:nvSpPr>
        <p:spPr/>
        <p:txBody>
          <a:bodyPr/>
          <a:lstStyle/>
          <a:p>
            <a:fld id="{AE08E161-E9B9-4625-A775-C63924A68DD0}" type="datetimeFigureOut">
              <a:rPr lang="de-DE" smtClean="0"/>
              <a:t>11.11.2024</a:t>
            </a:fld>
            <a:endParaRPr lang="de-DE"/>
          </a:p>
        </p:txBody>
      </p:sp>
      <p:sp>
        <p:nvSpPr>
          <p:cNvPr id="6" name="Footer Placeholder 5">
            <a:extLst>
              <a:ext uri="{FF2B5EF4-FFF2-40B4-BE49-F238E27FC236}">
                <a16:creationId xmlns:a16="http://schemas.microsoft.com/office/drawing/2014/main" id="{6AB45268-5456-46A0-8FD2-A7338E8EE8D2}"/>
              </a:ext>
            </a:extLst>
          </p:cNvPr>
          <p:cNvSpPr>
            <a:spLocks noGrp="1"/>
          </p:cNvSpPr>
          <p:nvPr>
            <p:ph type="ftr" sz="quarter" idx="11"/>
          </p:nvPr>
        </p:nvSpPr>
        <p:spPr/>
        <p:txBody>
          <a:bodyPr/>
          <a:lstStyle/>
          <a:p>
            <a:endParaRPr lang="de-DE"/>
          </a:p>
        </p:txBody>
      </p:sp>
      <p:sp>
        <p:nvSpPr>
          <p:cNvPr id="7" name="Slide Number Placeholder 6">
            <a:extLst>
              <a:ext uri="{FF2B5EF4-FFF2-40B4-BE49-F238E27FC236}">
                <a16:creationId xmlns:a16="http://schemas.microsoft.com/office/drawing/2014/main" id="{47AC7154-7ACB-484C-88C9-8DD9E2CACA23}"/>
              </a:ext>
            </a:extLst>
          </p:cNvPr>
          <p:cNvSpPr>
            <a:spLocks noGrp="1"/>
          </p:cNvSpPr>
          <p:nvPr>
            <p:ph type="sldNum" sz="quarter" idx="12"/>
          </p:nvPr>
        </p:nvSpPr>
        <p:spPr/>
        <p:txBody>
          <a:bodyPr/>
          <a:lstStyle/>
          <a:p>
            <a:fld id="{BD2F98E1-A9A7-436C-BABF-4DD4C4C5C0A0}" type="slidenum">
              <a:rPr lang="de-DE" smtClean="0"/>
              <a:t>‹Nr.›</a:t>
            </a:fld>
            <a:endParaRPr lang="de-DE"/>
          </a:p>
        </p:txBody>
      </p:sp>
    </p:spTree>
    <p:extLst>
      <p:ext uri="{BB962C8B-B14F-4D97-AF65-F5344CB8AC3E}">
        <p14:creationId xmlns:p14="http://schemas.microsoft.com/office/powerpoint/2010/main" val="302571329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2678274-3F47-4949-8F78-A94430CAC86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de-DE"/>
          </a:p>
        </p:txBody>
      </p:sp>
      <p:sp>
        <p:nvSpPr>
          <p:cNvPr id="3" name="Text Placeholder 2">
            <a:extLst>
              <a:ext uri="{FF2B5EF4-FFF2-40B4-BE49-F238E27FC236}">
                <a16:creationId xmlns:a16="http://schemas.microsoft.com/office/drawing/2014/main" id="{C9377B1D-4F37-4E98-BDBC-2CA17F6DC01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4" name="Date Placeholder 3">
            <a:extLst>
              <a:ext uri="{FF2B5EF4-FFF2-40B4-BE49-F238E27FC236}">
                <a16:creationId xmlns:a16="http://schemas.microsoft.com/office/drawing/2014/main" id="{0770A5CB-27F6-4547-BEEE-67C94A0D487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E08E161-E9B9-4625-A775-C63924A68DD0}" type="datetimeFigureOut">
              <a:rPr lang="de-DE" smtClean="0"/>
              <a:t>11.11.2024</a:t>
            </a:fld>
            <a:endParaRPr lang="de-DE"/>
          </a:p>
        </p:txBody>
      </p:sp>
      <p:sp>
        <p:nvSpPr>
          <p:cNvPr id="5" name="Footer Placeholder 4">
            <a:extLst>
              <a:ext uri="{FF2B5EF4-FFF2-40B4-BE49-F238E27FC236}">
                <a16:creationId xmlns:a16="http://schemas.microsoft.com/office/drawing/2014/main" id="{F2930761-5901-4D58-8C0B-A95C65665C0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Slide Number Placeholder 5">
            <a:extLst>
              <a:ext uri="{FF2B5EF4-FFF2-40B4-BE49-F238E27FC236}">
                <a16:creationId xmlns:a16="http://schemas.microsoft.com/office/drawing/2014/main" id="{BD2661A7-6697-47EC-824A-D1D169FFFB0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D2F98E1-A9A7-436C-BABF-4DD4C4C5C0A0}" type="slidenum">
              <a:rPr lang="de-DE" smtClean="0"/>
              <a:t>‹Nr.›</a:t>
            </a:fld>
            <a:endParaRPr lang="de-DE"/>
          </a:p>
        </p:txBody>
      </p:sp>
    </p:spTree>
    <p:extLst>
      <p:ext uri="{BB962C8B-B14F-4D97-AF65-F5344CB8AC3E}">
        <p14:creationId xmlns:p14="http://schemas.microsoft.com/office/powerpoint/2010/main" val="47627823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image" Target="../media/image2.jpeg"/><Relationship Id="rId1" Type="http://schemas.openxmlformats.org/officeDocument/2006/relationships/slideLayout" Target="../slideLayouts/slideLayout7.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svg"/></Relationships>
</file>

<file path=ppt/slides/_rels/slide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Layout" Target="../slideLayouts/slideLayout7.xml"/><Relationship Id="rId6" Type="http://schemas.openxmlformats.org/officeDocument/2006/relationships/image" Target="../media/image7.png"/><Relationship Id="rId5" Type="http://schemas.openxmlformats.org/officeDocument/2006/relationships/image" Target="../media/image8.png"/><Relationship Id="rId4" Type="http://schemas.openxmlformats.org/officeDocument/2006/relationships/image" Target="../media/image4.svg"/></Relationships>
</file>

<file path=ppt/slides/_rels/slide7.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8ABFF824-90A4-48C2-86B2-611E3C93C833}"/>
              </a:ext>
            </a:extLst>
          </p:cNvPr>
          <p:cNvSpPr txBox="1"/>
          <p:nvPr/>
        </p:nvSpPr>
        <p:spPr>
          <a:xfrm>
            <a:off x="352425" y="361950"/>
            <a:ext cx="11153775" cy="5078313"/>
          </a:xfrm>
          <a:prstGeom prst="rect">
            <a:avLst/>
          </a:prstGeom>
          <a:noFill/>
        </p:spPr>
        <p:txBody>
          <a:bodyPr wrap="square" rtlCol="0">
            <a:spAutoFit/>
          </a:bodyPr>
          <a:lstStyle/>
          <a:p>
            <a:r>
              <a:rPr lang="de-CH" sz="1800" b="1" dirty="0">
                <a:solidFill>
                  <a:srgbClr val="0070C0"/>
                </a:solidFill>
                <a:effectLst/>
                <a:ea typeface="Times New Roman" panose="02020603050405020304" pitchFamily="18" charset="0"/>
                <a:cs typeface="Times New Roman" panose="02020603050405020304" pitchFamily="18" charset="0"/>
              </a:rPr>
              <a:t>Appendix </a:t>
            </a:r>
            <a:r>
              <a:rPr lang="de-CH" b="1" dirty="0">
                <a:solidFill>
                  <a:srgbClr val="0070C0"/>
                </a:solidFill>
                <a:ea typeface="Times New Roman" panose="02020603050405020304" pitchFamily="18" charset="0"/>
                <a:cs typeface="Times New Roman" panose="02020603050405020304" pitchFamily="18" charset="0"/>
              </a:rPr>
              <a:t>2</a:t>
            </a:r>
            <a:endParaRPr lang="de-DE" sz="1800" dirty="0">
              <a:effectLst/>
              <a:ea typeface="Times New Roman" panose="02020603050405020304" pitchFamily="18" charset="0"/>
              <a:cs typeface="Times New Roman" panose="02020603050405020304" pitchFamily="18" charset="0"/>
            </a:endParaRPr>
          </a:p>
          <a:p>
            <a:r>
              <a:rPr lang="en-US" dirty="0"/>
              <a:t> </a:t>
            </a:r>
          </a:p>
          <a:p>
            <a:r>
              <a:rPr lang="en-US" dirty="0"/>
              <a:t>Pelvis configuration and orientation may vary substantially in different patients (Figure 1). Optimal contrast of anatomic (bony) landmarks depends on the amount of superposition of a structure in relation to the x-ray beam orientation. If the x-ray beam orientation follows exactly the orientation of the structure of interest like a tangential line, the absorption of the x-rays is maximally and therefore depiction of that structure is maximally contrasted in the resulting radiograph (Figure 2). In conventional S1 screw placement one must rely on an approximation of the optimal view. For example, the inlet view is achieved by overlaying the lines of the anterior cortices of the S1 and S2 vertebral body. These two have seldomly the exact same orientation and shape, therefore an angle in between the two optimal beam directions must be chosen to achieve the inlet view leading to a suboptimal contrasting of the anterior cortex of the S1 vertebral body and thus, it can be very difficult to reassure to not perforate the anterior vertebral body of S1. Especially in osteoporotic bone or patients with distended bowels due to opioid pain medication in the context of the preceding conservative treatment of the pelvis fracture. </a:t>
            </a:r>
          </a:p>
          <a:p>
            <a:r>
              <a:rPr lang="en-US" dirty="0"/>
              <a:t>The angle between this tangential line to the anterior surface of the S1 vertebral body and the perpendicular we call the personalized inlet angle (Figure 3A). It allows for perfect depiction of the anterior surface of the S1 vertebral body and antero-posterior orientation of the screw. Therefore, knowledge of the personalized inlet angle and its precise translation during the surgery enables the surgeon to prevent nerve lesions anteriorly (L5) or posteriorly (spinal canal) through screw perforation.</a:t>
            </a:r>
          </a:p>
        </p:txBody>
      </p:sp>
    </p:spTree>
    <p:extLst>
      <p:ext uri="{BB962C8B-B14F-4D97-AF65-F5344CB8AC3E}">
        <p14:creationId xmlns:p14="http://schemas.microsoft.com/office/powerpoint/2010/main" val="172459524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5B508DAD-854C-4FFF-A663-908BAD7BE67E}"/>
              </a:ext>
            </a:extLst>
          </p:cNvPr>
          <p:cNvSpPr txBox="1"/>
          <p:nvPr/>
        </p:nvSpPr>
        <p:spPr>
          <a:xfrm>
            <a:off x="657225" y="704850"/>
            <a:ext cx="10467975" cy="5467350"/>
          </a:xfrm>
          <a:prstGeom prst="rect">
            <a:avLst/>
          </a:prstGeom>
          <a:noFill/>
        </p:spPr>
        <p:txBody>
          <a:bodyPr wrap="square" rtlCol="0">
            <a:spAutoFit/>
          </a:bodyPr>
          <a:lstStyle/>
          <a:p>
            <a:r>
              <a:rPr lang="en-US" dirty="0"/>
              <a:t>The angle formed between a line connecting the symphysis with the S1/2-interconnection and the perpendicular on the patient we call the personalized outlet angle (Figure 3B). This view offers a perpendicular view on the </a:t>
            </a:r>
            <a:r>
              <a:rPr lang="en-US" dirty="0" err="1"/>
              <a:t>paracoronal</a:t>
            </a:r>
            <a:r>
              <a:rPr lang="en-US" dirty="0"/>
              <a:t> surface of the upper part of the sacrum without superposition of the symphysis (which at times can hamper correct detection of the S1 foramina) and informs about the cranio-caudal direction of the screw. The personalized outlet view defining angle is more of informative nature and maybe approximated because the foramina run by nature not in one single plane but are 3-dimensinal structures therefore exact perpendicular depiction is not possible. This projection enables the surgeon to see the height and location of the S1 foramina to prevent perforation of the top plate of S1 or the S1 foramina. </a:t>
            </a:r>
          </a:p>
          <a:p>
            <a:r>
              <a:rPr lang="en-US" dirty="0"/>
              <a:t> </a:t>
            </a:r>
          </a:p>
          <a:p>
            <a:r>
              <a:rPr lang="en-US" dirty="0"/>
              <a:t>These angles are measured as follows: </a:t>
            </a:r>
          </a:p>
          <a:p>
            <a:r>
              <a:rPr lang="en-US" dirty="0"/>
              <a:t>1. Orient the pelvis as symmetrically as possible in the sagittal (Fig 4B), axial (Fig 4A) and coronal (Fig 4C) plane. Then the sagittal plane is set in the middle of the pelvis (blue crosshairs). If in the perfect median sagittal plane, the symphysis may not be seen one should scroll to the side of the more difficult fracture until the symphysis is visible. This view should be enlarged for the most precise measurements. </a:t>
            </a:r>
          </a:p>
          <a:p>
            <a:r>
              <a:rPr lang="en-US" dirty="0"/>
              <a:t>2. The personalized inlet angle is measured between the tangential of the anterior S1 body and the horizontal line (which corresponds to the perpendicular in the supine patient, Fig 4D α). </a:t>
            </a:r>
          </a:p>
          <a:p>
            <a:r>
              <a:rPr lang="en-US" dirty="0"/>
              <a:t>3. The personalized outlet angle is measured between the horizontal and a line that connects the symphysis tangentially with the connection of the S1 and S2 vertebral body (corresponding to the location of the S1 foramina, Fig 4D β). </a:t>
            </a:r>
          </a:p>
        </p:txBody>
      </p:sp>
    </p:spTree>
    <p:extLst>
      <p:ext uri="{BB962C8B-B14F-4D97-AF65-F5344CB8AC3E}">
        <p14:creationId xmlns:p14="http://schemas.microsoft.com/office/powerpoint/2010/main" val="273294909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a:extLst>
              <a:ext uri="{FF2B5EF4-FFF2-40B4-BE49-F238E27FC236}">
                <a16:creationId xmlns:a16="http://schemas.microsoft.com/office/drawing/2014/main" id="{6EAB2058-FAEE-FC54-4873-E53D5A9A9704}"/>
              </a:ext>
            </a:extLst>
          </p:cNvPr>
          <p:cNvSpPr txBox="1"/>
          <p:nvPr/>
        </p:nvSpPr>
        <p:spPr>
          <a:xfrm>
            <a:off x="228600" y="444500"/>
            <a:ext cx="2069990" cy="369332"/>
          </a:xfrm>
          <a:prstGeom prst="rect">
            <a:avLst/>
          </a:prstGeom>
          <a:noFill/>
        </p:spPr>
        <p:txBody>
          <a:bodyPr wrap="none" lIns="91440" tIns="45720" rIns="91440" bIns="45720" rtlCol="0" anchor="t">
            <a:spAutoFit/>
          </a:bodyPr>
          <a:lstStyle/>
          <a:p>
            <a:r>
              <a:rPr lang="de-CH" dirty="0"/>
              <a:t>Appendix 2, </a:t>
            </a:r>
            <a:r>
              <a:rPr lang="de-CH" dirty="0" err="1"/>
              <a:t>figure</a:t>
            </a:r>
            <a:r>
              <a:rPr lang="de-CH" dirty="0"/>
              <a:t> 1</a:t>
            </a:r>
          </a:p>
        </p:txBody>
      </p:sp>
      <p:pic>
        <p:nvPicPr>
          <p:cNvPr id="1026" name="Picture 2">
            <a:extLst>
              <a:ext uri="{FF2B5EF4-FFF2-40B4-BE49-F238E27FC236}">
                <a16:creationId xmlns:a16="http://schemas.microsoft.com/office/drawing/2014/main" id="{E9CEE07D-02D9-D163-1799-530401904F95}"/>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04775" y="1454422"/>
            <a:ext cx="11982450" cy="37433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398676613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 name="Rechteck 39">
            <a:extLst>
              <a:ext uri="{FF2B5EF4-FFF2-40B4-BE49-F238E27FC236}">
                <a16:creationId xmlns:a16="http://schemas.microsoft.com/office/drawing/2014/main" id="{AB037582-987A-E423-8B2F-937EE35A9545}"/>
              </a:ext>
            </a:extLst>
          </p:cNvPr>
          <p:cNvSpPr/>
          <p:nvPr/>
        </p:nvSpPr>
        <p:spPr>
          <a:xfrm>
            <a:off x="5988861" y="4638203"/>
            <a:ext cx="5446412" cy="1057711"/>
          </a:xfrm>
          <a:prstGeom prst="rect">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de-DE"/>
          </a:p>
        </p:txBody>
      </p:sp>
      <p:sp>
        <p:nvSpPr>
          <p:cNvPr id="41" name="Rechteck 40">
            <a:extLst>
              <a:ext uri="{FF2B5EF4-FFF2-40B4-BE49-F238E27FC236}">
                <a16:creationId xmlns:a16="http://schemas.microsoft.com/office/drawing/2014/main" id="{6883C690-66A9-CFC6-6C45-C3F85F9ED6FC}"/>
              </a:ext>
            </a:extLst>
          </p:cNvPr>
          <p:cNvSpPr/>
          <p:nvPr/>
        </p:nvSpPr>
        <p:spPr>
          <a:xfrm>
            <a:off x="5988861" y="5796438"/>
            <a:ext cx="5446412" cy="1034541"/>
          </a:xfrm>
          <a:prstGeom prst="rect">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de-DE"/>
          </a:p>
        </p:txBody>
      </p:sp>
      <p:grpSp>
        <p:nvGrpSpPr>
          <p:cNvPr id="7" name="Gruppieren 6">
            <a:extLst>
              <a:ext uri="{FF2B5EF4-FFF2-40B4-BE49-F238E27FC236}">
                <a16:creationId xmlns:a16="http://schemas.microsoft.com/office/drawing/2014/main" id="{75071A4D-461F-D4A1-B137-351F9EF51B32}"/>
              </a:ext>
            </a:extLst>
          </p:cNvPr>
          <p:cNvGrpSpPr/>
          <p:nvPr/>
        </p:nvGrpSpPr>
        <p:grpSpPr>
          <a:xfrm>
            <a:off x="1263535" y="1304171"/>
            <a:ext cx="2207452" cy="4518612"/>
            <a:chOff x="4073237" y="1204418"/>
            <a:chExt cx="2207452" cy="4518612"/>
          </a:xfrm>
        </p:grpSpPr>
        <p:sp>
          <p:nvSpPr>
            <p:cNvPr id="6" name="Trapez 5">
              <a:extLst>
                <a:ext uri="{FF2B5EF4-FFF2-40B4-BE49-F238E27FC236}">
                  <a16:creationId xmlns:a16="http://schemas.microsoft.com/office/drawing/2014/main" id="{1A6211F0-4D22-5A7D-78D4-D372AAF25FEA}"/>
                </a:ext>
              </a:extLst>
            </p:cNvPr>
            <p:cNvSpPr/>
            <p:nvPr/>
          </p:nvSpPr>
          <p:spPr>
            <a:xfrm rot="9360801">
              <a:off x="4656660" y="1204418"/>
              <a:ext cx="1512916" cy="4518612"/>
            </a:xfrm>
            <a:custGeom>
              <a:avLst/>
              <a:gdLst>
                <a:gd name="connsiteX0" fmla="*/ 0 w 1512916"/>
                <a:gd name="connsiteY0" fmla="*/ 4496802 h 4496802"/>
                <a:gd name="connsiteX1" fmla="*/ 483846 w 1512916"/>
                <a:gd name="connsiteY1" fmla="*/ 0 h 4496802"/>
                <a:gd name="connsiteX2" fmla="*/ 1029070 w 1512916"/>
                <a:gd name="connsiteY2" fmla="*/ 0 h 4496802"/>
                <a:gd name="connsiteX3" fmla="*/ 1512916 w 1512916"/>
                <a:gd name="connsiteY3" fmla="*/ 4496802 h 4496802"/>
                <a:gd name="connsiteX4" fmla="*/ 0 w 1512916"/>
                <a:gd name="connsiteY4" fmla="*/ 4496802 h 4496802"/>
                <a:gd name="connsiteX0" fmla="*/ 0 w 1512916"/>
                <a:gd name="connsiteY0" fmla="*/ 4496802 h 4496802"/>
                <a:gd name="connsiteX1" fmla="*/ 62353 w 1512916"/>
                <a:gd name="connsiteY1" fmla="*/ 2881057 h 4496802"/>
                <a:gd name="connsiteX2" fmla="*/ 483846 w 1512916"/>
                <a:gd name="connsiteY2" fmla="*/ 0 h 4496802"/>
                <a:gd name="connsiteX3" fmla="*/ 1029070 w 1512916"/>
                <a:gd name="connsiteY3" fmla="*/ 0 h 4496802"/>
                <a:gd name="connsiteX4" fmla="*/ 1512916 w 1512916"/>
                <a:gd name="connsiteY4" fmla="*/ 4496802 h 4496802"/>
                <a:gd name="connsiteX5" fmla="*/ 0 w 1512916"/>
                <a:gd name="connsiteY5" fmla="*/ 4496802 h 4496802"/>
                <a:gd name="connsiteX0" fmla="*/ 0 w 1512916"/>
                <a:gd name="connsiteY0" fmla="*/ 4518612 h 4518612"/>
                <a:gd name="connsiteX1" fmla="*/ 62353 w 1512916"/>
                <a:gd name="connsiteY1" fmla="*/ 2902867 h 4518612"/>
                <a:gd name="connsiteX2" fmla="*/ 802898 w 1512916"/>
                <a:gd name="connsiteY2" fmla="*/ 0 h 4518612"/>
                <a:gd name="connsiteX3" fmla="*/ 1029070 w 1512916"/>
                <a:gd name="connsiteY3" fmla="*/ 21810 h 4518612"/>
                <a:gd name="connsiteX4" fmla="*/ 1512916 w 1512916"/>
                <a:gd name="connsiteY4" fmla="*/ 4518612 h 4518612"/>
                <a:gd name="connsiteX5" fmla="*/ 0 w 1512916"/>
                <a:gd name="connsiteY5" fmla="*/ 4518612 h 4518612"/>
                <a:gd name="connsiteX0" fmla="*/ 0 w 1512916"/>
                <a:gd name="connsiteY0" fmla="*/ 4518612 h 4518612"/>
                <a:gd name="connsiteX1" fmla="*/ 62353 w 1512916"/>
                <a:gd name="connsiteY1" fmla="*/ 2902867 h 4518612"/>
                <a:gd name="connsiteX2" fmla="*/ 802898 w 1512916"/>
                <a:gd name="connsiteY2" fmla="*/ 0 h 4518612"/>
                <a:gd name="connsiteX3" fmla="*/ 1294054 w 1512916"/>
                <a:gd name="connsiteY3" fmla="*/ 121516 h 4518612"/>
                <a:gd name="connsiteX4" fmla="*/ 1512916 w 1512916"/>
                <a:gd name="connsiteY4" fmla="*/ 4518612 h 4518612"/>
                <a:gd name="connsiteX5" fmla="*/ 0 w 1512916"/>
                <a:gd name="connsiteY5" fmla="*/ 4518612 h 4518612"/>
                <a:gd name="connsiteX0" fmla="*/ 0 w 1512916"/>
                <a:gd name="connsiteY0" fmla="*/ 4518612 h 4518612"/>
                <a:gd name="connsiteX1" fmla="*/ 62353 w 1512916"/>
                <a:gd name="connsiteY1" fmla="*/ 2902867 h 4518612"/>
                <a:gd name="connsiteX2" fmla="*/ 802898 w 1512916"/>
                <a:gd name="connsiteY2" fmla="*/ 0 h 4518612"/>
                <a:gd name="connsiteX3" fmla="*/ 1294054 w 1512916"/>
                <a:gd name="connsiteY3" fmla="*/ 121516 h 4518612"/>
                <a:gd name="connsiteX4" fmla="*/ 1156285 w 1512916"/>
                <a:gd name="connsiteY4" fmla="*/ 2734522 h 4518612"/>
                <a:gd name="connsiteX5" fmla="*/ 1512916 w 1512916"/>
                <a:gd name="connsiteY5" fmla="*/ 4518612 h 4518612"/>
                <a:gd name="connsiteX6" fmla="*/ 0 w 1512916"/>
                <a:gd name="connsiteY6" fmla="*/ 4518612 h 4518612"/>
                <a:gd name="connsiteX0" fmla="*/ 0 w 1512916"/>
                <a:gd name="connsiteY0" fmla="*/ 4518612 h 4518612"/>
                <a:gd name="connsiteX1" fmla="*/ 62353 w 1512916"/>
                <a:gd name="connsiteY1" fmla="*/ 2902867 h 4518612"/>
                <a:gd name="connsiteX2" fmla="*/ 248526 w 1512916"/>
                <a:gd name="connsiteY2" fmla="*/ 1748312 h 4518612"/>
                <a:gd name="connsiteX3" fmla="*/ 802898 w 1512916"/>
                <a:gd name="connsiteY3" fmla="*/ 0 h 4518612"/>
                <a:gd name="connsiteX4" fmla="*/ 1294054 w 1512916"/>
                <a:gd name="connsiteY4" fmla="*/ 121516 h 4518612"/>
                <a:gd name="connsiteX5" fmla="*/ 1156285 w 1512916"/>
                <a:gd name="connsiteY5" fmla="*/ 2734522 h 4518612"/>
                <a:gd name="connsiteX6" fmla="*/ 1512916 w 1512916"/>
                <a:gd name="connsiteY6" fmla="*/ 4518612 h 4518612"/>
                <a:gd name="connsiteX7" fmla="*/ 0 w 1512916"/>
                <a:gd name="connsiteY7" fmla="*/ 4518612 h 4518612"/>
                <a:gd name="connsiteX0" fmla="*/ 0 w 1512916"/>
                <a:gd name="connsiteY0" fmla="*/ 4518612 h 4518612"/>
                <a:gd name="connsiteX1" fmla="*/ 62353 w 1512916"/>
                <a:gd name="connsiteY1" fmla="*/ 2902867 h 4518612"/>
                <a:gd name="connsiteX2" fmla="*/ 248526 w 1512916"/>
                <a:gd name="connsiteY2" fmla="*/ 1748312 h 4518612"/>
                <a:gd name="connsiteX3" fmla="*/ 802898 w 1512916"/>
                <a:gd name="connsiteY3" fmla="*/ 0 h 4518612"/>
                <a:gd name="connsiteX4" fmla="*/ 1294054 w 1512916"/>
                <a:gd name="connsiteY4" fmla="*/ 121516 h 4518612"/>
                <a:gd name="connsiteX5" fmla="*/ 1151821 w 1512916"/>
                <a:gd name="connsiteY5" fmla="*/ 1313174 h 4518612"/>
                <a:gd name="connsiteX6" fmla="*/ 1156285 w 1512916"/>
                <a:gd name="connsiteY6" fmla="*/ 2734522 h 4518612"/>
                <a:gd name="connsiteX7" fmla="*/ 1512916 w 1512916"/>
                <a:gd name="connsiteY7" fmla="*/ 4518612 h 4518612"/>
                <a:gd name="connsiteX8" fmla="*/ 0 w 1512916"/>
                <a:gd name="connsiteY8" fmla="*/ 4518612 h 4518612"/>
                <a:gd name="connsiteX0" fmla="*/ 0 w 1512916"/>
                <a:gd name="connsiteY0" fmla="*/ 4518612 h 4518612"/>
                <a:gd name="connsiteX1" fmla="*/ 62353 w 1512916"/>
                <a:gd name="connsiteY1" fmla="*/ 2902867 h 4518612"/>
                <a:gd name="connsiteX2" fmla="*/ 248526 w 1512916"/>
                <a:gd name="connsiteY2" fmla="*/ 1748312 h 4518612"/>
                <a:gd name="connsiteX3" fmla="*/ 802898 w 1512916"/>
                <a:gd name="connsiteY3" fmla="*/ 0 h 4518612"/>
                <a:gd name="connsiteX4" fmla="*/ 1294054 w 1512916"/>
                <a:gd name="connsiteY4" fmla="*/ 121516 h 4518612"/>
                <a:gd name="connsiteX5" fmla="*/ 1151821 w 1512916"/>
                <a:gd name="connsiteY5" fmla="*/ 1313174 h 4518612"/>
                <a:gd name="connsiteX6" fmla="*/ 1156285 w 1512916"/>
                <a:gd name="connsiteY6" fmla="*/ 2734522 h 4518612"/>
                <a:gd name="connsiteX7" fmla="*/ 1512916 w 1512916"/>
                <a:gd name="connsiteY7" fmla="*/ 4518612 h 4518612"/>
                <a:gd name="connsiteX8" fmla="*/ 0 w 1512916"/>
                <a:gd name="connsiteY8" fmla="*/ 4518612 h 45186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512916" h="4518612">
                  <a:moveTo>
                    <a:pt x="0" y="4518612"/>
                  </a:moveTo>
                  <a:cubicBezTo>
                    <a:pt x="63543" y="3992990"/>
                    <a:pt x="-1190" y="3428489"/>
                    <a:pt x="62353" y="2902867"/>
                  </a:cubicBezTo>
                  <a:cubicBezTo>
                    <a:pt x="155905" y="2556291"/>
                    <a:pt x="154974" y="2094888"/>
                    <a:pt x="248526" y="1748312"/>
                  </a:cubicBezTo>
                  <a:lnTo>
                    <a:pt x="802898" y="0"/>
                  </a:lnTo>
                  <a:lnTo>
                    <a:pt x="1294054" y="121516"/>
                  </a:lnTo>
                  <a:cubicBezTo>
                    <a:pt x="1243860" y="413481"/>
                    <a:pt x="1174783" y="877673"/>
                    <a:pt x="1151821" y="1313174"/>
                  </a:cubicBezTo>
                  <a:cubicBezTo>
                    <a:pt x="1128860" y="1748675"/>
                    <a:pt x="1111014" y="2200851"/>
                    <a:pt x="1156285" y="2734522"/>
                  </a:cubicBezTo>
                  <a:lnTo>
                    <a:pt x="1512916" y="4518612"/>
                  </a:lnTo>
                  <a:lnTo>
                    <a:pt x="0" y="4518612"/>
                  </a:lnTo>
                  <a:close/>
                </a:path>
              </a:pathLst>
            </a:custGeom>
            <a:solidFill>
              <a:schemeClr val="accent1">
                <a:lumMod val="20000"/>
                <a:lumOff val="80000"/>
              </a:schemeClr>
            </a:solidFill>
            <a:ln w="381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2" name="Trapez 1">
              <a:extLst>
                <a:ext uri="{FF2B5EF4-FFF2-40B4-BE49-F238E27FC236}">
                  <a16:creationId xmlns:a16="http://schemas.microsoft.com/office/drawing/2014/main" id="{629DA2D0-F7E1-D3CD-3CF9-1322AE48CEBC}"/>
                </a:ext>
              </a:extLst>
            </p:cNvPr>
            <p:cNvSpPr/>
            <p:nvPr/>
          </p:nvSpPr>
          <p:spPr>
            <a:xfrm rot="9099572">
              <a:off x="4073237" y="1346662"/>
              <a:ext cx="1512916" cy="1396538"/>
            </a:xfrm>
            <a:prstGeom prst="trapezoid">
              <a:avLst>
                <a:gd name="adj" fmla="val 13227"/>
              </a:avLst>
            </a:prstGeom>
            <a:solidFill>
              <a:schemeClr val="accent1">
                <a:lumMod val="60000"/>
                <a:lumOff val="40000"/>
              </a:schemeClr>
            </a:solidFill>
            <a:ln w="38100">
              <a:solidFill>
                <a:schemeClr val="accent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lIns="91440" tIns="45720" rIns="91440" bIns="45720" rtlCol="0" anchor="ctr"/>
            <a:lstStyle/>
            <a:p>
              <a:pPr algn="ctr"/>
              <a:endParaRPr lang="de-DE" dirty="0">
                <a:cs typeface="Calibri"/>
              </a:endParaRPr>
            </a:p>
          </p:txBody>
        </p:sp>
        <p:sp>
          <p:nvSpPr>
            <p:cNvPr id="3" name="Trapez 2">
              <a:extLst>
                <a:ext uri="{FF2B5EF4-FFF2-40B4-BE49-F238E27FC236}">
                  <a16:creationId xmlns:a16="http://schemas.microsoft.com/office/drawing/2014/main" id="{BF81093C-E20F-DA9E-FFEC-8D1B03FC53E6}"/>
                </a:ext>
              </a:extLst>
            </p:cNvPr>
            <p:cNvSpPr/>
            <p:nvPr/>
          </p:nvSpPr>
          <p:spPr>
            <a:xfrm rot="9560985">
              <a:off x="4836444" y="2749273"/>
              <a:ext cx="1158130" cy="1069043"/>
            </a:xfrm>
            <a:prstGeom prst="trapezoid">
              <a:avLst>
                <a:gd name="adj" fmla="val 13227"/>
              </a:avLst>
            </a:prstGeom>
            <a:solidFill>
              <a:schemeClr val="accent1">
                <a:lumMod val="60000"/>
                <a:lumOff val="40000"/>
              </a:schemeClr>
            </a:solidFill>
            <a:ln w="38100">
              <a:solidFill>
                <a:schemeClr val="accent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 name="Trapez 3">
              <a:extLst>
                <a:ext uri="{FF2B5EF4-FFF2-40B4-BE49-F238E27FC236}">
                  <a16:creationId xmlns:a16="http://schemas.microsoft.com/office/drawing/2014/main" id="{686EA76D-06D1-2BF8-85B2-88E48681B7D2}"/>
                </a:ext>
              </a:extLst>
            </p:cNvPr>
            <p:cNvSpPr/>
            <p:nvPr/>
          </p:nvSpPr>
          <p:spPr>
            <a:xfrm rot="9940181">
              <a:off x="5322926" y="3866601"/>
              <a:ext cx="902735" cy="994376"/>
            </a:xfrm>
            <a:prstGeom prst="trapezoid">
              <a:avLst>
                <a:gd name="adj" fmla="val 13227"/>
              </a:avLst>
            </a:prstGeom>
            <a:solidFill>
              <a:schemeClr val="accent1">
                <a:lumMod val="60000"/>
                <a:lumOff val="40000"/>
              </a:schemeClr>
            </a:solidFill>
            <a:ln w="38100">
              <a:solidFill>
                <a:schemeClr val="accent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5" name="Trapez 4">
              <a:extLst>
                <a:ext uri="{FF2B5EF4-FFF2-40B4-BE49-F238E27FC236}">
                  <a16:creationId xmlns:a16="http://schemas.microsoft.com/office/drawing/2014/main" id="{E03606E5-1F2A-5FD4-F183-92D06EC29B3D}"/>
                </a:ext>
              </a:extLst>
            </p:cNvPr>
            <p:cNvSpPr/>
            <p:nvPr/>
          </p:nvSpPr>
          <p:spPr>
            <a:xfrm rot="10235389">
              <a:off x="5642359" y="4928972"/>
              <a:ext cx="638330" cy="703130"/>
            </a:xfrm>
            <a:prstGeom prst="trapezoid">
              <a:avLst>
                <a:gd name="adj" fmla="val 13227"/>
              </a:avLst>
            </a:prstGeom>
            <a:solidFill>
              <a:schemeClr val="accent1">
                <a:lumMod val="60000"/>
                <a:lumOff val="40000"/>
              </a:schemeClr>
            </a:solidFill>
            <a:ln w="38100">
              <a:solidFill>
                <a:schemeClr val="accent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grpSp>
      <p:sp>
        <p:nvSpPr>
          <p:cNvPr id="10" name="Trapez 9">
            <a:extLst>
              <a:ext uri="{FF2B5EF4-FFF2-40B4-BE49-F238E27FC236}">
                <a16:creationId xmlns:a16="http://schemas.microsoft.com/office/drawing/2014/main" id="{FAC13295-1ACC-A604-49F5-22D82E78D465}"/>
              </a:ext>
            </a:extLst>
          </p:cNvPr>
          <p:cNvSpPr/>
          <p:nvPr/>
        </p:nvSpPr>
        <p:spPr>
          <a:xfrm rot="9099572">
            <a:off x="5185600" y="1266772"/>
            <a:ext cx="2925686" cy="2700634"/>
          </a:xfrm>
          <a:prstGeom prst="trapezoid">
            <a:avLst>
              <a:gd name="adj" fmla="val 13227"/>
            </a:avLst>
          </a:prstGeom>
          <a:solidFill>
            <a:schemeClr val="accent1">
              <a:lumMod val="60000"/>
              <a:lumOff val="40000"/>
            </a:schemeClr>
          </a:solidFill>
          <a:ln w="127000">
            <a:solidFill>
              <a:schemeClr val="accent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23" name="Gerade Verbindung 22">
            <a:extLst>
              <a:ext uri="{FF2B5EF4-FFF2-40B4-BE49-F238E27FC236}">
                <a16:creationId xmlns:a16="http://schemas.microsoft.com/office/drawing/2014/main" id="{81850EC0-8810-4C78-720C-2877CEF59A7A}"/>
              </a:ext>
            </a:extLst>
          </p:cNvPr>
          <p:cNvCxnSpPr>
            <a:cxnSpLocks/>
          </p:cNvCxnSpPr>
          <p:nvPr/>
        </p:nvCxnSpPr>
        <p:spPr>
          <a:xfrm flipH="1">
            <a:off x="3336174" y="399011"/>
            <a:ext cx="4076572" cy="0"/>
          </a:xfrm>
          <a:prstGeom prst="line">
            <a:avLst/>
          </a:prstGeom>
          <a:ln w="38100">
            <a:solidFill>
              <a:schemeClr val="tx1"/>
            </a:solidFill>
            <a:prstDash val="sysDash"/>
          </a:ln>
        </p:spPr>
        <p:style>
          <a:lnRef idx="1">
            <a:schemeClr val="accent1"/>
          </a:lnRef>
          <a:fillRef idx="0">
            <a:schemeClr val="accent1"/>
          </a:fillRef>
          <a:effectRef idx="0">
            <a:schemeClr val="accent1"/>
          </a:effectRef>
          <a:fontRef idx="minor">
            <a:schemeClr val="tx1"/>
          </a:fontRef>
        </p:style>
      </p:cxnSp>
      <p:sp>
        <p:nvSpPr>
          <p:cNvPr id="26" name="Freihandform 25">
            <a:extLst>
              <a:ext uri="{FF2B5EF4-FFF2-40B4-BE49-F238E27FC236}">
                <a16:creationId xmlns:a16="http://schemas.microsoft.com/office/drawing/2014/main" id="{C31B9F94-09FE-F175-ACD8-E3F18EB143D6}"/>
              </a:ext>
            </a:extLst>
          </p:cNvPr>
          <p:cNvSpPr/>
          <p:nvPr/>
        </p:nvSpPr>
        <p:spPr>
          <a:xfrm rot="3263863">
            <a:off x="3580641" y="158311"/>
            <a:ext cx="645458" cy="634701"/>
          </a:xfrm>
          <a:custGeom>
            <a:avLst/>
            <a:gdLst>
              <a:gd name="connsiteX0" fmla="*/ 10756 w 645458"/>
              <a:gd name="connsiteY0" fmla="*/ 0 h 634701"/>
              <a:gd name="connsiteX1" fmla="*/ 632563 w 645458"/>
              <a:gd name="connsiteY1" fmla="*/ 506788 h 634701"/>
              <a:gd name="connsiteX2" fmla="*/ 645458 w 645458"/>
              <a:gd name="connsiteY2" fmla="*/ 634701 h 634701"/>
              <a:gd name="connsiteX3" fmla="*/ 0 w 645458"/>
              <a:gd name="connsiteY3" fmla="*/ 634701 h 634701"/>
              <a:gd name="connsiteX4" fmla="*/ 0 w 645458"/>
              <a:gd name="connsiteY4" fmla="*/ 949 h 634701"/>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645458" h="634701">
                <a:moveTo>
                  <a:pt x="10756" y="0"/>
                </a:moveTo>
                <a:cubicBezTo>
                  <a:pt x="317475" y="0"/>
                  <a:pt x="573380" y="217565"/>
                  <a:pt x="632563" y="506788"/>
                </a:cubicBezTo>
                <a:lnTo>
                  <a:pt x="645458" y="634701"/>
                </a:lnTo>
                <a:lnTo>
                  <a:pt x="0" y="634701"/>
                </a:lnTo>
                <a:lnTo>
                  <a:pt x="0" y="949"/>
                </a:lnTo>
                <a:close/>
              </a:path>
            </a:pathLst>
          </a:custGeom>
          <a:noFill/>
          <a:ln w="57150">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de-DE"/>
          </a:p>
        </p:txBody>
      </p:sp>
      <p:cxnSp>
        <p:nvCxnSpPr>
          <p:cNvPr id="16" name="Gerade Verbindung mit Pfeil 15">
            <a:extLst>
              <a:ext uri="{FF2B5EF4-FFF2-40B4-BE49-F238E27FC236}">
                <a16:creationId xmlns:a16="http://schemas.microsoft.com/office/drawing/2014/main" id="{2906D984-4CBD-D8AB-E7FF-D72EED01B214}"/>
              </a:ext>
            </a:extLst>
          </p:cNvPr>
          <p:cNvCxnSpPr>
            <a:cxnSpLocks/>
          </p:cNvCxnSpPr>
          <p:nvPr/>
        </p:nvCxnSpPr>
        <p:spPr>
          <a:xfrm>
            <a:off x="3546027" y="547347"/>
            <a:ext cx="3236197" cy="4408352"/>
          </a:xfrm>
          <a:prstGeom prst="straightConnector1">
            <a:avLst/>
          </a:prstGeom>
          <a:ln w="57150">
            <a:solidFill>
              <a:srgbClr val="FF0000"/>
            </a:solidFill>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20" name="Gerade Verbindung 19">
            <a:extLst>
              <a:ext uri="{FF2B5EF4-FFF2-40B4-BE49-F238E27FC236}">
                <a16:creationId xmlns:a16="http://schemas.microsoft.com/office/drawing/2014/main" id="{6923D35F-556D-F480-9797-C63777797551}"/>
              </a:ext>
            </a:extLst>
          </p:cNvPr>
          <p:cNvCxnSpPr>
            <a:cxnSpLocks/>
          </p:cNvCxnSpPr>
          <p:nvPr/>
        </p:nvCxnSpPr>
        <p:spPr>
          <a:xfrm flipH="1" flipV="1">
            <a:off x="4031089" y="457627"/>
            <a:ext cx="2932934" cy="5477561"/>
          </a:xfrm>
          <a:prstGeom prst="line">
            <a:avLst/>
          </a:prstGeom>
          <a:ln w="57150">
            <a:solidFill>
              <a:srgbClr val="92D050"/>
            </a:solidFill>
            <a:prstDash val="sysDot"/>
            <a:headEnd type="triangle"/>
          </a:ln>
        </p:spPr>
        <p:style>
          <a:lnRef idx="1">
            <a:schemeClr val="accent1"/>
          </a:lnRef>
          <a:fillRef idx="0">
            <a:schemeClr val="accent1"/>
          </a:fillRef>
          <a:effectRef idx="0">
            <a:schemeClr val="accent1"/>
          </a:effectRef>
          <a:fontRef idx="minor">
            <a:schemeClr val="tx1"/>
          </a:fontRef>
        </p:style>
      </p:cxnSp>
      <p:sp>
        <p:nvSpPr>
          <p:cNvPr id="22" name="Freihandform 21">
            <a:extLst>
              <a:ext uri="{FF2B5EF4-FFF2-40B4-BE49-F238E27FC236}">
                <a16:creationId xmlns:a16="http://schemas.microsoft.com/office/drawing/2014/main" id="{FB73B61F-92F8-FCCC-EBEE-64D7EADC2E4A}"/>
              </a:ext>
            </a:extLst>
          </p:cNvPr>
          <p:cNvSpPr/>
          <p:nvPr/>
        </p:nvSpPr>
        <p:spPr>
          <a:xfrm rot="3794088">
            <a:off x="4147837" y="264117"/>
            <a:ext cx="645458" cy="634701"/>
          </a:xfrm>
          <a:custGeom>
            <a:avLst/>
            <a:gdLst>
              <a:gd name="connsiteX0" fmla="*/ 10756 w 645458"/>
              <a:gd name="connsiteY0" fmla="*/ 0 h 634701"/>
              <a:gd name="connsiteX1" fmla="*/ 632563 w 645458"/>
              <a:gd name="connsiteY1" fmla="*/ 506788 h 634701"/>
              <a:gd name="connsiteX2" fmla="*/ 645458 w 645458"/>
              <a:gd name="connsiteY2" fmla="*/ 634701 h 634701"/>
              <a:gd name="connsiteX3" fmla="*/ 0 w 645458"/>
              <a:gd name="connsiteY3" fmla="*/ 634701 h 634701"/>
              <a:gd name="connsiteX4" fmla="*/ 0 w 645458"/>
              <a:gd name="connsiteY4" fmla="*/ 949 h 634701"/>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645458" h="634701">
                <a:moveTo>
                  <a:pt x="10756" y="0"/>
                </a:moveTo>
                <a:cubicBezTo>
                  <a:pt x="317475" y="0"/>
                  <a:pt x="573380" y="217565"/>
                  <a:pt x="632563" y="506788"/>
                </a:cubicBezTo>
                <a:lnTo>
                  <a:pt x="645458" y="634701"/>
                </a:lnTo>
                <a:lnTo>
                  <a:pt x="0" y="634701"/>
                </a:lnTo>
                <a:lnTo>
                  <a:pt x="0" y="949"/>
                </a:lnTo>
                <a:close/>
              </a:path>
            </a:pathLst>
          </a:custGeom>
          <a:noFill/>
          <a:ln w="57150">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de-DE"/>
          </a:p>
        </p:txBody>
      </p:sp>
      <p:sp>
        <p:nvSpPr>
          <p:cNvPr id="25" name="Freihandform 24">
            <a:extLst>
              <a:ext uri="{FF2B5EF4-FFF2-40B4-BE49-F238E27FC236}">
                <a16:creationId xmlns:a16="http://schemas.microsoft.com/office/drawing/2014/main" id="{83BDF88D-7B0F-7C62-2576-C280E524092E}"/>
              </a:ext>
            </a:extLst>
          </p:cNvPr>
          <p:cNvSpPr/>
          <p:nvPr/>
        </p:nvSpPr>
        <p:spPr>
          <a:xfrm>
            <a:off x="6362497" y="4995833"/>
            <a:ext cx="4422371" cy="436400"/>
          </a:xfrm>
          <a:custGeom>
            <a:avLst/>
            <a:gdLst>
              <a:gd name="connsiteX0" fmla="*/ 0 w 4422371"/>
              <a:gd name="connsiteY0" fmla="*/ 201946 h 402186"/>
              <a:gd name="connsiteX1" fmla="*/ 714894 w 4422371"/>
              <a:gd name="connsiteY1" fmla="*/ 19066 h 402186"/>
              <a:gd name="connsiteX2" fmla="*/ 1064029 w 4422371"/>
              <a:gd name="connsiteY2" fmla="*/ 35692 h 402186"/>
              <a:gd name="connsiteX3" fmla="*/ 1463040 w 4422371"/>
              <a:gd name="connsiteY3" fmla="*/ 285074 h 402186"/>
              <a:gd name="connsiteX4" fmla="*/ 2360814 w 4422371"/>
              <a:gd name="connsiteY4" fmla="*/ 401452 h 402186"/>
              <a:gd name="connsiteX5" fmla="*/ 3042458 w 4422371"/>
              <a:gd name="connsiteY5" fmla="*/ 235197 h 402186"/>
              <a:gd name="connsiteX6" fmla="*/ 3241964 w 4422371"/>
              <a:gd name="connsiteY6" fmla="*/ 118819 h 402186"/>
              <a:gd name="connsiteX7" fmla="*/ 3507971 w 4422371"/>
              <a:gd name="connsiteY7" fmla="*/ 35692 h 402186"/>
              <a:gd name="connsiteX8" fmla="*/ 4422371 w 4422371"/>
              <a:gd name="connsiteY8" fmla="*/ 251823 h 402186"/>
              <a:gd name="connsiteX9" fmla="*/ 4422371 w 4422371"/>
              <a:gd name="connsiteY9" fmla="*/ 251823 h 402186"/>
              <a:gd name="connsiteX0" fmla="*/ 0 w 4422371"/>
              <a:gd name="connsiteY0" fmla="*/ 201946 h 402186"/>
              <a:gd name="connsiteX1" fmla="*/ 714894 w 4422371"/>
              <a:gd name="connsiteY1" fmla="*/ 19066 h 402186"/>
              <a:gd name="connsiteX2" fmla="*/ 1064029 w 4422371"/>
              <a:gd name="connsiteY2" fmla="*/ 35692 h 402186"/>
              <a:gd name="connsiteX3" fmla="*/ 1463040 w 4422371"/>
              <a:gd name="connsiteY3" fmla="*/ 285074 h 402186"/>
              <a:gd name="connsiteX4" fmla="*/ 2360814 w 4422371"/>
              <a:gd name="connsiteY4" fmla="*/ 401452 h 402186"/>
              <a:gd name="connsiteX5" fmla="*/ 3042458 w 4422371"/>
              <a:gd name="connsiteY5" fmla="*/ 235197 h 402186"/>
              <a:gd name="connsiteX6" fmla="*/ 3507971 w 4422371"/>
              <a:gd name="connsiteY6" fmla="*/ 35692 h 402186"/>
              <a:gd name="connsiteX7" fmla="*/ 4422371 w 4422371"/>
              <a:gd name="connsiteY7" fmla="*/ 251823 h 402186"/>
              <a:gd name="connsiteX8" fmla="*/ 4422371 w 4422371"/>
              <a:gd name="connsiteY8" fmla="*/ 251823 h 402186"/>
              <a:gd name="connsiteX0" fmla="*/ 0 w 4422371"/>
              <a:gd name="connsiteY0" fmla="*/ 201946 h 401803"/>
              <a:gd name="connsiteX1" fmla="*/ 714894 w 4422371"/>
              <a:gd name="connsiteY1" fmla="*/ 19066 h 401803"/>
              <a:gd name="connsiteX2" fmla="*/ 1064029 w 4422371"/>
              <a:gd name="connsiteY2" fmla="*/ 35692 h 401803"/>
              <a:gd name="connsiteX3" fmla="*/ 1463040 w 4422371"/>
              <a:gd name="connsiteY3" fmla="*/ 285074 h 401803"/>
              <a:gd name="connsiteX4" fmla="*/ 2360814 w 4422371"/>
              <a:gd name="connsiteY4" fmla="*/ 401452 h 401803"/>
              <a:gd name="connsiteX5" fmla="*/ 2942705 w 4422371"/>
              <a:gd name="connsiteY5" fmla="*/ 251822 h 401803"/>
              <a:gd name="connsiteX6" fmla="*/ 3507971 w 4422371"/>
              <a:gd name="connsiteY6" fmla="*/ 35692 h 401803"/>
              <a:gd name="connsiteX7" fmla="*/ 4422371 w 4422371"/>
              <a:gd name="connsiteY7" fmla="*/ 251823 h 401803"/>
              <a:gd name="connsiteX8" fmla="*/ 4422371 w 4422371"/>
              <a:gd name="connsiteY8" fmla="*/ 251823 h 401803"/>
              <a:gd name="connsiteX0" fmla="*/ 0 w 4422371"/>
              <a:gd name="connsiteY0" fmla="*/ 167182 h 367039"/>
              <a:gd name="connsiteX1" fmla="*/ 1064029 w 4422371"/>
              <a:gd name="connsiteY1" fmla="*/ 928 h 367039"/>
              <a:gd name="connsiteX2" fmla="*/ 1463040 w 4422371"/>
              <a:gd name="connsiteY2" fmla="*/ 250310 h 367039"/>
              <a:gd name="connsiteX3" fmla="*/ 2360814 w 4422371"/>
              <a:gd name="connsiteY3" fmla="*/ 366688 h 367039"/>
              <a:gd name="connsiteX4" fmla="*/ 2942705 w 4422371"/>
              <a:gd name="connsiteY4" fmla="*/ 217058 h 367039"/>
              <a:gd name="connsiteX5" fmla="*/ 3507971 w 4422371"/>
              <a:gd name="connsiteY5" fmla="*/ 928 h 367039"/>
              <a:gd name="connsiteX6" fmla="*/ 4422371 w 4422371"/>
              <a:gd name="connsiteY6" fmla="*/ 217059 h 367039"/>
              <a:gd name="connsiteX7" fmla="*/ 4422371 w 4422371"/>
              <a:gd name="connsiteY7" fmla="*/ 217059 h 367039"/>
              <a:gd name="connsiteX0" fmla="*/ 0 w 4422371"/>
              <a:gd name="connsiteY0" fmla="*/ 216833 h 416739"/>
              <a:gd name="connsiteX1" fmla="*/ 798022 w 4422371"/>
              <a:gd name="connsiteY1" fmla="*/ 702 h 416739"/>
              <a:gd name="connsiteX2" fmla="*/ 1463040 w 4422371"/>
              <a:gd name="connsiteY2" fmla="*/ 299961 h 416739"/>
              <a:gd name="connsiteX3" fmla="*/ 2360814 w 4422371"/>
              <a:gd name="connsiteY3" fmla="*/ 416339 h 416739"/>
              <a:gd name="connsiteX4" fmla="*/ 2942705 w 4422371"/>
              <a:gd name="connsiteY4" fmla="*/ 266709 h 416739"/>
              <a:gd name="connsiteX5" fmla="*/ 3507971 w 4422371"/>
              <a:gd name="connsiteY5" fmla="*/ 50579 h 416739"/>
              <a:gd name="connsiteX6" fmla="*/ 4422371 w 4422371"/>
              <a:gd name="connsiteY6" fmla="*/ 266710 h 416739"/>
              <a:gd name="connsiteX7" fmla="*/ 4422371 w 4422371"/>
              <a:gd name="connsiteY7" fmla="*/ 266710 h 416739"/>
              <a:gd name="connsiteX0" fmla="*/ 0 w 4422371"/>
              <a:gd name="connsiteY0" fmla="*/ 219118 h 419024"/>
              <a:gd name="connsiteX1" fmla="*/ 798022 w 4422371"/>
              <a:gd name="connsiteY1" fmla="*/ 2987 h 419024"/>
              <a:gd name="connsiteX2" fmla="*/ 1463040 w 4422371"/>
              <a:gd name="connsiteY2" fmla="*/ 302246 h 419024"/>
              <a:gd name="connsiteX3" fmla="*/ 2360814 w 4422371"/>
              <a:gd name="connsiteY3" fmla="*/ 418624 h 419024"/>
              <a:gd name="connsiteX4" fmla="*/ 2942705 w 4422371"/>
              <a:gd name="connsiteY4" fmla="*/ 268994 h 419024"/>
              <a:gd name="connsiteX5" fmla="*/ 3507971 w 4422371"/>
              <a:gd name="connsiteY5" fmla="*/ 52864 h 419024"/>
              <a:gd name="connsiteX6" fmla="*/ 4422371 w 4422371"/>
              <a:gd name="connsiteY6" fmla="*/ 268995 h 419024"/>
              <a:gd name="connsiteX7" fmla="*/ 4422371 w 4422371"/>
              <a:gd name="connsiteY7" fmla="*/ 268995 h 419024"/>
              <a:gd name="connsiteX0" fmla="*/ 0 w 4422371"/>
              <a:gd name="connsiteY0" fmla="*/ 219118 h 429284"/>
              <a:gd name="connsiteX1" fmla="*/ 798022 w 4422371"/>
              <a:gd name="connsiteY1" fmla="*/ 2987 h 429284"/>
              <a:gd name="connsiteX2" fmla="*/ 1463040 w 4422371"/>
              <a:gd name="connsiteY2" fmla="*/ 302246 h 429284"/>
              <a:gd name="connsiteX3" fmla="*/ 2360814 w 4422371"/>
              <a:gd name="connsiteY3" fmla="*/ 418624 h 429284"/>
              <a:gd name="connsiteX4" fmla="*/ 3507971 w 4422371"/>
              <a:gd name="connsiteY4" fmla="*/ 52864 h 429284"/>
              <a:gd name="connsiteX5" fmla="*/ 4422371 w 4422371"/>
              <a:gd name="connsiteY5" fmla="*/ 268995 h 429284"/>
              <a:gd name="connsiteX6" fmla="*/ 4422371 w 4422371"/>
              <a:gd name="connsiteY6" fmla="*/ 268995 h 429284"/>
              <a:gd name="connsiteX0" fmla="*/ 0 w 4422371"/>
              <a:gd name="connsiteY0" fmla="*/ 216834 h 427000"/>
              <a:gd name="connsiteX1" fmla="*/ 798022 w 4422371"/>
              <a:gd name="connsiteY1" fmla="*/ 703 h 427000"/>
              <a:gd name="connsiteX2" fmla="*/ 1463040 w 4422371"/>
              <a:gd name="connsiteY2" fmla="*/ 299962 h 427000"/>
              <a:gd name="connsiteX3" fmla="*/ 2360814 w 4422371"/>
              <a:gd name="connsiteY3" fmla="*/ 416340 h 427000"/>
              <a:gd name="connsiteX4" fmla="*/ 3507971 w 4422371"/>
              <a:gd name="connsiteY4" fmla="*/ 50580 h 427000"/>
              <a:gd name="connsiteX5" fmla="*/ 4422371 w 4422371"/>
              <a:gd name="connsiteY5" fmla="*/ 266711 h 427000"/>
              <a:gd name="connsiteX6" fmla="*/ 4422371 w 4422371"/>
              <a:gd name="connsiteY6" fmla="*/ 266711 h 427000"/>
              <a:gd name="connsiteX0" fmla="*/ 0 w 4422371"/>
              <a:gd name="connsiteY0" fmla="*/ 216834 h 442565"/>
              <a:gd name="connsiteX1" fmla="*/ 798022 w 4422371"/>
              <a:gd name="connsiteY1" fmla="*/ 703 h 442565"/>
              <a:gd name="connsiteX2" fmla="*/ 1463040 w 4422371"/>
              <a:gd name="connsiteY2" fmla="*/ 299962 h 442565"/>
              <a:gd name="connsiteX3" fmla="*/ 2277686 w 4422371"/>
              <a:gd name="connsiteY3" fmla="*/ 432966 h 442565"/>
              <a:gd name="connsiteX4" fmla="*/ 3507971 w 4422371"/>
              <a:gd name="connsiteY4" fmla="*/ 50580 h 442565"/>
              <a:gd name="connsiteX5" fmla="*/ 4422371 w 4422371"/>
              <a:gd name="connsiteY5" fmla="*/ 266711 h 442565"/>
              <a:gd name="connsiteX6" fmla="*/ 4422371 w 4422371"/>
              <a:gd name="connsiteY6" fmla="*/ 266711 h 442565"/>
              <a:gd name="connsiteX0" fmla="*/ 0 w 4422371"/>
              <a:gd name="connsiteY0" fmla="*/ 216834 h 433106"/>
              <a:gd name="connsiteX1" fmla="*/ 798022 w 4422371"/>
              <a:gd name="connsiteY1" fmla="*/ 703 h 433106"/>
              <a:gd name="connsiteX2" fmla="*/ 1463040 w 4422371"/>
              <a:gd name="connsiteY2" fmla="*/ 299962 h 433106"/>
              <a:gd name="connsiteX3" fmla="*/ 2277686 w 4422371"/>
              <a:gd name="connsiteY3" fmla="*/ 432966 h 433106"/>
              <a:gd name="connsiteX4" fmla="*/ 3507971 w 4422371"/>
              <a:gd name="connsiteY4" fmla="*/ 50580 h 433106"/>
              <a:gd name="connsiteX5" fmla="*/ 4422371 w 4422371"/>
              <a:gd name="connsiteY5" fmla="*/ 266711 h 433106"/>
              <a:gd name="connsiteX6" fmla="*/ 4422371 w 4422371"/>
              <a:gd name="connsiteY6" fmla="*/ 266711 h 433106"/>
              <a:gd name="connsiteX0" fmla="*/ 0 w 4422371"/>
              <a:gd name="connsiteY0" fmla="*/ 220142 h 436414"/>
              <a:gd name="connsiteX1" fmla="*/ 798022 w 4422371"/>
              <a:gd name="connsiteY1" fmla="*/ 4011 h 436414"/>
              <a:gd name="connsiteX2" fmla="*/ 2277686 w 4422371"/>
              <a:gd name="connsiteY2" fmla="*/ 436274 h 436414"/>
              <a:gd name="connsiteX3" fmla="*/ 3507971 w 4422371"/>
              <a:gd name="connsiteY3" fmla="*/ 53888 h 436414"/>
              <a:gd name="connsiteX4" fmla="*/ 4422371 w 4422371"/>
              <a:gd name="connsiteY4" fmla="*/ 270019 h 436414"/>
              <a:gd name="connsiteX5" fmla="*/ 4422371 w 4422371"/>
              <a:gd name="connsiteY5" fmla="*/ 270019 h 436414"/>
              <a:gd name="connsiteX0" fmla="*/ 0 w 4422371"/>
              <a:gd name="connsiteY0" fmla="*/ 220142 h 436400"/>
              <a:gd name="connsiteX1" fmla="*/ 798022 w 4422371"/>
              <a:gd name="connsiteY1" fmla="*/ 4011 h 436400"/>
              <a:gd name="connsiteX2" fmla="*/ 2277686 w 4422371"/>
              <a:gd name="connsiteY2" fmla="*/ 436274 h 436400"/>
              <a:gd name="connsiteX3" fmla="*/ 3507971 w 4422371"/>
              <a:gd name="connsiteY3" fmla="*/ 53888 h 436400"/>
              <a:gd name="connsiteX4" fmla="*/ 4422371 w 4422371"/>
              <a:gd name="connsiteY4" fmla="*/ 270019 h 436400"/>
              <a:gd name="connsiteX5" fmla="*/ 4422371 w 4422371"/>
              <a:gd name="connsiteY5" fmla="*/ 270019 h 436400"/>
              <a:gd name="connsiteX0" fmla="*/ 0 w 4422371"/>
              <a:gd name="connsiteY0" fmla="*/ 220142 h 436400"/>
              <a:gd name="connsiteX1" fmla="*/ 798022 w 4422371"/>
              <a:gd name="connsiteY1" fmla="*/ 4011 h 436400"/>
              <a:gd name="connsiteX2" fmla="*/ 2277686 w 4422371"/>
              <a:gd name="connsiteY2" fmla="*/ 436274 h 436400"/>
              <a:gd name="connsiteX3" fmla="*/ 3507971 w 4422371"/>
              <a:gd name="connsiteY3" fmla="*/ 53888 h 436400"/>
              <a:gd name="connsiteX4" fmla="*/ 4422371 w 4422371"/>
              <a:gd name="connsiteY4" fmla="*/ 270019 h 436400"/>
              <a:gd name="connsiteX5" fmla="*/ 4422371 w 4422371"/>
              <a:gd name="connsiteY5" fmla="*/ 270019 h 436400"/>
              <a:gd name="connsiteX0" fmla="*/ 0 w 4422371"/>
              <a:gd name="connsiteY0" fmla="*/ 220142 h 436400"/>
              <a:gd name="connsiteX1" fmla="*/ 798022 w 4422371"/>
              <a:gd name="connsiteY1" fmla="*/ 4011 h 436400"/>
              <a:gd name="connsiteX2" fmla="*/ 2277686 w 4422371"/>
              <a:gd name="connsiteY2" fmla="*/ 436274 h 436400"/>
              <a:gd name="connsiteX3" fmla="*/ 3507971 w 4422371"/>
              <a:gd name="connsiteY3" fmla="*/ 53888 h 436400"/>
              <a:gd name="connsiteX4" fmla="*/ 4422371 w 4422371"/>
              <a:gd name="connsiteY4" fmla="*/ 270019 h 436400"/>
              <a:gd name="connsiteX5" fmla="*/ 4422371 w 4422371"/>
              <a:gd name="connsiteY5" fmla="*/ 270019 h 4364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4422371" h="436400">
                <a:moveTo>
                  <a:pt x="0" y="220142"/>
                </a:moveTo>
                <a:cubicBezTo>
                  <a:pt x="221673" y="185506"/>
                  <a:pt x="418408" y="-32011"/>
                  <a:pt x="798022" y="4011"/>
                </a:cubicBezTo>
                <a:cubicBezTo>
                  <a:pt x="1177636" y="40033"/>
                  <a:pt x="1210886" y="444586"/>
                  <a:pt x="2277686" y="436274"/>
                </a:cubicBezTo>
                <a:cubicBezTo>
                  <a:pt x="3344486" y="427962"/>
                  <a:pt x="3084022" y="114848"/>
                  <a:pt x="3507971" y="53888"/>
                </a:cubicBezTo>
                <a:cubicBezTo>
                  <a:pt x="3931920" y="-7072"/>
                  <a:pt x="4422371" y="270019"/>
                  <a:pt x="4422371" y="270019"/>
                </a:cubicBezTo>
                <a:lnTo>
                  <a:pt x="4422371" y="270019"/>
                </a:lnTo>
              </a:path>
            </a:pathLst>
          </a:custGeom>
          <a:noFill/>
          <a:ln w="76200">
            <a:solidFill>
              <a:schemeClr val="bg1">
                <a:lumMod val="9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28" name="Freihandform 27">
            <a:extLst>
              <a:ext uri="{FF2B5EF4-FFF2-40B4-BE49-F238E27FC236}">
                <a16:creationId xmlns:a16="http://schemas.microsoft.com/office/drawing/2014/main" id="{8A545194-CFBA-0A0E-2D39-51D8AB8457BA}"/>
              </a:ext>
            </a:extLst>
          </p:cNvPr>
          <p:cNvSpPr/>
          <p:nvPr/>
        </p:nvSpPr>
        <p:spPr>
          <a:xfrm>
            <a:off x="6404168" y="6094692"/>
            <a:ext cx="4422371" cy="436400"/>
          </a:xfrm>
          <a:custGeom>
            <a:avLst/>
            <a:gdLst>
              <a:gd name="connsiteX0" fmla="*/ 0 w 4422371"/>
              <a:gd name="connsiteY0" fmla="*/ 201946 h 402186"/>
              <a:gd name="connsiteX1" fmla="*/ 714894 w 4422371"/>
              <a:gd name="connsiteY1" fmla="*/ 19066 h 402186"/>
              <a:gd name="connsiteX2" fmla="*/ 1064029 w 4422371"/>
              <a:gd name="connsiteY2" fmla="*/ 35692 h 402186"/>
              <a:gd name="connsiteX3" fmla="*/ 1463040 w 4422371"/>
              <a:gd name="connsiteY3" fmla="*/ 285074 h 402186"/>
              <a:gd name="connsiteX4" fmla="*/ 2360814 w 4422371"/>
              <a:gd name="connsiteY4" fmla="*/ 401452 h 402186"/>
              <a:gd name="connsiteX5" fmla="*/ 3042458 w 4422371"/>
              <a:gd name="connsiteY5" fmla="*/ 235197 h 402186"/>
              <a:gd name="connsiteX6" fmla="*/ 3241964 w 4422371"/>
              <a:gd name="connsiteY6" fmla="*/ 118819 h 402186"/>
              <a:gd name="connsiteX7" fmla="*/ 3507971 w 4422371"/>
              <a:gd name="connsiteY7" fmla="*/ 35692 h 402186"/>
              <a:gd name="connsiteX8" fmla="*/ 4422371 w 4422371"/>
              <a:gd name="connsiteY8" fmla="*/ 251823 h 402186"/>
              <a:gd name="connsiteX9" fmla="*/ 4422371 w 4422371"/>
              <a:gd name="connsiteY9" fmla="*/ 251823 h 402186"/>
              <a:gd name="connsiteX0" fmla="*/ 0 w 4422371"/>
              <a:gd name="connsiteY0" fmla="*/ 201946 h 402186"/>
              <a:gd name="connsiteX1" fmla="*/ 714894 w 4422371"/>
              <a:gd name="connsiteY1" fmla="*/ 19066 h 402186"/>
              <a:gd name="connsiteX2" fmla="*/ 1064029 w 4422371"/>
              <a:gd name="connsiteY2" fmla="*/ 35692 h 402186"/>
              <a:gd name="connsiteX3" fmla="*/ 1463040 w 4422371"/>
              <a:gd name="connsiteY3" fmla="*/ 285074 h 402186"/>
              <a:gd name="connsiteX4" fmla="*/ 2360814 w 4422371"/>
              <a:gd name="connsiteY4" fmla="*/ 401452 h 402186"/>
              <a:gd name="connsiteX5" fmla="*/ 3042458 w 4422371"/>
              <a:gd name="connsiteY5" fmla="*/ 235197 h 402186"/>
              <a:gd name="connsiteX6" fmla="*/ 3507971 w 4422371"/>
              <a:gd name="connsiteY6" fmla="*/ 35692 h 402186"/>
              <a:gd name="connsiteX7" fmla="*/ 4422371 w 4422371"/>
              <a:gd name="connsiteY7" fmla="*/ 251823 h 402186"/>
              <a:gd name="connsiteX8" fmla="*/ 4422371 w 4422371"/>
              <a:gd name="connsiteY8" fmla="*/ 251823 h 402186"/>
              <a:gd name="connsiteX0" fmla="*/ 0 w 4422371"/>
              <a:gd name="connsiteY0" fmla="*/ 201946 h 401803"/>
              <a:gd name="connsiteX1" fmla="*/ 714894 w 4422371"/>
              <a:gd name="connsiteY1" fmla="*/ 19066 h 401803"/>
              <a:gd name="connsiteX2" fmla="*/ 1064029 w 4422371"/>
              <a:gd name="connsiteY2" fmla="*/ 35692 h 401803"/>
              <a:gd name="connsiteX3" fmla="*/ 1463040 w 4422371"/>
              <a:gd name="connsiteY3" fmla="*/ 285074 h 401803"/>
              <a:gd name="connsiteX4" fmla="*/ 2360814 w 4422371"/>
              <a:gd name="connsiteY4" fmla="*/ 401452 h 401803"/>
              <a:gd name="connsiteX5" fmla="*/ 2942705 w 4422371"/>
              <a:gd name="connsiteY5" fmla="*/ 251822 h 401803"/>
              <a:gd name="connsiteX6" fmla="*/ 3507971 w 4422371"/>
              <a:gd name="connsiteY6" fmla="*/ 35692 h 401803"/>
              <a:gd name="connsiteX7" fmla="*/ 4422371 w 4422371"/>
              <a:gd name="connsiteY7" fmla="*/ 251823 h 401803"/>
              <a:gd name="connsiteX8" fmla="*/ 4422371 w 4422371"/>
              <a:gd name="connsiteY8" fmla="*/ 251823 h 401803"/>
              <a:gd name="connsiteX0" fmla="*/ 0 w 4422371"/>
              <a:gd name="connsiteY0" fmla="*/ 167182 h 367039"/>
              <a:gd name="connsiteX1" fmla="*/ 1064029 w 4422371"/>
              <a:gd name="connsiteY1" fmla="*/ 928 h 367039"/>
              <a:gd name="connsiteX2" fmla="*/ 1463040 w 4422371"/>
              <a:gd name="connsiteY2" fmla="*/ 250310 h 367039"/>
              <a:gd name="connsiteX3" fmla="*/ 2360814 w 4422371"/>
              <a:gd name="connsiteY3" fmla="*/ 366688 h 367039"/>
              <a:gd name="connsiteX4" fmla="*/ 2942705 w 4422371"/>
              <a:gd name="connsiteY4" fmla="*/ 217058 h 367039"/>
              <a:gd name="connsiteX5" fmla="*/ 3507971 w 4422371"/>
              <a:gd name="connsiteY5" fmla="*/ 928 h 367039"/>
              <a:gd name="connsiteX6" fmla="*/ 4422371 w 4422371"/>
              <a:gd name="connsiteY6" fmla="*/ 217059 h 367039"/>
              <a:gd name="connsiteX7" fmla="*/ 4422371 w 4422371"/>
              <a:gd name="connsiteY7" fmla="*/ 217059 h 367039"/>
              <a:gd name="connsiteX0" fmla="*/ 0 w 4422371"/>
              <a:gd name="connsiteY0" fmla="*/ 216833 h 416739"/>
              <a:gd name="connsiteX1" fmla="*/ 798022 w 4422371"/>
              <a:gd name="connsiteY1" fmla="*/ 702 h 416739"/>
              <a:gd name="connsiteX2" fmla="*/ 1463040 w 4422371"/>
              <a:gd name="connsiteY2" fmla="*/ 299961 h 416739"/>
              <a:gd name="connsiteX3" fmla="*/ 2360814 w 4422371"/>
              <a:gd name="connsiteY3" fmla="*/ 416339 h 416739"/>
              <a:gd name="connsiteX4" fmla="*/ 2942705 w 4422371"/>
              <a:gd name="connsiteY4" fmla="*/ 266709 h 416739"/>
              <a:gd name="connsiteX5" fmla="*/ 3507971 w 4422371"/>
              <a:gd name="connsiteY5" fmla="*/ 50579 h 416739"/>
              <a:gd name="connsiteX6" fmla="*/ 4422371 w 4422371"/>
              <a:gd name="connsiteY6" fmla="*/ 266710 h 416739"/>
              <a:gd name="connsiteX7" fmla="*/ 4422371 w 4422371"/>
              <a:gd name="connsiteY7" fmla="*/ 266710 h 416739"/>
              <a:gd name="connsiteX0" fmla="*/ 0 w 4422371"/>
              <a:gd name="connsiteY0" fmla="*/ 219118 h 419024"/>
              <a:gd name="connsiteX1" fmla="*/ 798022 w 4422371"/>
              <a:gd name="connsiteY1" fmla="*/ 2987 h 419024"/>
              <a:gd name="connsiteX2" fmla="*/ 1463040 w 4422371"/>
              <a:gd name="connsiteY2" fmla="*/ 302246 h 419024"/>
              <a:gd name="connsiteX3" fmla="*/ 2360814 w 4422371"/>
              <a:gd name="connsiteY3" fmla="*/ 418624 h 419024"/>
              <a:gd name="connsiteX4" fmla="*/ 2942705 w 4422371"/>
              <a:gd name="connsiteY4" fmla="*/ 268994 h 419024"/>
              <a:gd name="connsiteX5" fmla="*/ 3507971 w 4422371"/>
              <a:gd name="connsiteY5" fmla="*/ 52864 h 419024"/>
              <a:gd name="connsiteX6" fmla="*/ 4422371 w 4422371"/>
              <a:gd name="connsiteY6" fmla="*/ 268995 h 419024"/>
              <a:gd name="connsiteX7" fmla="*/ 4422371 w 4422371"/>
              <a:gd name="connsiteY7" fmla="*/ 268995 h 419024"/>
              <a:gd name="connsiteX0" fmla="*/ 0 w 4422371"/>
              <a:gd name="connsiteY0" fmla="*/ 219118 h 429284"/>
              <a:gd name="connsiteX1" fmla="*/ 798022 w 4422371"/>
              <a:gd name="connsiteY1" fmla="*/ 2987 h 429284"/>
              <a:gd name="connsiteX2" fmla="*/ 1463040 w 4422371"/>
              <a:gd name="connsiteY2" fmla="*/ 302246 h 429284"/>
              <a:gd name="connsiteX3" fmla="*/ 2360814 w 4422371"/>
              <a:gd name="connsiteY3" fmla="*/ 418624 h 429284"/>
              <a:gd name="connsiteX4" fmla="*/ 3507971 w 4422371"/>
              <a:gd name="connsiteY4" fmla="*/ 52864 h 429284"/>
              <a:gd name="connsiteX5" fmla="*/ 4422371 w 4422371"/>
              <a:gd name="connsiteY5" fmla="*/ 268995 h 429284"/>
              <a:gd name="connsiteX6" fmla="*/ 4422371 w 4422371"/>
              <a:gd name="connsiteY6" fmla="*/ 268995 h 429284"/>
              <a:gd name="connsiteX0" fmla="*/ 0 w 4422371"/>
              <a:gd name="connsiteY0" fmla="*/ 216834 h 427000"/>
              <a:gd name="connsiteX1" fmla="*/ 798022 w 4422371"/>
              <a:gd name="connsiteY1" fmla="*/ 703 h 427000"/>
              <a:gd name="connsiteX2" fmla="*/ 1463040 w 4422371"/>
              <a:gd name="connsiteY2" fmla="*/ 299962 h 427000"/>
              <a:gd name="connsiteX3" fmla="*/ 2360814 w 4422371"/>
              <a:gd name="connsiteY3" fmla="*/ 416340 h 427000"/>
              <a:gd name="connsiteX4" fmla="*/ 3507971 w 4422371"/>
              <a:gd name="connsiteY4" fmla="*/ 50580 h 427000"/>
              <a:gd name="connsiteX5" fmla="*/ 4422371 w 4422371"/>
              <a:gd name="connsiteY5" fmla="*/ 266711 h 427000"/>
              <a:gd name="connsiteX6" fmla="*/ 4422371 w 4422371"/>
              <a:gd name="connsiteY6" fmla="*/ 266711 h 427000"/>
              <a:gd name="connsiteX0" fmla="*/ 0 w 4422371"/>
              <a:gd name="connsiteY0" fmla="*/ 216834 h 442565"/>
              <a:gd name="connsiteX1" fmla="*/ 798022 w 4422371"/>
              <a:gd name="connsiteY1" fmla="*/ 703 h 442565"/>
              <a:gd name="connsiteX2" fmla="*/ 1463040 w 4422371"/>
              <a:gd name="connsiteY2" fmla="*/ 299962 h 442565"/>
              <a:gd name="connsiteX3" fmla="*/ 2277686 w 4422371"/>
              <a:gd name="connsiteY3" fmla="*/ 432966 h 442565"/>
              <a:gd name="connsiteX4" fmla="*/ 3507971 w 4422371"/>
              <a:gd name="connsiteY4" fmla="*/ 50580 h 442565"/>
              <a:gd name="connsiteX5" fmla="*/ 4422371 w 4422371"/>
              <a:gd name="connsiteY5" fmla="*/ 266711 h 442565"/>
              <a:gd name="connsiteX6" fmla="*/ 4422371 w 4422371"/>
              <a:gd name="connsiteY6" fmla="*/ 266711 h 442565"/>
              <a:gd name="connsiteX0" fmla="*/ 0 w 4422371"/>
              <a:gd name="connsiteY0" fmla="*/ 216834 h 433106"/>
              <a:gd name="connsiteX1" fmla="*/ 798022 w 4422371"/>
              <a:gd name="connsiteY1" fmla="*/ 703 h 433106"/>
              <a:gd name="connsiteX2" fmla="*/ 1463040 w 4422371"/>
              <a:gd name="connsiteY2" fmla="*/ 299962 h 433106"/>
              <a:gd name="connsiteX3" fmla="*/ 2277686 w 4422371"/>
              <a:gd name="connsiteY3" fmla="*/ 432966 h 433106"/>
              <a:gd name="connsiteX4" fmla="*/ 3507971 w 4422371"/>
              <a:gd name="connsiteY4" fmla="*/ 50580 h 433106"/>
              <a:gd name="connsiteX5" fmla="*/ 4422371 w 4422371"/>
              <a:gd name="connsiteY5" fmla="*/ 266711 h 433106"/>
              <a:gd name="connsiteX6" fmla="*/ 4422371 w 4422371"/>
              <a:gd name="connsiteY6" fmla="*/ 266711 h 433106"/>
              <a:gd name="connsiteX0" fmla="*/ 0 w 4422371"/>
              <a:gd name="connsiteY0" fmla="*/ 220142 h 436414"/>
              <a:gd name="connsiteX1" fmla="*/ 798022 w 4422371"/>
              <a:gd name="connsiteY1" fmla="*/ 4011 h 436414"/>
              <a:gd name="connsiteX2" fmla="*/ 2277686 w 4422371"/>
              <a:gd name="connsiteY2" fmla="*/ 436274 h 436414"/>
              <a:gd name="connsiteX3" fmla="*/ 3507971 w 4422371"/>
              <a:gd name="connsiteY3" fmla="*/ 53888 h 436414"/>
              <a:gd name="connsiteX4" fmla="*/ 4422371 w 4422371"/>
              <a:gd name="connsiteY4" fmla="*/ 270019 h 436414"/>
              <a:gd name="connsiteX5" fmla="*/ 4422371 w 4422371"/>
              <a:gd name="connsiteY5" fmla="*/ 270019 h 436414"/>
              <a:gd name="connsiteX0" fmla="*/ 0 w 4422371"/>
              <a:gd name="connsiteY0" fmla="*/ 220142 h 436400"/>
              <a:gd name="connsiteX1" fmla="*/ 798022 w 4422371"/>
              <a:gd name="connsiteY1" fmla="*/ 4011 h 436400"/>
              <a:gd name="connsiteX2" fmla="*/ 2277686 w 4422371"/>
              <a:gd name="connsiteY2" fmla="*/ 436274 h 436400"/>
              <a:gd name="connsiteX3" fmla="*/ 3507971 w 4422371"/>
              <a:gd name="connsiteY3" fmla="*/ 53888 h 436400"/>
              <a:gd name="connsiteX4" fmla="*/ 4422371 w 4422371"/>
              <a:gd name="connsiteY4" fmla="*/ 270019 h 436400"/>
              <a:gd name="connsiteX5" fmla="*/ 4422371 w 4422371"/>
              <a:gd name="connsiteY5" fmla="*/ 270019 h 436400"/>
              <a:gd name="connsiteX0" fmla="*/ 0 w 4422371"/>
              <a:gd name="connsiteY0" fmla="*/ 220142 h 436400"/>
              <a:gd name="connsiteX1" fmla="*/ 798022 w 4422371"/>
              <a:gd name="connsiteY1" fmla="*/ 4011 h 436400"/>
              <a:gd name="connsiteX2" fmla="*/ 2277686 w 4422371"/>
              <a:gd name="connsiteY2" fmla="*/ 436274 h 436400"/>
              <a:gd name="connsiteX3" fmla="*/ 3507971 w 4422371"/>
              <a:gd name="connsiteY3" fmla="*/ 53888 h 436400"/>
              <a:gd name="connsiteX4" fmla="*/ 4422371 w 4422371"/>
              <a:gd name="connsiteY4" fmla="*/ 270019 h 436400"/>
              <a:gd name="connsiteX5" fmla="*/ 4422371 w 4422371"/>
              <a:gd name="connsiteY5" fmla="*/ 270019 h 436400"/>
              <a:gd name="connsiteX0" fmla="*/ 0 w 4422371"/>
              <a:gd name="connsiteY0" fmla="*/ 220142 h 436400"/>
              <a:gd name="connsiteX1" fmla="*/ 798022 w 4422371"/>
              <a:gd name="connsiteY1" fmla="*/ 4011 h 436400"/>
              <a:gd name="connsiteX2" fmla="*/ 2277686 w 4422371"/>
              <a:gd name="connsiteY2" fmla="*/ 436274 h 436400"/>
              <a:gd name="connsiteX3" fmla="*/ 3507971 w 4422371"/>
              <a:gd name="connsiteY3" fmla="*/ 53888 h 436400"/>
              <a:gd name="connsiteX4" fmla="*/ 4422371 w 4422371"/>
              <a:gd name="connsiteY4" fmla="*/ 270019 h 436400"/>
              <a:gd name="connsiteX5" fmla="*/ 4422371 w 4422371"/>
              <a:gd name="connsiteY5" fmla="*/ 270019 h 4364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4422371" h="436400">
                <a:moveTo>
                  <a:pt x="0" y="220142"/>
                </a:moveTo>
                <a:cubicBezTo>
                  <a:pt x="221673" y="185506"/>
                  <a:pt x="418408" y="-32011"/>
                  <a:pt x="798022" y="4011"/>
                </a:cubicBezTo>
                <a:cubicBezTo>
                  <a:pt x="1177636" y="40033"/>
                  <a:pt x="1210886" y="444586"/>
                  <a:pt x="2277686" y="436274"/>
                </a:cubicBezTo>
                <a:cubicBezTo>
                  <a:pt x="3344486" y="427962"/>
                  <a:pt x="3084022" y="114848"/>
                  <a:pt x="3507971" y="53888"/>
                </a:cubicBezTo>
                <a:cubicBezTo>
                  <a:pt x="3931920" y="-7072"/>
                  <a:pt x="4422371" y="270019"/>
                  <a:pt x="4422371" y="270019"/>
                </a:cubicBezTo>
                <a:lnTo>
                  <a:pt x="4422371" y="270019"/>
                </a:lnTo>
              </a:path>
            </a:pathLst>
          </a:custGeom>
          <a:noFill/>
          <a:ln w="7620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32" name="Gerade Verbindung 31">
            <a:extLst>
              <a:ext uri="{FF2B5EF4-FFF2-40B4-BE49-F238E27FC236}">
                <a16:creationId xmlns:a16="http://schemas.microsoft.com/office/drawing/2014/main" id="{42EFB83A-EF6B-AC5E-4DFF-B6FDDF675510}"/>
              </a:ext>
            </a:extLst>
          </p:cNvPr>
          <p:cNvCxnSpPr>
            <a:cxnSpLocks/>
          </p:cNvCxnSpPr>
          <p:nvPr/>
        </p:nvCxnSpPr>
        <p:spPr>
          <a:xfrm>
            <a:off x="4698071" y="2081284"/>
            <a:ext cx="1619755" cy="2308036"/>
          </a:xfrm>
          <a:prstGeom prst="line">
            <a:avLst/>
          </a:prstGeom>
          <a:ln w="1905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4" name="Gerade Verbindung 33">
            <a:extLst>
              <a:ext uri="{FF2B5EF4-FFF2-40B4-BE49-F238E27FC236}">
                <a16:creationId xmlns:a16="http://schemas.microsoft.com/office/drawing/2014/main" id="{D906B5F4-8612-9F0A-87C6-9B5FBAC1070F}"/>
              </a:ext>
            </a:extLst>
          </p:cNvPr>
          <p:cNvCxnSpPr>
            <a:cxnSpLocks/>
          </p:cNvCxnSpPr>
          <p:nvPr/>
        </p:nvCxnSpPr>
        <p:spPr>
          <a:xfrm>
            <a:off x="5270271" y="2876206"/>
            <a:ext cx="598516" cy="881149"/>
          </a:xfrm>
          <a:prstGeom prst="line">
            <a:avLst/>
          </a:prstGeom>
          <a:ln w="190500">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8" name="Straight Arrow Connector 7">
            <a:extLst>
              <a:ext uri="{FF2B5EF4-FFF2-40B4-BE49-F238E27FC236}">
                <a16:creationId xmlns:a16="http://schemas.microsoft.com/office/drawing/2014/main" id="{C4827DF2-726E-984C-64C4-23F9A2E2B7EC}"/>
              </a:ext>
            </a:extLst>
          </p:cNvPr>
          <p:cNvCxnSpPr/>
          <p:nvPr/>
        </p:nvCxnSpPr>
        <p:spPr>
          <a:xfrm flipV="1">
            <a:off x="2369226" y="681476"/>
            <a:ext cx="4875719" cy="517728"/>
          </a:xfrm>
          <a:prstGeom prst="straightConnector1">
            <a:avLst/>
          </a:prstGeom>
          <a:ln w="28575">
            <a:solidFill>
              <a:schemeClr val="bg1">
                <a:lumMod val="85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9" name="Straight Arrow Connector 8">
            <a:extLst>
              <a:ext uri="{FF2B5EF4-FFF2-40B4-BE49-F238E27FC236}">
                <a16:creationId xmlns:a16="http://schemas.microsoft.com/office/drawing/2014/main" id="{385F425F-92FA-AB82-B14F-FCE1FA94120D}"/>
              </a:ext>
            </a:extLst>
          </p:cNvPr>
          <p:cNvCxnSpPr>
            <a:cxnSpLocks/>
          </p:cNvCxnSpPr>
          <p:nvPr/>
        </p:nvCxnSpPr>
        <p:spPr>
          <a:xfrm>
            <a:off x="1839608" y="3009629"/>
            <a:ext cx="4459592" cy="1357548"/>
          </a:xfrm>
          <a:prstGeom prst="straightConnector1">
            <a:avLst/>
          </a:prstGeom>
          <a:ln w="28575">
            <a:solidFill>
              <a:schemeClr val="bg1">
                <a:lumMod val="85000"/>
              </a:schemeClr>
            </a:solidFill>
            <a:prstDash val="dash"/>
          </a:ln>
        </p:spPr>
        <p:style>
          <a:lnRef idx="1">
            <a:schemeClr val="accent1"/>
          </a:lnRef>
          <a:fillRef idx="0">
            <a:schemeClr val="accent1"/>
          </a:fillRef>
          <a:effectRef idx="0">
            <a:schemeClr val="accent1"/>
          </a:effectRef>
          <a:fontRef idx="minor">
            <a:schemeClr val="tx1"/>
          </a:fontRef>
        </p:style>
      </p:cxnSp>
      <p:sp>
        <p:nvSpPr>
          <p:cNvPr id="11" name="TextBox 10">
            <a:extLst>
              <a:ext uri="{FF2B5EF4-FFF2-40B4-BE49-F238E27FC236}">
                <a16:creationId xmlns:a16="http://schemas.microsoft.com/office/drawing/2014/main" id="{6AB24474-405B-7E39-F9BA-016C782FCED7}"/>
              </a:ext>
            </a:extLst>
          </p:cNvPr>
          <p:cNvSpPr txBox="1"/>
          <p:nvPr/>
        </p:nvSpPr>
        <p:spPr>
          <a:xfrm>
            <a:off x="1679697" y="2011232"/>
            <a:ext cx="2743199"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cs typeface="Calibri"/>
              </a:rPr>
              <a:t>S1</a:t>
            </a:r>
            <a:endParaRPr lang="en-US" dirty="0"/>
          </a:p>
        </p:txBody>
      </p:sp>
      <p:sp>
        <p:nvSpPr>
          <p:cNvPr id="12" name="TextBox 11">
            <a:extLst>
              <a:ext uri="{FF2B5EF4-FFF2-40B4-BE49-F238E27FC236}">
                <a16:creationId xmlns:a16="http://schemas.microsoft.com/office/drawing/2014/main" id="{30A557B3-47CE-5B66-0B01-E74C0F3E3C6C}"/>
              </a:ext>
            </a:extLst>
          </p:cNvPr>
          <p:cNvSpPr txBox="1"/>
          <p:nvPr/>
        </p:nvSpPr>
        <p:spPr>
          <a:xfrm>
            <a:off x="2366037" y="3232593"/>
            <a:ext cx="2743199"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cs typeface="Calibri"/>
              </a:rPr>
              <a:t>S2</a:t>
            </a:r>
            <a:endParaRPr lang="en-US" dirty="0"/>
          </a:p>
        </p:txBody>
      </p:sp>
      <p:sp>
        <p:nvSpPr>
          <p:cNvPr id="13" name="TextBox 12">
            <a:extLst>
              <a:ext uri="{FF2B5EF4-FFF2-40B4-BE49-F238E27FC236}">
                <a16:creationId xmlns:a16="http://schemas.microsoft.com/office/drawing/2014/main" id="{A9CF194B-6C8F-D61C-9927-63AE1CF9219F}"/>
              </a:ext>
            </a:extLst>
          </p:cNvPr>
          <p:cNvSpPr txBox="1"/>
          <p:nvPr/>
        </p:nvSpPr>
        <p:spPr>
          <a:xfrm>
            <a:off x="6143612" y="2432764"/>
            <a:ext cx="2743199"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cs typeface="Calibri"/>
              </a:rPr>
              <a:t>S1</a:t>
            </a:r>
            <a:endParaRPr lang="en-US" dirty="0"/>
          </a:p>
        </p:txBody>
      </p:sp>
      <p:sp>
        <p:nvSpPr>
          <p:cNvPr id="14" name="Textfeld 13">
            <a:extLst>
              <a:ext uri="{FF2B5EF4-FFF2-40B4-BE49-F238E27FC236}">
                <a16:creationId xmlns:a16="http://schemas.microsoft.com/office/drawing/2014/main" id="{7C2C898C-CB31-9F41-D1E7-8AA27B71B9D1}"/>
              </a:ext>
            </a:extLst>
          </p:cNvPr>
          <p:cNvSpPr txBox="1"/>
          <p:nvPr/>
        </p:nvSpPr>
        <p:spPr>
          <a:xfrm>
            <a:off x="228600" y="444500"/>
            <a:ext cx="2069990" cy="369332"/>
          </a:xfrm>
          <a:prstGeom prst="rect">
            <a:avLst/>
          </a:prstGeom>
          <a:noFill/>
        </p:spPr>
        <p:txBody>
          <a:bodyPr wrap="none" lIns="91440" tIns="45720" rIns="91440" bIns="45720" rtlCol="0" anchor="t">
            <a:spAutoFit/>
          </a:bodyPr>
          <a:lstStyle/>
          <a:p>
            <a:r>
              <a:rPr lang="de-CH" dirty="0"/>
              <a:t>Appendix 2, </a:t>
            </a:r>
            <a:r>
              <a:rPr lang="de-CH" dirty="0" err="1"/>
              <a:t>figure</a:t>
            </a:r>
            <a:r>
              <a:rPr lang="de-CH" dirty="0"/>
              <a:t> 2</a:t>
            </a:r>
          </a:p>
        </p:txBody>
      </p:sp>
    </p:spTree>
    <p:extLst>
      <p:ext uri="{BB962C8B-B14F-4D97-AF65-F5344CB8AC3E}">
        <p14:creationId xmlns:p14="http://schemas.microsoft.com/office/powerpoint/2010/main" val="216502089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a:extLst>
              <a:ext uri="{FF2B5EF4-FFF2-40B4-BE49-F238E27FC236}">
                <a16:creationId xmlns:a16="http://schemas.microsoft.com/office/drawing/2014/main" id="{3DD0E67C-6E21-F37D-C9E3-FEB0ADD6416E}"/>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284412" y="0"/>
            <a:ext cx="7623175" cy="6858000"/>
          </a:xfrm>
          <a:prstGeom prst="rect">
            <a:avLst/>
          </a:prstGeom>
          <a:noFill/>
          <a:extLst>
            <a:ext uri="{909E8E84-426E-40DD-AFC4-6F175D3DCCD1}">
              <a14:hiddenFill xmlns:a14="http://schemas.microsoft.com/office/drawing/2010/main">
                <a:solidFill>
                  <a:srgbClr val="FFFFFF"/>
                </a:solidFill>
              </a14:hiddenFill>
            </a:ext>
          </a:extLst>
        </p:spPr>
      </p:pic>
      <p:pic>
        <p:nvPicPr>
          <p:cNvPr id="13" name="Grafik 12" descr="Auge">
            <a:extLst>
              <a:ext uri="{FF2B5EF4-FFF2-40B4-BE49-F238E27FC236}">
                <a16:creationId xmlns:a16="http://schemas.microsoft.com/office/drawing/2014/main" id="{847A5B60-3796-0588-3BC7-7A6C9C1FFA3D}"/>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3578763" y="-457200"/>
            <a:ext cx="914400" cy="914400"/>
          </a:xfrm>
          <a:prstGeom prst="rect">
            <a:avLst/>
          </a:prstGeom>
        </p:spPr>
      </p:pic>
      <p:sp>
        <p:nvSpPr>
          <p:cNvPr id="23" name="Freihandform 22">
            <a:extLst>
              <a:ext uri="{FF2B5EF4-FFF2-40B4-BE49-F238E27FC236}">
                <a16:creationId xmlns:a16="http://schemas.microsoft.com/office/drawing/2014/main" id="{766E6536-9DBB-EF3F-6F5E-998F9BF97A8A}"/>
              </a:ext>
            </a:extLst>
          </p:cNvPr>
          <p:cNvSpPr/>
          <p:nvPr/>
        </p:nvSpPr>
        <p:spPr>
          <a:xfrm rot="8566892">
            <a:off x="9097645" y="1577821"/>
            <a:ext cx="165438" cy="480508"/>
          </a:xfrm>
          <a:custGeom>
            <a:avLst/>
            <a:gdLst>
              <a:gd name="connsiteX0" fmla="*/ 22 w 512509"/>
              <a:gd name="connsiteY0" fmla="*/ 487947 h 967477"/>
              <a:gd name="connsiteX1" fmla="*/ 320089 w 512509"/>
              <a:gd name="connsiteY1" fmla="*/ 83255 h 967477"/>
              <a:gd name="connsiteX2" fmla="*/ 366348 w 512509"/>
              <a:gd name="connsiteY2" fmla="*/ 77662 h 967477"/>
              <a:gd name="connsiteX3" fmla="*/ 292146 w 512509"/>
              <a:gd name="connsiteY3" fmla="*/ 0 h 967477"/>
              <a:gd name="connsiteX4" fmla="*/ 402328 w 512509"/>
              <a:gd name="connsiteY4" fmla="*/ 0 h 967477"/>
              <a:gd name="connsiteX5" fmla="*/ 512509 w 512509"/>
              <a:gd name="connsiteY5" fmla="*/ 115320 h 967477"/>
              <a:gd name="connsiteX6" fmla="*/ 402328 w 512509"/>
              <a:gd name="connsiteY6" fmla="*/ 230640 h 967477"/>
              <a:gd name="connsiteX7" fmla="*/ 292146 w 512509"/>
              <a:gd name="connsiteY7" fmla="*/ 230640 h 967477"/>
              <a:gd name="connsiteX8" fmla="*/ 349748 w 512509"/>
              <a:gd name="connsiteY8" fmla="*/ 170352 h 967477"/>
              <a:gd name="connsiteX9" fmla="*/ 278477 w 512509"/>
              <a:gd name="connsiteY9" fmla="*/ 186170 h 967477"/>
              <a:gd name="connsiteX10" fmla="*/ 85044 w 512509"/>
              <a:gd name="connsiteY10" fmla="*/ 487076 h 967477"/>
              <a:gd name="connsiteX11" fmla="*/ 284608 w 512509"/>
              <a:gd name="connsiteY11" fmla="*/ 783952 h 967477"/>
              <a:gd name="connsiteX12" fmla="*/ 349615 w 512509"/>
              <a:gd name="connsiteY12" fmla="*/ 796987 h 967477"/>
              <a:gd name="connsiteX13" fmla="*/ 292145 w 512509"/>
              <a:gd name="connsiteY13" fmla="*/ 736837 h 967477"/>
              <a:gd name="connsiteX14" fmla="*/ 402327 w 512509"/>
              <a:gd name="connsiteY14" fmla="*/ 736837 h 967477"/>
              <a:gd name="connsiteX15" fmla="*/ 512508 w 512509"/>
              <a:gd name="connsiteY15" fmla="*/ 852157 h 967477"/>
              <a:gd name="connsiteX16" fmla="*/ 402327 w 512509"/>
              <a:gd name="connsiteY16" fmla="*/ 967477 h 967477"/>
              <a:gd name="connsiteX17" fmla="*/ 292145 w 512509"/>
              <a:gd name="connsiteY17" fmla="*/ 967477 h 967477"/>
              <a:gd name="connsiteX18" fmla="*/ 366362 w 512509"/>
              <a:gd name="connsiteY18" fmla="*/ 889799 h 967477"/>
              <a:gd name="connsiteX19" fmla="*/ 328321 w 512509"/>
              <a:gd name="connsiteY19" fmla="*/ 885990 h 967477"/>
              <a:gd name="connsiteX20" fmla="*/ 22 w 512509"/>
              <a:gd name="connsiteY20" fmla="*/ 487947 h 96747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Lst>
            <a:rect l="l" t="t" r="r" b="b"/>
            <a:pathLst>
              <a:path w="512509" h="967477">
                <a:moveTo>
                  <a:pt x="22" y="487947"/>
                </a:moveTo>
                <a:cubicBezTo>
                  <a:pt x="-1997" y="291031"/>
                  <a:pt x="135054" y="124822"/>
                  <a:pt x="320089" y="83255"/>
                </a:cubicBezTo>
                <a:lnTo>
                  <a:pt x="366348" y="77662"/>
                </a:lnTo>
                <a:lnTo>
                  <a:pt x="292146" y="0"/>
                </a:lnTo>
                <a:lnTo>
                  <a:pt x="402328" y="0"/>
                </a:lnTo>
                <a:lnTo>
                  <a:pt x="512509" y="115320"/>
                </a:lnTo>
                <a:lnTo>
                  <a:pt x="402328" y="230640"/>
                </a:lnTo>
                <a:lnTo>
                  <a:pt x="292146" y="230640"/>
                </a:lnTo>
                <a:lnTo>
                  <a:pt x="349748" y="170352"/>
                </a:lnTo>
                <a:lnTo>
                  <a:pt x="278477" y="186170"/>
                </a:lnTo>
                <a:cubicBezTo>
                  <a:pt x="163309" y="237317"/>
                  <a:pt x="83672" y="353252"/>
                  <a:pt x="85044" y="487076"/>
                </a:cubicBezTo>
                <a:cubicBezTo>
                  <a:pt x="86417" y="620899"/>
                  <a:pt x="168415" y="735177"/>
                  <a:pt x="284608" y="783952"/>
                </a:cubicBezTo>
                <a:lnTo>
                  <a:pt x="349615" y="796987"/>
                </a:lnTo>
                <a:lnTo>
                  <a:pt x="292145" y="736837"/>
                </a:lnTo>
                <a:lnTo>
                  <a:pt x="402327" y="736837"/>
                </a:lnTo>
                <a:lnTo>
                  <a:pt x="512508" y="852157"/>
                </a:lnTo>
                <a:lnTo>
                  <a:pt x="402327" y="967477"/>
                </a:lnTo>
                <a:lnTo>
                  <a:pt x="292145" y="967477"/>
                </a:lnTo>
                <a:lnTo>
                  <a:pt x="366362" y="889799"/>
                </a:lnTo>
                <a:lnTo>
                  <a:pt x="328321" y="885990"/>
                </a:lnTo>
                <a:cubicBezTo>
                  <a:pt x="142473" y="848226"/>
                  <a:pt x="2042" y="684864"/>
                  <a:pt x="22" y="487947"/>
                </a:cubicBezTo>
                <a:close/>
              </a:path>
            </a:pathLst>
          </a:custGeom>
          <a:solidFill>
            <a:schemeClr val="accent1">
              <a:lumMod val="40000"/>
              <a:lumOff val="60000"/>
            </a:schemeClr>
          </a:solidFill>
          <a:ln>
            <a:solidFill>
              <a:schemeClr val="accent1">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de-DE">
              <a:solidFill>
                <a:schemeClr val="tx1"/>
              </a:solidFill>
            </a:endParaRPr>
          </a:p>
        </p:txBody>
      </p:sp>
      <p:cxnSp>
        <p:nvCxnSpPr>
          <p:cNvPr id="25" name="Gerade Verbindung mit Pfeil 24">
            <a:extLst>
              <a:ext uri="{FF2B5EF4-FFF2-40B4-BE49-F238E27FC236}">
                <a16:creationId xmlns:a16="http://schemas.microsoft.com/office/drawing/2014/main" id="{358C83BF-265F-410B-A8E6-EEF1278389E7}"/>
              </a:ext>
            </a:extLst>
          </p:cNvPr>
          <p:cNvCxnSpPr>
            <a:cxnSpLocks/>
          </p:cNvCxnSpPr>
          <p:nvPr/>
        </p:nvCxnSpPr>
        <p:spPr>
          <a:xfrm flipH="1">
            <a:off x="6114193" y="2228283"/>
            <a:ext cx="481102" cy="302758"/>
          </a:xfrm>
          <a:prstGeom prst="straightConnector1">
            <a:avLst/>
          </a:prstGeom>
          <a:ln w="28575">
            <a:solidFill>
              <a:srgbClr val="FFC000"/>
            </a:solidFill>
            <a:headEnd type="triangle"/>
            <a:tailEnd type="triangle"/>
          </a:ln>
        </p:spPr>
        <p:style>
          <a:lnRef idx="1">
            <a:schemeClr val="accent1"/>
          </a:lnRef>
          <a:fillRef idx="0">
            <a:schemeClr val="accent1"/>
          </a:fillRef>
          <a:effectRef idx="0">
            <a:schemeClr val="accent1"/>
          </a:effectRef>
          <a:fontRef idx="minor">
            <a:schemeClr val="tx1"/>
          </a:fontRef>
        </p:style>
      </p:cxnSp>
      <p:sp>
        <p:nvSpPr>
          <p:cNvPr id="4" name="Freihandform 3">
            <a:extLst>
              <a:ext uri="{FF2B5EF4-FFF2-40B4-BE49-F238E27FC236}">
                <a16:creationId xmlns:a16="http://schemas.microsoft.com/office/drawing/2014/main" id="{C8355A5D-C508-419A-C8C8-8BBBE7F905EC}"/>
              </a:ext>
            </a:extLst>
          </p:cNvPr>
          <p:cNvSpPr/>
          <p:nvPr/>
        </p:nvSpPr>
        <p:spPr>
          <a:xfrm>
            <a:off x="6178317" y="2202568"/>
            <a:ext cx="746056" cy="189418"/>
          </a:xfrm>
          <a:custGeom>
            <a:avLst/>
            <a:gdLst>
              <a:gd name="connsiteX0" fmla="*/ 746056 w 746056"/>
              <a:gd name="connsiteY0" fmla="*/ 33372 h 189418"/>
              <a:gd name="connsiteX1" fmla="*/ 552497 w 746056"/>
              <a:gd name="connsiteY1" fmla="*/ 106791 h 189418"/>
              <a:gd name="connsiteX2" fmla="*/ 245472 w 746056"/>
              <a:gd name="connsiteY2" fmla="*/ 180210 h 189418"/>
              <a:gd name="connsiteX3" fmla="*/ 118657 w 746056"/>
              <a:gd name="connsiteY3" fmla="*/ 186885 h 189418"/>
              <a:gd name="connsiteX4" fmla="*/ 58587 w 746056"/>
              <a:gd name="connsiteY4" fmla="*/ 166861 h 189418"/>
              <a:gd name="connsiteX5" fmla="*/ 11866 w 746056"/>
              <a:gd name="connsiteY5" fmla="*/ 133489 h 189418"/>
              <a:gd name="connsiteX6" fmla="*/ 5191 w 746056"/>
              <a:gd name="connsiteY6" fmla="*/ 80093 h 189418"/>
              <a:gd name="connsiteX7" fmla="*/ 78610 w 746056"/>
              <a:gd name="connsiteY7" fmla="*/ 0 h 1894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746056" h="189418">
                <a:moveTo>
                  <a:pt x="746056" y="33372"/>
                </a:moveTo>
                <a:cubicBezTo>
                  <a:pt x="690992" y="57845"/>
                  <a:pt x="635928" y="82318"/>
                  <a:pt x="552497" y="106791"/>
                </a:cubicBezTo>
                <a:cubicBezTo>
                  <a:pt x="469066" y="131264"/>
                  <a:pt x="317778" y="166861"/>
                  <a:pt x="245472" y="180210"/>
                </a:cubicBezTo>
                <a:cubicBezTo>
                  <a:pt x="173166" y="193559"/>
                  <a:pt x="149804" y="189110"/>
                  <a:pt x="118657" y="186885"/>
                </a:cubicBezTo>
                <a:cubicBezTo>
                  <a:pt x="87510" y="184660"/>
                  <a:pt x="76385" y="175760"/>
                  <a:pt x="58587" y="166861"/>
                </a:cubicBezTo>
                <a:cubicBezTo>
                  <a:pt x="40789" y="157962"/>
                  <a:pt x="20765" y="147950"/>
                  <a:pt x="11866" y="133489"/>
                </a:cubicBezTo>
                <a:cubicBezTo>
                  <a:pt x="2967" y="119028"/>
                  <a:pt x="-5933" y="102341"/>
                  <a:pt x="5191" y="80093"/>
                </a:cubicBezTo>
                <a:cubicBezTo>
                  <a:pt x="16315" y="57845"/>
                  <a:pt x="47462" y="28922"/>
                  <a:pt x="78610" y="0"/>
                </a:cubicBezTo>
              </a:path>
            </a:pathLst>
          </a:cu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7" name="Gerade Verbindung 6">
            <a:extLst>
              <a:ext uri="{FF2B5EF4-FFF2-40B4-BE49-F238E27FC236}">
                <a16:creationId xmlns:a16="http://schemas.microsoft.com/office/drawing/2014/main" id="{41070653-6A0F-F466-1619-90151AEC6B0F}"/>
              </a:ext>
            </a:extLst>
          </p:cNvPr>
          <p:cNvCxnSpPr>
            <a:cxnSpLocks/>
          </p:cNvCxnSpPr>
          <p:nvPr/>
        </p:nvCxnSpPr>
        <p:spPr>
          <a:xfrm>
            <a:off x="4584536" y="165594"/>
            <a:ext cx="2419403" cy="1"/>
          </a:xfrm>
          <a:prstGeom prst="line">
            <a:avLst/>
          </a:prstGeom>
          <a:ln w="57150">
            <a:solidFill>
              <a:srgbClr val="FFFF00">
                <a:alpha val="50196"/>
              </a:srgbClr>
            </a:solidFill>
          </a:ln>
        </p:spPr>
        <p:style>
          <a:lnRef idx="1">
            <a:schemeClr val="accent1"/>
          </a:lnRef>
          <a:fillRef idx="0">
            <a:schemeClr val="accent1"/>
          </a:fillRef>
          <a:effectRef idx="0">
            <a:schemeClr val="accent1"/>
          </a:effectRef>
          <a:fontRef idx="minor">
            <a:schemeClr val="tx1"/>
          </a:fontRef>
        </p:style>
      </p:cxnSp>
      <p:sp>
        <p:nvSpPr>
          <p:cNvPr id="11" name="Freihandform 10">
            <a:extLst>
              <a:ext uri="{FF2B5EF4-FFF2-40B4-BE49-F238E27FC236}">
                <a16:creationId xmlns:a16="http://schemas.microsoft.com/office/drawing/2014/main" id="{B93C214A-64EE-0CEA-BFA9-7FC0E68A585E}"/>
              </a:ext>
            </a:extLst>
          </p:cNvPr>
          <p:cNvSpPr/>
          <p:nvPr/>
        </p:nvSpPr>
        <p:spPr>
          <a:xfrm rot="4279627">
            <a:off x="4665780" y="33658"/>
            <a:ext cx="645458" cy="634701"/>
          </a:xfrm>
          <a:custGeom>
            <a:avLst/>
            <a:gdLst>
              <a:gd name="connsiteX0" fmla="*/ 10756 w 645458"/>
              <a:gd name="connsiteY0" fmla="*/ 0 h 634701"/>
              <a:gd name="connsiteX1" fmla="*/ 632563 w 645458"/>
              <a:gd name="connsiteY1" fmla="*/ 506788 h 634701"/>
              <a:gd name="connsiteX2" fmla="*/ 645458 w 645458"/>
              <a:gd name="connsiteY2" fmla="*/ 634701 h 634701"/>
              <a:gd name="connsiteX3" fmla="*/ 0 w 645458"/>
              <a:gd name="connsiteY3" fmla="*/ 634701 h 634701"/>
              <a:gd name="connsiteX4" fmla="*/ 0 w 645458"/>
              <a:gd name="connsiteY4" fmla="*/ 949 h 634701"/>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645458" h="634701">
                <a:moveTo>
                  <a:pt x="10756" y="0"/>
                </a:moveTo>
                <a:cubicBezTo>
                  <a:pt x="317475" y="0"/>
                  <a:pt x="573380" y="217565"/>
                  <a:pt x="632563" y="506788"/>
                </a:cubicBezTo>
                <a:lnTo>
                  <a:pt x="645458" y="634701"/>
                </a:lnTo>
                <a:lnTo>
                  <a:pt x="0" y="634701"/>
                </a:lnTo>
                <a:lnTo>
                  <a:pt x="0" y="949"/>
                </a:lnTo>
                <a:close/>
              </a:path>
            </a:pathLst>
          </a:custGeom>
          <a:noFill/>
          <a:ln w="571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de-DE"/>
          </a:p>
        </p:txBody>
      </p:sp>
      <p:cxnSp>
        <p:nvCxnSpPr>
          <p:cNvPr id="5" name="Gerade Verbindung mit Pfeil 4">
            <a:extLst>
              <a:ext uri="{FF2B5EF4-FFF2-40B4-BE49-F238E27FC236}">
                <a16:creationId xmlns:a16="http://schemas.microsoft.com/office/drawing/2014/main" id="{FB2EB22C-08B1-7DCD-3041-2BD68EC5F4CE}"/>
              </a:ext>
            </a:extLst>
          </p:cNvPr>
          <p:cNvCxnSpPr>
            <a:cxnSpLocks/>
          </p:cNvCxnSpPr>
          <p:nvPr/>
        </p:nvCxnSpPr>
        <p:spPr>
          <a:xfrm rot="5700515" flipV="1">
            <a:off x="4409925" y="315715"/>
            <a:ext cx="2103927" cy="1943935"/>
          </a:xfrm>
          <a:prstGeom prst="straightConnector1">
            <a:avLst/>
          </a:prstGeom>
          <a:ln w="57150">
            <a:solidFill>
              <a:srgbClr val="FFFF00"/>
            </a:solidFill>
            <a:tailEnd type="triangle"/>
          </a:ln>
        </p:spPr>
        <p:style>
          <a:lnRef idx="1">
            <a:schemeClr val="accent1"/>
          </a:lnRef>
          <a:fillRef idx="0">
            <a:schemeClr val="accent1"/>
          </a:fillRef>
          <a:effectRef idx="0">
            <a:schemeClr val="accent1"/>
          </a:effectRef>
          <a:fontRef idx="minor">
            <a:schemeClr val="tx1"/>
          </a:fontRef>
        </p:style>
      </p:cxnSp>
      <p:pic>
        <p:nvPicPr>
          <p:cNvPr id="9" name="Grafik 8">
            <a:extLst>
              <a:ext uri="{FF2B5EF4-FFF2-40B4-BE49-F238E27FC236}">
                <a16:creationId xmlns:a16="http://schemas.microsoft.com/office/drawing/2014/main" id="{56885402-D1A6-964C-488C-D2B534C23650}"/>
              </a:ext>
            </a:extLst>
          </p:cNvPr>
          <p:cNvPicPr>
            <a:picLocks noChangeAspect="1"/>
          </p:cNvPicPr>
          <p:nvPr/>
        </p:nvPicPr>
        <p:blipFill>
          <a:blip r:embed="rId5"/>
          <a:stretch>
            <a:fillRect/>
          </a:stretch>
        </p:blipFill>
        <p:spPr>
          <a:xfrm>
            <a:off x="8384043" y="1576719"/>
            <a:ext cx="3824025" cy="3241766"/>
          </a:xfrm>
          <a:prstGeom prst="rect">
            <a:avLst/>
          </a:prstGeom>
        </p:spPr>
      </p:pic>
      <p:pic>
        <p:nvPicPr>
          <p:cNvPr id="10" name="Grafik 9">
            <a:extLst>
              <a:ext uri="{FF2B5EF4-FFF2-40B4-BE49-F238E27FC236}">
                <a16:creationId xmlns:a16="http://schemas.microsoft.com/office/drawing/2014/main" id="{B90E839B-8334-38AE-B7BC-A7E9AB11C17D}"/>
              </a:ext>
            </a:extLst>
          </p:cNvPr>
          <p:cNvPicPr>
            <a:picLocks noChangeAspect="1"/>
          </p:cNvPicPr>
          <p:nvPr/>
        </p:nvPicPr>
        <p:blipFill>
          <a:blip r:embed="rId6"/>
          <a:stretch>
            <a:fillRect/>
          </a:stretch>
        </p:blipFill>
        <p:spPr>
          <a:xfrm>
            <a:off x="-359468" y="1287682"/>
            <a:ext cx="3938231" cy="4355922"/>
          </a:xfrm>
          <a:prstGeom prst="rect">
            <a:avLst/>
          </a:prstGeom>
        </p:spPr>
      </p:pic>
      <p:pic>
        <p:nvPicPr>
          <p:cNvPr id="2" name="Grafik 1">
            <a:extLst>
              <a:ext uri="{FF2B5EF4-FFF2-40B4-BE49-F238E27FC236}">
                <a16:creationId xmlns:a16="http://schemas.microsoft.com/office/drawing/2014/main" id="{249AA386-CC69-1B24-B8C5-488B267D6737}"/>
              </a:ext>
            </a:extLst>
          </p:cNvPr>
          <p:cNvPicPr>
            <a:picLocks noChangeAspect="1"/>
          </p:cNvPicPr>
          <p:nvPr/>
        </p:nvPicPr>
        <p:blipFill>
          <a:blip r:embed="rId7"/>
          <a:stretch>
            <a:fillRect/>
          </a:stretch>
        </p:blipFill>
        <p:spPr>
          <a:xfrm>
            <a:off x="-246191" y="1164100"/>
            <a:ext cx="3914546" cy="4529799"/>
          </a:xfrm>
          <a:prstGeom prst="rect">
            <a:avLst/>
          </a:prstGeom>
        </p:spPr>
      </p:pic>
      <p:cxnSp>
        <p:nvCxnSpPr>
          <p:cNvPr id="3" name="Gerade Verbindung 2">
            <a:extLst>
              <a:ext uri="{FF2B5EF4-FFF2-40B4-BE49-F238E27FC236}">
                <a16:creationId xmlns:a16="http://schemas.microsoft.com/office/drawing/2014/main" id="{E0BFE428-B968-C188-401E-B83BE8A29F98}"/>
              </a:ext>
            </a:extLst>
          </p:cNvPr>
          <p:cNvCxnSpPr>
            <a:cxnSpLocks/>
          </p:cNvCxnSpPr>
          <p:nvPr/>
        </p:nvCxnSpPr>
        <p:spPr>
          <a:xfrm>
            <a:off x="27574" y="1291485"/>
            <a:ext cx="2419403" cy="1"/>
          </a:xfrm>
          <a:prstGeom prst="line">
            <a:avLst/>
          </a:prstGeom>
          <a:ln w="57150">
            <a:solidFill>
              <a:srgbClr val="FFFF00">
                <a:alpha val="50196"/>
              </a:srgbClr>
            </a:solidFill>
          </a:ln>
        </p:spPr>
        <p:style>
          <a:lnRef idx="1">
            <a:schemeClr val="accent1"/>
          </a:lnRef>
          <a:fillRef idx="0">
            <a:schemeClr val="accent1"/>
          </a:fillRef>
          <a:effectRef idx="0">
            <a:schemeClr val="accent1"/>
          </a:effectRef>
          <a:fontRef idx="minor">
            <a:schemeClr val="tx1"/>
          </a:fontRef>
        </p:style>
      </p:cxnSp>
      <p:sp>
        <p:nvSpPr>
          <p:cNvPr id="6" name="Freihandform 5">
            <a:extLst>
              <a:ext uri="{FF2B5EF4-FFF2-40B4-BE49-F238E27FC236}">
                <a16:creationId xmlns:a16="http://schemas.microsoft.com/office/drawing/2014/main" id="{5A3A8132-10A1-1984-FA09-CB7B2DDD464F}"/>
              </a:ext>
            </a:extLst>
          </p:cNvPr>
          <p:cNvSpPr/>
          <p:nvPr/>
        </p:nvSpPr>
        <p:spPr>
          <a:xfrm rot="4279627">
            <a:off x="108818" y="1159549"/>
            <a:ext cx="645458" cy="634701"/>
          </a:xfrm>
          <a:custGeom>
            <a:avLst/>
            <a:gdLst>
              <a:gd name="connsiteX0" fmla="*/ 10756 w 645458"/>
              <a:gd name="connsiteY0" fmla="*/ 0 h 634701"/>
              <a:gd name="connsiteX1" fmla="*/ 632563 w 645458"/>
              <a:gd name="connsiteY1" fmla="*/ 506788 h 634701"/>
              <a:gd name="connsiteX2" fmla="*/ 645458 w 645458"/>
              <a:gd name="connsiteY2" fmla="*/ 634701 h 634701"/>
              <a:gd name="connsiteX3" fmla="*/ 0 w 645458"/>
              <a:gd name="connsiteY3" fmla="*/ 634701 h 634701"/>
              <a:gd name="connsiteX4" fmla="*/ 0 w 645458"/>
              <a:gd name="connsiteY4" fmla="*/ 949 h 634701"/>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645458" h="634701">
                <a:moveTo>
                  <a:pt x="10756" y="0"/>
                </a:moveTo>
                <a:cubicBezTo>
                  <a:pt x="317475" y="0"/>
                  <a:pt x="573380" y="217565"/>
                  <a:pt x="632563" y="506788"/>
                </a:cubicBezTo>
                <a:lnTo>
                  <a:pt x="645458" y="634701"/>
                </a:lnTo>
                <a:lnTo>
                  <a:pt x="0" y="634701"/>
                </a:lnTo>
                <a:lnTo>
                  <a:pt x="0" y="949"/>
                </a:lnTo>
                <a:close/>
              </a:path>
            </a:pathLst>
          </a:custGeom>
          <a:noFill/>
          <a:ln w="571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de-DE"/>
          </a:p>
        </p:txBody>
      </p:sp>
      <p:cxnSp>
        <p:nvCxnSpPr>
          <p:cNvPr id="8" name="Gerade Verbindung mit Pfeil 7">
            <a:extLst>
              <a:ext uri="{FF2B5EF4-FFF2-40B4-BE49-F238E27FC236}">
                <a16:creationId xmlns:a16="http://schemas.microsoft.com/office/drawing/2014/main" id="{824EAAEC-DAAE-095C-247E-E8CB534FD982}"/>
              </a:ext>
            </a:extLst>
          </p:cNvPr>
          <p:cNvCxnSpPr>
            <a:cxnSpLocks/>
          </p:cNvCxnSpPr>
          <p:nvPr/>
        </p:nvCxnSpPr>
        <p:spPr>
          <a:xfrm>
            <a:off x="28512" y="1280768"/>
            <a:ext cx="2088202" cy="1767578"/>
          </a:xfrm>
          <a:prstGeom prst="straightConnector1">
            <a:avLst/>
          </a:prstGeom>
          <a:ln w="57150">
            <a:solidFill>
              <a:srgbClr val="FFFF00"/>
            </a:solidFill>
            <a:tailEnd type="triangle"/>
          </a:ln>
        </p:spPr>
        <p:style>
          <a:lnRef idx="1">
            <a:schemeClr val="accent1"/>
          </a:lnRef>
          <a:fillRef idx="0">
            <a:schemeClr val="accent1"/>
          </a:fillRef>
          <a:effectRef idx="0">
            <a:schemeClr val="accent1"/>
          </a:effectRef>
          <a:fontRef idx="minor">
            <a:schemeClr val="tx1"/>
          </a:fontRef>
        </p:style>
      </p:cxnSp>
      <p:sp>
        <p:nvSpPr>
          <p:cNvPr id="18" name="Freihandform 17">
            <a:extLst>
              <a:ext uri="{FF2B5EF4-FFF2-40B4-BE49-F238E27FC236}">
                <a16:creationId xmlns:a16="http://schemas.microsoft.com/office/drawing/2014/main" id="{D1C100D5-034D-FDED-AD20-C6ECABE0A2EB}"/>
              </a:ext>
            </a:extLst>
          </p:cNvPr>
          <p:cNvSpPr/>
          <p:nvPr/>
        </p:nvSpPr>
        <p:spPr>
          <a:xfrm>
            <a:off x="9621848" y="2778434"/>
            <a:ext cx="1173971" cy="129948"/>
          </a:xfrm>
          <a:custGeom>
            <a:avLst/>
            <a:gdLst>
              <a:gd name="connsiteX0" fmla="*/ 0 w 1173971"/>
              <a:gd name="connsiteY0" fmla="*/ 118149 h 129948"/>
              <a:gd name="connsiteX1" fmla="*/ 123886 w 1173971"/>
              <a:gd name="connsiteY1" fmla="*/ 94552 h 129948"/>
              <a:gd name="connsiteX2" fmla="*/ 230075 w 1173971"/>
              <a:gd name="connsiteY2" fmla="*/ 53256 h 129948"/>
              <a:gd name="connsiteX3" fmla="*/ 300867 w 1173971"/>
              <a:gd name="connsiteY3" fmla="*/ 17860 h 129948"/>
              <a:gd name="connsiteX4" fmla="*/ 371659 w 1173971"/>
              <a:gd name="connsiteY4" fmla="*/ 6061 h 129948"/>
              <a:gd name="connsiteX5" fmla="*/ 489646 w 1173971"/>
              <a:gd name="connsiteY5" fmla="*/ 29659 h 129948"/>
              <a:gd name="connsiteX6" fmla="*/ 595835 w 1173971"/>
              <a:gd name="connsiteY6" fmla="*/ 59156 h 129948"/>
              <a:gd name="connsiteX7" fmla="*/ 749218 w 1173971"/>
              <a:gd name="connsiteY7" fmla="*/ 29659 h 129948"/>
              <a:gd name="connsiteX8" fmla="*/ 802312 w 1173971"/>
              <a:gd name="connsiteY8" fmla="*/ 162 h 129948"/>
              <a:gd name="connsiteX9" fmla="*/ 890802 w 1173971"/>
              <a:gd name="connsiteY9" fmla="*/ 23760 h 129948"/>
              <a:gd name="connsiteX10" fmla="*/ 1173971 w 1173971"/>
              <a:gd name="connsiteY10" fmla="*/ 129948 h 12994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1173971" h="129948">
                <a:moveTo>
                  <a:pt x="0" y="118149"/>
                </a:moveTo>
                <a:cubicBezTo>
                  <a:pt x="42770" y="111758"/>
                  <a:pt x="85540" y="105367"/>
                  <a:pt x="123886" y="94552"/>
                </a:cubicBezTo>
                <a:cubicBezTo>
                  <a:pt x="162232" y="83737"/>
                  <a:pt x="200578" y="66038"/>
                  <a:pt x="230075" y="53256"/>
                </a:cubicBezTo>
                <a:cubicBezTo>
                  <a:pt x="259572" y="40474"/>
                  <a:pt x="277270" y="25726"/>
                  <a:pt x="300867" y="17860"/>
                </a:cubicBezTo>
                <a:cubicBezTo>
                  <a:pt x="324464" y="9994"/>
                  <a:pt x="340196" y="4094"/>
                  <a:pt x="371659" y="6061"/>
                </a:cubicBezTo>
                <a:cubicBezTo>
                  <a:pt x="403122" y="8027"/>
                  <a:pt x="452283" y="20810"/>
                  <a:pt x="489646" y="29659"/>
                </a:cubicBezTo>
                <a:cubicBezTo>
                  <a:pt x="527009" y="38508"/>
                  <a:pt x="552573" y="59156"/>
                  <a:pt x="595835" y="59156"/>
                </a:cubicBezTo>
                <a:cubicBezTo>
                  <a:pt x="639097" y="59156"/>
                  <a:pt x="714805" y="39491"/>
                  <a:pt x="749218" y="29659"/>
                </a:cubicBezTo>
                <a:cubicBezTo>
                  <a:pt x="783631" y="19827"/>
                  <a:pt x="778715" y="1145"/>
                  <a:pt x="802312" y="162"/>
                </a:cubicBezTo>
                <a:cubicBezTo>
                  <a:pt x="825909" y="-821"/>
                  <a:pt x="828859" y="2129"/>
                  <a:pt x="890802" y="23760"/>
                </a:cubicBezTo>
                <a:cubicBezTo>
                  <a:pt x="952745" y="45391"/>
                  <a:pt x="1063358" y="87669"/>
                  <a:pt x="1173971" y="129948"/>
                </a:cubicBezTo>
              </a:path>
            </a:pathLst>
          </a:custGeom>
          <a:noFill/>
          <a:ln w="38100">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19" name="Gerade Verbindung mit Pfeil 18">
            <a:extLst>
              <a:ext uri="{FF2B5EF4-FFF2-40B4-BE49-F238E27FC236}">
                <a16:creationId xmlns:a16="http://schemas.microsoft.com/office/drawing/2014/main" id="{10FF2713-D93D-E038-72EE-9E867AA9B4A8}"/>
              </a:ext>
            </a:extLst>
          </p:cNvPr>
          <p:cNvCxnSpPr>
            <a:cxnSpLocks/>
          </p:cNvCxnSpPr>
          <p:nvPr/>
        </p:nvCxnSpPr>
        <p:spPr>
          <a:xfrm>
            <a:off x="10221236" y="2613470"/>
            <a:ext cx="0" cy="398772"/>
          </a:xfrm>
          <a:prstGeom prst="straightConnector1">
            <a:avLst/>
          </a:prstGeom>
          <a:ln w="28575">
            <a:solidFill>
              <a:srgbClr val="FFC000"/>
            </a:solidFill>
            <a:headEnd type="triangle"/>
            <a:tailEnd type="triangle"/>
          </a:ln>
        </p:spPr>
        <p:style>
          <a:lnRef idx="1">
            <a:schemeClr val="accent1"/>
          </a:lnRef>
          <a:fillRef idx="0">
            <a:schemeClr val="accent1"/>
          </a:fillRef>
          <a:effectRef idx="0">
            <a:schemeClr val="accent1"/>
          </a:effectRef>
          <a:fontRef idx="minor">
            <a:schemeClr val="tx1"/>
          </a:fontRef>
        </p:style>
      </p:cxnSp>
      <p:sp>
        <p:nvSpPr>
          <p:cNvPr id="12" name="Textfeld 11">
            <a:extLst>
              <a:ext uri="{FF2B5EF4-FFF2-40B4-BE49-F238E27FC236}">
                <a16:creationId xmlns:a16="http://schemas.microsoft.com/office/drawing/2014/main" id="{F4759B8B-D244-8AA9-F084-3BBCB3F7E244}"/>
              </a:ext>
            </a:extLst>
          </p:cNvPr>
          <p:cNvSpPr txBox="1"/>
          <p:nvPr/>
        </p:nvSpPr>
        <p:spPr>
          <a:xfrm>
            <a:off x="81541" y="421607"/>
            <a:ext cx="2203039" cy="369332"/>
          </a:xfrm>
          <a:prstGeom prst="rect">
            <a:avLst/>
          </a:prstGeom>
          <a:noFill/>
        </p:spPr>
        <p:txBody>
          <a:bodyPr wrap="none" rtlCol="0">
            <a:spAutoFit/>
          </a:bodyPr>
          <a:lstStyle/>
          <a:p>
            <a:r>
              <a:rPr lang="de-CH" dirty="0"/>
              <a:t>Appendix 2, </a:t>
            </a:r>
            <a:r>
              <a:rPr lang="de-CH" dirty="0" err="1"/>
              <a:t>figure</a:t>
            </a:r>
            <a:r>
              <a:rPr lang="de-CH" dirty="0"/>
              <a:t> 3A</a:t>
            </a:r>
          </a:p>
        </p:txBody>
      </p:sp>
    </p:spTree>
    <p:extLst>
      <p:ext uri="{BB962C8B-B14F-4D97-AF65-F5344CB8AC3E}">
        <p14:creationId xmlns:p14="http://schemas.microsoft.com/office/powerpoint/2010/main" val="4810507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a:extLst>
              <a:ext uri="{FF2B5EF4-FFF2-40B4-BE49-F238E27FC236}">
                <a16:creationId xmlns:a16="http://schemas.microsoft.com/office/drawing/2014/main" id="{3DD0E67C-6E21-F37D-C9E3-FEB0ADD6416E}"/>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284412" y="0"/>
            <a:ext cx="7623175" cy="6858000"/>
          </a:xfrm>
          <a:prstGeom prst="rect">
            <a:avLst/>
          </a:prstGeom>
          <a:noFill/>
          <a:extLst>
            <a:ext uri="{909E8E84-426E-40DD-AFC4-6F175D3DCCD1}">
              <a14:hiddenFill xmlns:a14="http://schemas.microsoft.com/office/drawing/2010/main">
                <a:solidFill>
                  <a:srgbClr val="FFFFFF"/>
                </a:solidFill>
              </a14:hiddenFill>
            </a:ext>
          </a:extLst>
        </p:spPr>
      </p:pic>
      <p:cxnSp>
        <p:nvCxnSpPr>
          <p:cNvPr id="5" name="Gerade Verbindung mit Pfeil 4">
            <a:extLst>
              <a:ext uri="{FF2B5EF4-FFF2-40B4-BE49-F238E27FC236}">
                <a16:creationId xmlns:a16="http://schemas.microsoft.com/office/drawing/2014/main" id="{FB2EB22C-08B1-7DCD-3041-2BD68EC5F4CE}"/>
              </a:ext>
            </a:extLst>
          </p:cNvPr>
          <p:cNvCxnSpPr>
            <a:cxnSpLocks/>
          </p:cNvCxnSpPr>
          <p:nvPr/>
        </p:nvCxnSpPr>
        <p:spPr>
          <a:xfrm flipV="1">
            <a:off x="4593514" y="2949301"/>
            <a:ext cx="2103927" cy="1943935"/>
          </a:xfrm>
          <a:prstGeom prst="straightConnector1">
            <a:avLst/>
          </a:prstGeom>
          <a:ln w="57150">
            <a:solidFill>
              <a:srgbClr val="FFFF00"/>
            </a:solidFill>
            <a:tailEnd type="triangle"/>
          </a:ln>
        </p:spPr>
        <p:style>
          <a:lnRef idx="1">
            <a:schemeClr val="accent1"/>
          </a:lnRef>
          <a:fillRef idx="0">
            <a:schemeClr val="accent1"/>
          </a:fillRef>
          <a:effectRef idx="0">
            <a:schemeClr val="accent1"/>
          </a:effectRef>
          <a:fontRef idx="minor">
            <a:schemeClr val="tx1"/>
          </a:fontRef>
        </p:style>
      </p:cxnSp>
      <p:cxnSp>
        <p:nvCxnSpPr>
          <p:cNvPr id="7" name="Gerade Verbindung 6">
            <a:extLst>
              <a:ext uri="{FF2B5EF4-FFF2-40B4-BE49-F238E27FC236}">
                <a16:creationId xmlns:a16="http://schemas.microsoft.com/office/drawing/2014/main" id="{41070653-6A0F-F466-1619-90151AEC6B0F}"/>
              </a:ext>
            </a:extLst>
          </p:cNvPr>
          <p:cNvCxnSpPr/>
          <p:nvPr/>
        </p:nvCxnSpPr>
        <p:spPr>
          <a:xfrm>
            <a:off x="4604272" y="4893236"/>
            <a:ext cx="2786231" cy="0"/>
          </a:xfrm>
          <a:prstGeom prst="line">
            <a:avLst/>
          </a:prstGeom>
          <a:ln w="57150">
            <a:solidFill>
              <a:srgbClr val="FFFF00">
                <a:alpha val="50196"/>
              </a:srgbClr>
            </a:solidFill>
          </a:ln>
        </p:spPr>
        <p:style>
          <a:lnRef idx="1">
            <a:schemeClr val="accent1"/>
          </a:lnRef>
          <a:fillRef idx="0">
            <a:schemeClr val="accent1"/>
          </a:fillRef>
          <a:effectRef idx="0">
            <a:schemeClr val="accent1"/>
          </a:effectRef>
          <a:fontRef idx="minor">
            <a:schemeClr val="tx1"/>
          </a:fontRef>
        </p:style>
      </p:cxnSp>
      <p:sp>
        <p:nvSpPr>
          <p:cNvPr id="11" name="Freihandform 10">
            <a:extLst>
              <a:ext uri="{FF2B5EF4-FFF2-40B4-BE49-F238E27FC236}">
                <a16:creationId xmlns:a16="http://schemas.microsoft.com/office/drawing/2014/main" id="{B93C214A-64EE-0CEA-BFA9-7FC0E68A585E}"/>
              </a:ext>
            </a:extLst>
          </p:cNvPr>
          <p:cNvSpPr/>
          <p:nvPr/>
        </p:nvSpPr>
        <p:spPr>
          <a:xfrm rot="1607093">
            <a:off x="4701898" y="4419900"/>
            <a:ext cx="645458" cy="634701"/>
          </a:xfrm>
          <a:custGeom>
            <a:avLst/>
            <a:gdLst>
              <a:gd name="connsiteX0" fmla="*/ 10756 w 645458"/>
              <a:gd name="connsiteY0" fmla="*/ 0 h 634701"/>
              <a:gd name="connsiteX1" fmla="*/ 632563 w 645458"/>
              <a:gd name="connsiteY1" fmla="*/ 506788 h 634701"/>
              <a:gd name="connsiteX2" fmla="*/ 645458 w 645458"/>
              <a:gd name="connsiteY2" fmla="*/ 634701 h 634701"/>
              <a:gd name="connsiteX3" fmla="*/ 0 w 645458"/>
              <a:gd name="connsiteY3" fmla="*/ 634701 h 634701"/>
              <a:gd name="connsiteX4" fmla="*/ 0 w 645458"/>
              <a:gd name="connsiteY4" fmla="*/ 949 h 634701"/>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645458" h="634701">
                <a:moveTo>
                  <a:pt x="10756" y="0"/>
                </a:moveTo>
                <a:cubicBezTo>
                  <a:pt x="317475" y="0"/>
                  <a:pt x="573380" y="217565"/>
                  <a:pt x="632563" y="506788"/>
                </a:cubicBezTo>
                <a:lnTo>
                  <a:pt x="645458" y="634701"/>
                </a:lnTo>
                <a:lnTo>
                  <a:pt x="0" y="634701"/>
                </a:lnTo>
                <a:lnTo>
                  <a:pt x="0" y="949"/>
                </a:lnTo>
                <a:close/>
              </a:path>
            </a:pathLst>
          </a:custGeom>
          <a:noFill/>
          <a:ln w="571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de-DE"/>
          </a:p>
        </p:txBody>
      </p:sp>
      <p:pic>
        <p:nvPicPr>
          <p:cNvPr id="13" name="Grafik 12" descr="Auge">
            <a:extLst>
              <a:ext uri="{FF2B5EF4-FFF2-40B4-BE49-F238E27FC236}">
                <a16:creationId xmlns:a16="http://schemas.microsoft.com/office/drawing/2014/main" id="{847A5B60-3796-0588-3BC7-7A6C9C1FFA3D}"/>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3673734" y="4650404"/>
            <a:ext cx="914400" cy="914400"/>
          </a:xfrm>
          <a:prstGeom prst="rect">
            <a:avLst/>
          </a:prstGeom>
        </p:spPr>
      </p:pic>
      <p:sp>
        <p:nvSpPr>
          <p:cNvPr id="23" name="Freihandform 22">
            <a:extLst>
              <a:ext uri="{FF2B5EF4-FFF2-40B4-BE49-F238E27FC236}">
                <a16:creationId xmlns:a16="http://schemas.microsoft.com/office/drawing/2014/main" id="{766E6536-9DBB-EF3F-6F5E-998F9BF97A8A}"/>
              </a:ext>
            </a:extLst>
          </p:cNvPr>
          <p:cNvSpPr/>
          <p:nvPr/>
        </p:nvSpPr>
        <p:spPr>
          <a:xfrm rot="8566892">
            <a:off x="9097645" y="1577821"/>
            <a:ext cx="165438" cy="480508"/>
          </a:xfrm>
          <a:custGeom>
            <a:avLst/>
            <a:gdLst>
              <a:gd name="connsiteX0" fmla="*/ 22 w 512509"/>
              <a:gd name="connsiteY0" fmla="*/ 487947 h 967477"/>
              <a:gd name="connsiteX1" fmla="*/ 320089 w 512509"/>
              <a:gd name="connsiteY1" fmla="*/ 83255 h 967477"/>
              <a:gd name="connsiteX2" fmla="*/ 366348 w 512509"/>
              <a:gd name="connsiteY2" fmla="*/ 77662 h 967477"/>
              <a:gd name="connsiteX3" fmla="*/ 292146 w 512509"/>
              <a:gd name="connsiteY3" fmla="*/ 0 h 967477"/>
              <a:gd name="connsiteX4" fmla="*/ 402328 w 512509"/>
              <a:gd name="connsiteY4" fmla="*/ 0 h 967477"/>
              <a:gd name="connsiteX5" fmla="*/ 512509 w 512509"/>
              <a:gd name="connsiteY5" fmla="*/ 115320 h 967477"/>
              <a:gd name="connsiteX6" fmla="*/ 402328 w 512509"/>
              <a:gd name="connsiteY6" fmla="*/ 230640 h 967477"/>
              <a:gd name="connsiteX7" fmla="*/ 292146 w 512509"/>
              <a:gd name="connsiteY7" fmla="*/ 230640 h 967477"/>
              <a:gd name="connsiteX8" fmla="*/ 349748 w 512509"/>
              <a:gd name="connsiteY8" fmla="*/ 170352 h 967477"/>
              <a:gd name="connsiteX9" fmla="*/ 278477 w 512509"/>
              <a:gd name="connsiteY9" fmla="*/ 186170 h 967477"/>
              <a:gd name="connsiteX10" fmla="*/ 85044 w 512509"/>
              <a:gd name="connsiteY10" fmla="*/ 487076 h 967477"/>
              <a:gd name="connsiteX11" fmla="*/ 284608 w 512509"/>
              <a:gd name="connsiteY11" fmla="*/ 783952 h 967477"/>
              <a:gd name="connsiteX12" fmla="*/ 349615 w 512509"/>
              <a:gd name="connsiteY12" fmla="*/ 796987 h 967477"/>
              <a:gd name="connsiteX13" fmla="*/ 292145 w 512509"/>
              <a:gd name="connsiteY13" fmla="*/ 736837 h 967477"/>
              <a:gd name="connsiteX14" fmla="*/ 402327 w 512509"/>
              <a:gd name="connsiteY14" fmla="*/ 736837 h 967477"/>
              <a:gd name="connsiteX15" fmla="*/ 512508 w 512509"/>
              <a:gd name="connsiteY15" fmla="*/ 852157 h 967477"/>
              <a:gd name="connsiteX16" fmla="*/ 402327 w 512509"/>
              <a:gd name="connsiteY16" fmla="*/ 967477 h 967477"/>
              <a:gd name="connsiteX17" fmla="*/ 292145 w 512509"/>
              <a:gd name="connsiteY17" fmla="*/ 967477 h 967477"/>
              <a:gd name="connsiteX18" fmla="*/ 366362 w 512509"/>
              <a:gd name="connsiteY18" fmla="*/ 889799 h 967477"/>
              <a:gd name="connsiteX19" fmla="*/ 328321 w 512509"/>
              <a:gd name="connsiteY19" fmla="*/ 885990 h 967477"/>
              <a:gd name="connsiteX20" fmla="*/ 22 w 512509"/>
              <a:gd name="connsiteY20" fmla="*/ 487947 h 96747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Lst>
            <a:rect l="l" t="t" r="r" b="b"/>
            <a:pathLst>
              <a:path w="512509" h="967477">
                <a:moveTo>
                  <a:pt x="22" y="487947"/>
                </a:moveTo>
                <a:cubicBezTo>
                  <a:pt x="-1997" y="291031"/>
                  <a:pt x="135054" y="124822"/>
                  <a:pt x="320089" y="83255"/>
                </a:cubicBezTo>
                <a:lnTo>
                  <a:pt x="366348" y="77662"/>
                </a:lnTo>
                <a:lnTo>
                  <a:pt x="292146" y="0"/>
                </a:lnTo>
                <a:lnTo>
                  <a:pt x="402328" y="0"/>
                </a:lnTo>
                <a:lnTo>
                  <a:pt x="512509" y="115320"/>
                </a:lnTo>
                <a:lnTo>
                  <a:pt x="402328" y="230640"/>
                </a:lnTo>
                <a:lnTo>
                  <a:pt x="292146" y="230640"/>
                </a:lnTo>
                <a:lnTo>
                  <a:pt x="349748" y="170352"/>
                </a:lnTo>
                <a:lnTo>
                  <a:pt x="278477" y="186170"/>
                </a:lnTo>
                <a:cubicBezTo>
                  <a:pt x="163309" y="237317"/>
                  <a:pt x="83672" y="353252"/>
                  <a:pt x="85044" y="487076"/>
                </a:cubicBezTo>
                <a:cubicBezTo>
                  <a:pt x="86417" y="620899"/>
                  <a:pt x="168415" y="735177"/>
                  <a:pt x="284608" y="783952"/>
                </a:cubicBezTo>
                <a:lnTo>
                  <a:pt x="349615" y="796987"/>
                </a:lnTo>
                <a:lnTo>
                  <a:pt x="292145" y="736837"/>
                </a:lnTo>
                <a:lnTo>
                  <a:pt x="402327" y="736837"/>
                </a:lnTo>
                <a:lnTo>
                  <a:pt x="512508" y="852157"/>
                </a:lnTo>
                <a:lnTo>
                  <a:pt x="402327" y="967477"/>
                </a:lnTo>
                <a:lnTo>
                  <a:pt x="292145" y="967477"/>
                </a:lnTo>
                <a:lnTo>
                  <a:pt x="366362" y="889799"/>
                </a:lnTo>
                <a:lnTo>
                  <a:pt x="328321" y="885990"/>
                </a:lnTo>
                <a:cubicBezTo>
                  <a:pt x="142473" y="848226"/>
                  <a:pt x="2042" y="684864"/>
                  <a:pt x="22" y="487947"/>
                </a:cubicBezTo>
                <a:close/>
              </a:path>
            </a:pathLst>
          </a:custGeom>
          <a:solidFill>
            <a:schemeClr val="accent1">
              <a:lumMod val="40000"/>
              <a:lumOff val="60000"/>
            </a:schemeClr>
          </a:solidFill>
          <a:ln>
            <a:solidFill>
              <a:schemeClr val="accent1">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de-DE">
              <a:solidFill>
                <a:schemeClr val="tx1"/>
              </a:solidFill>
            </a:endParaRPr>
          </a:p>
        </p:txBody>
      </p:sp>
      <p:cxnSp>
        <p:nvCxnSpPr>
          <p:cNvPr id="25" name="Gerade Verbindung mit Pfeil 24">
            <a:extLst>
              <a:ext uri="{FF2B5EF4-FFF2-40B4-BE49-F238E27FC236}">
                <a16:creationId xmlns:a16="http://schemas.microsoft.com/office/drawing/2014/main" id="{358C83BF-265F-410B-A8E6-EEF1278389E7}"/>
              </a:ext>
            </a:extLst>
          </p:cNvPr>
          <p:cNvCxnSpPr>
            <a:cxnSpLocks/>
          </p:cNvCxnSpPr>
          <p:nvPr/>
        </p:nvCxnSpPr>
        <p:spPr>
          <a:xfrm>
            <a:off x="6613909" y="2624676"/>
            <a:ext cx="203209" cy="327048"/>
          </a:xfrm>
          <a:prstGeom prst="straightConnector1">
            <a:avLst/>
          </a:prstGeom>
          <a:ln w="28575">
            <a:solidFill>
              <a:srgbClr val="FFC000"/>
            </a:solidFill>
            <a:headEnd type="triangle"/>
            <a:tailEnd type="triangle"/>
          </a:ln>
        </p:spPr>
        <p:style>
          <a:lnRef idx="1">
            <a:schemeClr val="accent1"/>
          </a:lnRef>
          <a:fillRef idx="0">
            <a:schemeClr val="accent1"/>
          </a:fillRef>
          <a:effectRef idx="0">
            <a:schemeClr val="accent1"/>
          </a:effectRef>
          <a:fontRef idx="minor">
            <a:schemeClr val="tx1"/>
          </a:fontRef>
        </p:style>
      </p:cxnSp>
      <p:sp>
        <p:nvSpPr>
          <p:cNvPr id="27" name="Freihandform 26">
            <a:extLst>
              <a:ext uri="{FF2B5EF4-FFF2-40B4-BE49-F238E27FC236}">
                <a16:creationId xmlns:a16="http://schemas.microsoft.com/office/drawing/2014/main" id="{B3865545-0A6D-D724-4E93-8511639F7735}"/>
              </a:ext>
            </a:extLst>
          </p:cNvPr>
          <p:cNvSpPr/>
          <p:nvPr/>
        </p:nvSpPr>
        <p:spPr>
          <a:xfrm>
            <a:off x="6270103" y="2762840"/>
            <a:ext cx="378969" cy="186461"/>
          </a:xfrm>
          <a:custGeom>
            <a:avLst/>
            <a:gdLst>
              <a:gd name="connsiteX0" fmla="*/ 373943 w 378969"/>
              <a:gd name="connsiteY0" fmla="*/ 147220 h 186461"/>
              <a:gd name="connsiteX1" fmla="*/ 347245 w 378969"/>
              <a:gd name="connsiteY1" fmla="*/ 40429 h 186461"/>
              <a:gd name="connsiteX2" fmla="*/ 187058 w 378969"/>
              <a:gd name="connsiteY2" fmla="*/ 382 h 186461"/>
              <a:gd name="connsiteX3" fmla="*/ 73592 w 378969"/>
              <a:gd name="connsiteY3" fmla="*/ 60452 h 186461"/>
              <a:gd name="connsiteX4" fmla="*/ 173 w 378969"/>
              <a:gd name="connsiteY4" fmla="*/ 140546 h 186461"/>
              <a:gd name="connsiteX5" fmla="*/ 93616 w 378969"/>
              <a:gd name="connsiteY5" fmla="*/ 180592 h 186461"/>
              <a:gd name="connsiteX6" fmla="*/ 280500 w 378969"/>
              <a:gd name="connsiteY6" fmla="*/ 180592 h 186461"/>
              <a:gd name="connsiteX7" fmla="*/ 373943 w 378969"/>
              <a:gd name="connsiteY7" fmla="*/ 147220 h 18646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378969" h="186461">
                <a:moveTo>
                  <a:pt x="373943" y="147220"/>
                </a:moveTo>
                <a:cubicBezTo>
                  <a:pt x="385067" y="123860"/>
                  <a:pt x="378393" y="64902"/>
                  <a:pt x="347245" y="40429"/>
                </a:cubicBezTo>
                <a:cubicBezTo>
                  <a:pt x="316097" y="15956"/>
                  <a:pt x="232667" y="-2955"/>
                  <a:pt x="187058" y="382"/>
                </a:cubicBezTo>
                <a:cubicBezTo>
                  <a:pt x="141449" y="3719"/>
                  <a:pt x="104739" y="37091"/>
                  <a:pt x="73592" y="60452"/>
                </a:cubicBezTo>
                <a:cubicBezTo>
                  <a:pt x="42444" y="83813"/>
                  <a:pt x="-3164" y="120523"/>
                  <a:pt x="173" y="140546"/>
                </a:cubicBezTo>
                <a:cubicBezTo>
                  <a:pt x="3510" y="160569"/>
                  <a:pt x="46895" y="173918"/>
                  <a:pt x="93616" y="180592"/>
                </a:cubicBezTo>
                <a:cubicBezTo>
                  <a:pt x="140337" y="187266"/>
                  <a:pt x="237116" y="189491"/>
                  <a:pt x="280500" y="180592"/>
                </a:cubicBezTo>
                <a:cubicBezTo>
                  <a:pt x="323884" y="171693"/>
                  <a:pt x="362819" y="170580"/>
                  <a:pt x="373943" y="147220"/>
                </a:cubicBezTo>
                <a:close/>
              </a:path>
            </a:pathLst>
          </a:custGeom>
          <a:solidFill>
            <a:srgbClr val="FF0000">
              <a:alpha val="50196"/>
            </a:srgbClr>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pic>
        <p:nvPicPr>
          <p:cNvPr id="30" name="Grafik 29">
            <a:extLst>
              <a:ext uri="{FF2B5EF4-FFF2-40B4-BE49-F238E27FC236}">
                <a16:creationId xmlns:a16="http://schemas.microsoft.com/office/drawing/2014/main" id="{7E660F7F-D0F8-E44B-D562-0C4E41F6EBE7}"/>
              </a:ext>
            </a:extLst>
          </p:cNvPr>
          <p:cNvPicPr>
            <a:picLocks noChangeAspect="1"/>
          </p:cNvPicPr>
          <p:nvPr/>
        </p:nvPicPr>
        <p:blipFill>
          <a:blip r:embed="rId5"/>
          <a:stretch>
            <a:fillRect/>
          </a:stretch>
        </p:blipFill>
        <p:spPr>
          <a:xfrm>
            <a:off x="8410308" y="1576719"/>
            <a:ext cx="4214092" cy="3513705"/>
          </a:xfrm>
          <a:prstGeom prst="rect">
            <a:avLst/>
          </a:prstGeom>
        </p:spPr>
      </p:pic>
      <p:pic>
        <p:nvPicPr>
          <p:cNvPr id="31" name="Grafik 30">
            <a:extLst>
              <a:ext uri="{FF2B5EF4-FFF2-40B4-BE49-F238E27FC236}">
                <a16:creationId xmlns:a16="http://schemas.microsoft.com/office/drawing/2014/main" id="{2B59B2FF-8DB2-190D-5487-6A58A9C916CB}"/>
              </a:ext>
            </a:extLst>
          </p:cNvPr>
          <p:cNvPicPr>
            <a:picLocks noChangeAspect="1"/>
          </p:cNvPicPr>
          <p:nvPr/>
        </p:nvPicPr>
        <p:blipFill>
          <a:blip r:embed="rId6"/>
          <a:stretch>
            <a:fillRect/>
          </a:stretch>
        </p:blipFill>
        <p:spPr>
          <a:xfrm>
            <a:off x="-246191" y="1164100"/>
            <a:ext cx="3914546" cy="4529799"/>
          </a:xfrm>
          <a:prstGeom prst="rect">
            <a:avLst/>
          </a:prstGeom>
        </p:spPr>
      </p:pic>
      <p:cxnSp>
        <p:nvCxnSpPr>
          <p:cNvPr id="2" name="Gerade Verbindung mit Pfeil 1">
            <a:extLst>
              <a:ext uri="{FF2B5EF4-FFF2-40B4-BE49-F238E27FC236}">
                <a16:creationId xmlns:a16="http://schemas.microsoft.com/office/drawing/2014/main" id="{9B703F5A-3DFC-3118-7D7E-BB9A1498E780}"/>
              </a:ext>
            </a:extLst>
          </p:cNvPr>
          <p:cNvCxnSpPr>
            <a:cxnSpLocks/>
          </p:cNvCxnSpPr>
          <p:nvPr/>
        </p:nvCxnSpPr>
        <p:spPr>
          <a:xfrm flipV="1">
            <a:off x="118609" y="3092824"/>
            <a:ext cx="2207605" cy="1526066"/>
          </a:xfrm>
          <a:prstGeom prst="straightConnector1">
            <a:avLst/>
          </a:prstGeom>
          <a:ln w="57150">
            <a:solidFill>
              <a:srgbClr val="FFFF00"/>
            </a:solidFill>
            <a:tailEnd type="triangle"/>
          </a:ln>
        </p:spPr>
        <p:style>
          <a:lnRef idx="1">
            <a:schemeClr val="accent1"/>
          </a:lnRef>
          <a:fillRef idx="0">
            <a:schemeClr val="accent1"/>
          </a:fillRef>
          <a:effectRef idx="0">
            <a:schemeClr val="accent1"/>
          </a:effectRef>
          <a:fontRef idx="minor">
            <a:schemeClr val="tx1"/>
          </a:fontRef>
        </p:style>
      </p:cxnSp>
      <p:cxnSp>
        <p:nvCxnSpPr>
          <p:cNvPr id="3" name="Gerade Verbindung 2">
            <a:extLst>
              <a:ext uri="{FF2B5EF4-FFF2-40B4-BE49-F238E27FC236}">
                <a16:creationId xmlns:a16="http://schemas.microsoft.com/office/drawing/2014/main" id="{96AAEF04-1DE7-7177-5434-563D804073CF}"/>
              </a:ext>
            </a:extLst>
          </p:cNvPr>
          <p:cNvCxnSpPr/>
          <p:nvPr/>
        </p:nvCxnSpPr>
        <p:spPr>
          <a:xfrm>
            <a:off x="129367" y="4618890"/>
            <a:ext cx="2786231" cy="0"/>
          </a:xfrm>
          <a:prstGeom prst="line">
            <a:avLst/>
          </a:prstGeom>
          <a:ln w="57150">
            <a:solidFill>
              <a:srgbClr val="FFFF00">
                <a:alpha val="50196"/>
              </a:srgbClr>
            </a:solidFill>
          </a:ln>
        </p:spPr>
        <p:style>
          <a:lnRef idx="1">
            <a:schemeClr val="accent1"/>
          </a:lnRef>
          <a:fillRef idx="0">
            <a:schemeClr val="accent1"/>
          </a:fillRef>
          <a:effectRef idx="0">
            <a:schemeClr val="accent1"/>
          </a:effectRef>
          <a:fontRef idx="minor">
            <a:schemeClr val="tx1"/>
          </a:fontRef>
        </p:style>
      </p:cxnSp>
      <p:sp>
        <p:nvSpPr>
          <p:cNvPr id="4" name="Freihandform 3">
            <a:extLst>
              <a:ext uri="{FF2B5EF4-FFF2-40B4-BE49-F238E27FC236}">
                <a16:creationId xmlns:a16="http://schemas.microsoft.com/office/drawing/2014/main" id="{A66FE9C3-641F-8648-1239-7A31D7154127}"/>
              </a:ext>
            </a:extLst>
          </p:cNvPr>
          <p:cNvSpPr/>
          <p:nvPr/>
        </p:nvSpPr>
        <p:spPr>
          <a:xfrm rot="1607093">
            <a:off x="226993" y="4145554"/>
            <a:ext cx="645458" cy="634701"/>
          </a:xfrm>
          <a:custGeom>
            <a:avLst/>
            <a:gdLst>
              <a:gd name="connsiteX0" fmla="*/ 10756 w 645458"/>
              <a:gd name="connsiteY0" fmla="*/ 0 h 634701"/>
              <a:gd name="connsiteX1" fmla="*/ 632563 w 645458"/>
              <a:gd name="connsiteY1" fmla="*/ 506788 h 634701"/>
              <a:gd name="connsiteX2" fmla="*/ 645458 w 645458"/>
              <a:gd name="connsiteY2" fmla="*/ 634701 h 634701"/>
              <a:gd name="connsiteX3" fmla="*/ 0 w 645458"/>
              <a:gd name="connsiteY3" fmla="*/ 634701 h 634701"/>
              <a:gd name="connsiteX4" fmla="*/ 0 w 645458"/>
              <a:gd name="connsiteY4" fmla="*/ 949 h 634701"/>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645458" h="634701">
                <a:moveTo>
                  <a:pt x="10756" y="0"/>
                </a:moveTo>
                <a:cubicBezTo>
                  <a:pt x="317475" y="0"/>
                  <a:pt x="573380" y="217565"/>
                  <a:pt x="632563" y="506788"/>
                </a:cubicBezTo>
                <a:lnTo>
                  <a:pt x="645458" y="634701"/>
                </a:lnTo>
                <a:lnTo>
                  <a:pt x="0" y="634701"/>
                </a:lnTo>
                <a:lnTo>
                  <a:pt x="0" y="949"/>
                </a:lnTo>
                <a:close/>
              </a:path>
            </a:pathLst>
          </a:custGeom>
          <a:noFill/>
          <a:ln w="571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de-DE"/>
          </a:p>
        </p:txBody>
      </p:sp>
      <p:sp>
        <p:nvSpPr>
          <p:cNvPr id="8" name="Oval 7">
            <a:extLst>
              <a:ext uri="{FF2B5EF4-FFF2-40B4-BE49-F238E27FC236}">
                <a16:creationId xmlns:a16="http://schemas.microsoft.com/office/drawing/2014/main" id="{08E2F777-CF96-EEF3-1BF9-62C3B5F98F34}"/>
              </a:ext>
            </a:extLst>
          </p:cNvPr>
          <p:cNvSpPr/>
          <p:nvPr/>
        </p:nvSpPr>
        <p:spPr>
          <a:xfrm rot="19066514" flipH="1">
            <a:off x="2263817" y="2962989"/>
            <a:ext cx="124795" cy="259668"/>
          </a:xfrm>
          <a:prstGeom prst="ellipse">
            <a:avLst/>
          </a:prstGeom>
          <a:solidFill>
            <a:srgbClr val="FF0000">
              <a:alpha val="50196"/>
            </a:srgbClr>
          </a:solidFill>
          <a:ln w="38100">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10" name="Gerade Verbindung mit Pfeil 9">
            <a:extLst>
              <a:ext uri="{FF2B5EF4-FFF2-40B4-BE49-F238E27FC236}">
                <a16:creationId xmlns:a16="http://schemas.microsoft.com/office/drawing/2014/main" id="{C9DC5103-FAC4-2070-4699-BD9307A0F989}"/>
              </a:ext>
            </a:extLst>
          </p:cNvPr>
          <p:cNvCxnSpPr>
            <a:cxnSpLocks/>
          </p:cNvCxnSpPr>
          <p:nvPr/>
        </p:nvCxnSpPr>
        <p:spPr>
          <a:xfrm>
            <a:off x="2248794" y="2898871"/>
            <a:ext cx="203209" cy="327048"/>
          </a:xfrm>
          <a:prstGeom prst="straightConnector1">
            <a:avLst/>
          </a:prstGeom>
          <a:ln w="28575">
            <a:solidFill>
              <a:srgbClr val="FFC000"/>
            </a:solidFill>
            <a:headEnd type="triangle"/>
            <a:tailEnd type="triangle"/>
          </a:ln>
        </p:spPr>
        <p:style>
          <a:lnRef idx="1">
            <a:schemeClr val="accent1"/>
          </a:lnRef>
          <a:fillRef idx="0">
            <a:schemeClr val="accent1"/>
          </a:fillRef>
          <a:effectRef idx="0">
            <a:schemeClr val="accent1"/>
          </a:effectRef>
          <a:fontRef idx="minor">
            <a:schemeClr val="tx1"/>
          </a:fontRef>
        </p:style>
      </p:cxnSp>
      <p:cxnSp>
        <p:nvCxnSpPr>
          <p:cNvPr id="14" name="Gerade Verbindung mit Pfeil 13">
            <a:extLst>
              <a:ext uri="{FF2B5EF4-FFF2-40B4-BE49-F238E27FC236}">
                <a16:creationId xmlns:a16="http://schemas.microsoft.com/office/drawing/2014/main" id="{9F2649AA-6140-E9A5-0EF0-8C201A2DE6AD}"/>
              </a:ext>
            </a:extLst>
          </p:cNvPr>
          <p:cNvCxnSpPr>
            <a:cxnSpLocks/>
          </p:cNvCxnSpPr>
          <p:nvPr/>
        </p:nvCxnSpPr>
        <p:spPr>
          <a:xfrm>
            <a:off x="10432589" y="2871898"/>
            <a:ext cx="0" cy="389354"/>
          </a:xfrm>
          <a:prstGeom prst="straightConnector1">
            <a:avLst/>
          </a:prstGeom>
          <a:ln w="28575">
            <a:solidFill>
              <a:srgbClr val="FFC000"/>
            </a:solidFill>
            <a:headEnd type="triangle"/>
            <a:tailEnd type="triangle"/>
          </a:ln>
        </p:spPr>
        <p:style>
          <a:lnRef idx="1">
            <a:schemeClr val="accent1"/>
          </a:lnRef>
          <a:fillRef idx="0">
            <a:schemeClr val="accent1"/>
          </a:fillRef>
          <a:effectRef idx="0">
            <a:schemeClr val="accent1"/>
          </a:effectRef>
          <a:fontRef idx="minor">
            <a:schemeClr val="tx1"/>
          </a:fontRef>
        </p:style>
      </p:cxnSp>
      <p:sp>
        <p:nvSpPr>
          <p:cNvPr id="15" name="Oval 14">
            <a:extLst>
              <a:ext uri="{FF2B5EF4-FFF2-40B4-BE49-F238E27FC236}">
                <a16:creationId xmlns:a16="http://schemas.microsoft.com/office/drawing/2014/main" id="{8610FA0B-43FA-6698-4B82-19CB2A3A29FF}"/>
              </a:ext>
            </a:extLst>
          </p:cNvPr>
          <p:cNvSpPr/>
          <p:nvPr/>
        </p:nvSpPr>
        <p:spPr>
          <a:xfrm rot="19066514" flipH="1">
            <a:off x="10637123" y="2985794"/>
            <a:ext cx="167424" cy="176708"/>
          </a:xfrm>
          <a:prstGeom prst="ellipse">
            <a:avLst/>
          </a:prstGeom>
          <a:solidFill>
            <a:srgbClr val="FF0000">
              <a:alpha val="50196"/>
            </a:srgbClr>
          </a:solidFill>
          <a:ln w="38100">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7" name="Oval 16">
            <a:extLst>
              <a:ext uri="{FF2B5EF4-FFF2-40B4-BE49-F238E27FC236}">
                <a16:creationId xmlns:a16="http://schemas.microsoft.com/office/drawing/2014/main" id="{8E970B84-00A1-0C46-DDC0-634BDDEFA2C3}"/>
              </a:ext>
            </a:extLst>
          </p:cNvPr>
          <p:cNvSpPr/>
          <p:nvPr/>
        </p:nvSpPr>
        <p:spPr>
          <a:xfrm rot="19066514" flipH="1">
            <a:off x="10061108" y="2985795"/>
            <a:ext cx="167424" cy="176708"/>
          </a:xfrm>
          <a:prstGeom prst="ellipse">
            <a:avLst/>
          </a:prstGeom>
          <a:solidFill>
            <a:srgbClr val="FF0000">
              <a:alpha val="50196"/>
            </a:srgbClr>
          </a:solidFill>
          <a:ln w="38100">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6" name="Textfeld 5">
            <a:extLst>
              <a:ext uri="{FF2B5EF4-FFF2-40B4-BE49-F238E27FC236}">
                <a16:creationId xmlns:a16="http://schemas.microsoft.com/office/drawing/2014/main" id="{9261DD1F-7168-FD1E-563E-72CA52D116B4}"/>
              </a:ext>
            </a:extLst>
          </p:cNvPr>
          <p:cNvSpPr txBox="1"/>
          <p:nvPr/>
        </p:nvSpPr>
        <p:spPr>
          <a:xfrm>
            <a:off x="0" y="397384"/>
            <a:ext cx="2195024" cy="369332"/>
          </a:xfrm>
          <a:prstGeom prst="rect">
            <a:avLst/>
          </a:prstGeom>
          <a:noFill/>
        </p:spPr>
        <p:txBody>
          <a:bodyPr wrap="none" rtlCol="0">
            <a:spAutoFit/>
          </a:bodyPr>
          <a:lstStyle/>
          <a:p>
            <a:r>
              <a:rPr lang="de-CH" dirty="0"/>
              <a:t>Appendix 2, </a:t>
            </a:r>
            <a:r>
              <a:rPr lang="de-CH" dirty="0" err="1"/>
              <a:t>figure</a:t>
            </a:r>
            <a:r>
              <a:rPr lang="de-CH" dirty="0"/>
              <a:t> 3B</a:t>
            </a:r>
          </a:p>
        </p:txBody>
      </p:sp>
    </p:spTree>
    <p:extLst>
      <p:ext uri="{BB962C8B-B14F-4D97-AF65-F5344CB8AC3E}">
        <p14:creationId xmlns:p14="http://schemas.microsoft.com/office/powerpoint/2010/main" val="119332121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a:extLst>
              <a:ext uri="{FF2B5EF4-FFF2-40B4-BE49-F238E27FC236}">
                <a16:creationId xmlns:a16="http://schemas.microsoft.com/office/drawing/2014/main" id="{5088352F-D7DE-B1D7-7C5D-C1780B5A92FD}"/>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0" y="1143000"/>
            <a:ext cx="12192000" cy="4572000"/>
          </a:xfrm>
          <a:prstGeom prst="rect">
            <a:avLst/>
          </a:prstGeom>
          <a:noFill/>
          <a:extLst>
            <a:ext uri="{909E8E84-426E-40DD-AFC4-6F175D3DCCD1}">
              <a14:hiddenFill xmlns:a14="http://schemas.microsoft.com/office/drawing/2010/main">
                <a:solidFill>
                  <a:srgbClr val="FFFFFF"/>
                </a:solidFill>
              </a14:hiddenFill>
            </a:ext>
          </a:extLst>
        </p:spPr>
      </p:pic>
      <p:sp>
        <p:nvSpPr>
          <p:cNvPr id="2" name="Textfeld 1">
            <a:extLst>
              <a:ext uri="{FF2B5EF4-FFF2-40B4-BE49-F238E27FC236}">
                <a16:creationId xmlns:a16="http://schemas.microsoft.com/office/drawing/2014/main" id="{C5DA76CB-70DD-E29E-DEB4-7CEA343D80DB}"/>
              </a:ext>
            </a:extLst>
          </p:cNvPr>
          <p:cNvSpPr txBox="1"/>
          <p:nvPr/>
        </p:nvSpPr>
        <p:spPr>
          <a:xfrm>
            <a:off x="228600" y="444500"/>
            <a:ext cx="2879571" cy="369332"/>
          </a:xfrm>
          <a:prstGeom prst="rect">
            <a:avLst/>
          </a:prstGeom>
          <a:noFill/>
        </p:spPr>
        <p:txBody>
          <a:bodyPr wrap="none" rtlCol="0">
            <a:spAutoFit/>
          </a:bodyPr>
          <a:lstStyle/>
          <a:p>
            <a:r>
              <a:rPr lang="de-CH" dirty="0"/>
              <a:t>Appendix 2, </a:t>
            </a:r>
            <a:r>
              <a:rPr lang="de-CH" dirty="0" err="1"/>
              <a:t>figure</a:t>
            </a:r>
            <a:r>
              <a:rPr lang="de-CH" dirty="0"/>
              <a:t> 4 A, B &amp; C</a:t>
            </a:r>
          </a:p>
        </p:txBody>
      </p:sp>
      <p:sp>
        <p:nvSpPr>
          <p:cNvPr id="3" name="Textfeld 2">
            <a:extLst>
              <a:ext uri="{FF2B5EF4-FFF2-40B4-BE49-F238E27FC236}">
                <a16:creationId xmlns:a16="http://schemas.microsoft.com/office/drawing/2014/main" id="{87A1261A-A30D-25F9-D0AF-B0EFDF4FD313}"/>
              </a:ext>
            </a:extLst>
          </p:cNvPr>
          <p:cNvSpPr txBox="1"/>
          <p:nvPr/>
        </p:nvSpPr>
        <p:spPr>
          <a:xfrm>
            <a:off x="215886" y="1295400"/>
            <a:ext cx="317716" cy="369332"/>
          </a:xfrm>
          <a:prstGeom prst="rect">
            <a:avLst/>
          </a:prstGeom>
          <a:noFill/>
        </p:spPr>
        <p:txBody>
          <a:bodyPr wrap="none" rtlCol="0">
            <a:spAutoFit/>
          </a:bodyPr>
          <a:lstStyle/>
          <a:p>
            <a:r>
              <a:rPr lang="de-CH" dirty="0">
                <a:solidFill>
                  <a:schemeClr val="bg1"/>
                </a:solidFill>
              </a:rPr>
              <a:t>A</a:t>
            </a:r>
          </a:p>
        </p:txBody>
      </p:sp>
      <p:sp>
        <p:nvSpPr>
          <p:cNvPr id="4" name="Textfeld 3">
            <a:extLst>
              <a:ext uri="{FF2B5EF4-FFF2-40B4-BE49-F238E27FC236}">
                <a16:creationId xmlns:a16="http://schemas.microsoft.com/office/drawing/2014/main" id="{D773F56D-23EB-C0A9-2563-F8C262F059E4}"/>
              </a:ext>
            </a:extLst>
          </p:cNvPr>
          <p:cNvSpPr txBox="1"/>
          <p:nvPr/>
        </p:nvSpPr>
        <p:spPr>
          <a:xfrm>
            <a:off x="4127486" y="1283732"/>
            <a:ext cx="309700" cy="369332"/>
          </a:xfrm>
          <a:prstGeom prst="rect">
            <a:avLst/>
          </a:prstGeom>
          <a:noFill/>
        </p:spPr>
        <p:txBody>
          <a:bodyPr wrap="none" rtlCol="0">
            <a:spAutoFit/>
          </a:bodyPr>
          <a:lstStyle/>
          <a:p>
            <a:r>
              <a:rPr lang="de-CH" dirty="0">
                <a:solidFill>
                  <a:schemeClr val="bg1"/>
                </a:solidFill>
              </a:rPr>
              <a:t>B</a:t>
            </a:r>
          </a:p>
        </p:txBody>
      </p:sp>
      <p:sp>
        <p:nvSpPr>
          <p:cNvPr id="5" name="Textfeld 4">
            <a:extLst>
              <a:ext uri="{FF2B5EF4-FFF2-40B4-BE49-F238E27FC236}">
                <a16:creationId xmlns:a16="http://schemas.microsoft.com/office/drawing/2014/main" id="{7EA44C2D-9505-4AE1-207E-F7494575615B}"/>
              </a:ext>
            </a:extLst>
          </p:cNvPr>
          <p:cNvSpPr txBox="1"/>
          <p:nvPr/>
        </p:nvSpPr>
        <p:spPr>
          <a:xfrm>
            <a:off x="8159743" y="1309132"/>
            <a:ext cx="308098" cy="369332"/>
          </a:xfrm>
          <a:prstGeom prst="rect">
            <a:avLst/>
          </a:prstGeom>
          <a:noFill/>
        </p:spPr>
        <p:txBody>
          <a:bodyPr wrap="none" rtlCol="0">
            <a:spAutoFit/>
          </a:bodyPr>
          <a:lstStyle/>
          <a:p>
            <a:r>
              <a:rPr lang="de-CH" dirty="0">
                <a:solidFill>
                  <a:schemeClr val="bg1"/>
                </a:solidFill>
              </a:rPr>
              <a:t>C</a:t>
            </a:r>
          </a:p>
        </p:txBody>
      </p:sp>
    </p:spTree>
    <p:extLst>
      <p:ext uri="{BB962C8B-B14F-4D97-AF65-F5344CB8AC3E}">
        <p14:creationId xmlns:p14="http://schemas.microsoft.com/office/powerpoint/2010/main" val="311098671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a:extLst>
              <a:ext uri="{FF2B5EF4-FFF2-40B4-BE49-F238E27FC236}">
                <a16:creationId xmlns:a16="http://schemas.microsoft.com/office/drawing/2014/main" id="{E09E9E26-17DD-5DC4-AE86-242C307686E4}"/>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706563" y="0"/>
            <a:ext cx="8777287" cy="6858000"/>
          </a:xfrm>
          <a:prstGeom prst="rect">
            <a:avLst/>
          </a:prstGeom>
          <a:noFill/>
          <a:extLst>
            <a:ext uri="{909E8E84-426E-40DD-AFC4-6F175D3DCCD1}">
              <a14:hiddenFill xmlns:a14="http://schemas.microsoft.com/office/drawing/2010/main">
                <a:solidFill>
                  <a:srgbClr val="FFFFFF"/>
                </a:solidFill>
              </a14:hiddenFill>
            </a:ext>
          </a:extLst>
        </p:spPr>
      </p:pic>
      <p:cxnSp>
        <p:nvCxnSpPr>
          <p:cNvPr id="3" name="Gerade Verbindung 2">
            <a:extLst>
              <a:ext uri="{FF2B5EF4-FFF2-40B4-BE49-F238E27FC236}">
                <a16:creationId xmlns:a16="http://schemas.microsoft.com/office/drawing/2014/main" id="{7A011D2C-FFE0-72BA-07FB-D746B237BD1A}"/>
              </a:ext>
            </a:extLst>
          </p:cNvPr>
          <p:cNvCxnSpPr>
            <a:cxnSpLocks/>
          </p:cNvCxnSpPr>
          <p:nvPr/>
        </p:nvCxnSpPr>
        <p:spPr>
          <a:xfrm flipV="1">
            <a:off x="4432151" y="1828800"/>
            <a:ext cx="3711388" cy="4658061"/>
          </a:xfrm>
          <a:prstGeom prst="line">
            <a:avLst/>
          </a:prstGeom>
          <a:ln w="28575">
            <a:solidFill>
              <a:srgbClr val="FFFF00"/>
            </a:solidFill>
            <a:prstDash val="solid"/>
          </a:ln>
        </p:spPr>
        <p:style>
          <a:lnRef idx="1">
            <a:schemeClr val="accent1"/>
          </a:lnRef>
          <a:fillRef idx="0">
            <a:schemeClr val="accent1"/>
          </a:fillRef>
          <a:effectRef idx="0">
            <a:schemeClr val="accent1"/>
          </a:effectRef>
          <a:fontRef idx="minor">
            <a:schemeClr val="tx1"/>
          </a:fontRef>
        </p:style>
      </p:cxnSp>
      <p:sp>
        <p:nvSpPr>
          <p:cNvPr id="7" name="Bogen 6">
            <a:extLst>
              <a:ext uri="{FF2B5EF4-FFF2-40B4-BE49-F238E27FC236}">
                <a16:creationId xmlns:a16="http://schemas.microsoft.com/office/drawing/2014/main" id="{38BE7196-443D-66E1-8DF2-D3899D8B1493}"/>
              </a:ext>
            </a:extLst>
          </p:cNvPr>
          <p:cNvSpPr/>
          <p:nvPr/>
        </p:nvSpPr>
        <p:spPr>
          <a:xfrm rot="1522500">
            <a:off x="4154312" y="5441245"/>
            <a:ext cx="1467555" cy="1467555"/>
          </a:xfrm>
          <a:prstGeom prst="arc">
            <a:avLst/>
          </a:prstGeom>
          <a:noFill/>
          <a:ln w="38100">
            <a:solidFill>
              <a:srgbClr val="FFFF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de-DE"/>
          </a:p>
        </p:txBody>
      </p:sp>
      <p:cxnSp>
        <p:nvCxnSpPr>
          <p:cNvPr id="8" name="Gerade Verbindung 7">
            <a:extLst>
              <a:ext uri="{FF2B5EF4-FFF2-40B4-BE49-F238E27FC236}">
                <a16:creationId xmlns:a16="http://schemas.microsoft.com/office/drawing/2014/main" id="{7A4F2114-A70C-3B05-7C84-E4BC33D9E32A}"/>
              </a:ext>
            </a:extLst>
          </p:cNvPr>
          <p:cNvCxnSpPr>
            <a:cxnSpLocks/>
          </p:cNvCxnSpPr>
          <p:nvPr/>
        </p:nvCxnSpPr>
        <p:spPr>
          <a:xfrm>
            <a:off x="4432151" y="6498150"/>
            <a:ext cx="5899299" cy="0"/>
          </a:xfrm>
          <a:prstGeom prst="line">
            <a:avLst/>
          </a:prstGeom>
          <a:ln w="28575">
            <a:solidFill>
              <a:schemeClr val="bg1">
                <a:lumMod val="65000"/>
              </a:schemeClr>
            </a:solidFill>
            <a:prstDash val="solid"/>
          </a:ln>
        </p:spPr>
        <p:style>
          <a:lnRef idx="1">
            <a:schemeClr val="accent1"/>
          </a:lnRef>
          <a:fillRef idx="0">
            <a:schemeClr val="accent1"/>
          </a:fillRef>
          <a:effectRef idx="0">
            <a:schemeClr val="accent1"/>
          </a:effectRef>
          <a:fontRef idx="minor">
            <a:schemeClr val="tx1"/>
          </a:fontRef>
        </p:style>
      </p:cxnSp>
      <p:cxnSp>
        <p:nvCxnSpPr>
          <p:cNvPr id="13" name="Gerade Verbindung 12">
            <a:extLst>
              <a:ext uri="{FF2B5EF4-FFF2-40B4-BE49-F238E27FC236}">
                <a16:creationId xmlns:a16="http://schemas.microsoft.com/office/drawing/2014/main" id="{40686085-14D1-A99D-AEAD-EF1AB6E27B64}"/>
              </a:ext>
            </a:extLst>
          </p:cNvPr>
          <p:cNvCxnSpPr>
            <a:cxnSpLocks/>
          </p:cNvCxnSpPr>
          <p:nvPr/>
        </p:nvCxnSpPr>
        <p:spPr>
          <a:xfrm flipH="1" flipV="1">
            <a:off x="3714044" y="462844"/>
            <a:ext cx="4429495" cy="1354667"/>
          </a:xfrm>
          <a:prstGeom prst="line">
            <a:avLst/>
          </a:prstGeom>
          <a:ln w="28575">
            <a:solidFill>
              <a:schemeClr val="accent1">
                <a:lumMod val="60000"/>
                <a:lumOff val="40000"/>
              </a:schemeClr>
            </a:solidFill>
            <a:prstDash val="solid"/>
          </a:ln>
        </p:spPr>
        <p:style>
          <a:lnRef idx="1">
            <a:schemeClr val="accent1"/>
          </a:lnRef>
          <a:fillRef idx="0">
            <a:schemeClr val="accent1"/>
          </a:fillRef>
          <a:effectRef idx="0">
            <a:schemeClr val="accent1"/>
          </a:effectRef>
          <a:fontRef idx="minor">
            <a:schemeClr val="tx1"/>
          </a:fontRef>
        </p:style>
      </p:cxnSp>
      <p:cxnSp>
        <p:nvCxnSpPr>
          <p:cNvPr id="16" name="Gerade Verbindung 15">
            <a:extLst>
              <a:ext uri="{FF2B5EF4-FFF2-40B4-BE49-F238E27FC236}">
                <a16:creationId xmlns:a16="http://schemas.microsoft.com/office/drawing/2014/main" id="{4AF09286-DAD1-3F6B-CF1F-C460B256968E}"/>
              </a:ext>
            </a:extLst>
          </p:cNvPr>
          <p:cNvCxnSpPr>
            <a:cxnSpLocks/>
          </p:cNvCxnSpPr>
          <p:nvPr/>
        </p:nvCxnSpPr>
        <p:spPr>
          <a:xfrm flipH="1">
            <a:off x="3714044" y="474133"/>
            <a:ext cx="5238045" cy="0"/>
          </a:xfrm>
          <a:prstGeom prst="line">
            <a:avLst/>
          </a:prstGeom>
          <a:ln w="28575">
            <a:solidFill>
              <a:schemeClr val="bg1">
                <a:lumMod val="65000"/>
              </a:schemeClr>
            </a:solidFill>
            <a:prstDash val="solid"/>
          </a:ln>
        </p:spPr>
        <p:style>
          <a:lnRef idx="1">
            <a:schemeClr val="accent1"/>
          </a:lnRef>
          <a:fillRef idx="0">
            <a:schemeClr val="accent1"/>
          </a:fillRef>
          <a:effectRef idx="0">
            <a:schemeClr val="accent1"/>
          </a:effectRef>
          <a:fontRef idx="minor">
            <a:schemeClr val="tx1"/>
          </a:fontRef>
        </p:style>
      </p:cxnSp>
      <p:sp>
        <p:nvSpPr>
          <p:cNvPr id="19" name="Bogen 18">
            <a:extLst>
              <a:ext uri="{FF2B5EF4-FFF2-40B4-BE49-F238E27FC236}">
                <a16:creationId xmlns:a16="http://schemas.microsoft.com/office/drawing/2014/main" id="{AA1F7644-51FF-35F3-1CE0-696E477A8480}"/>
              </a:ext>
            </a:extLst>
          </p:cNvPr>
          <p:cNvSpPr/>
          <p:nvPr/>
        </p:nvSpPr>
        <p:spPr>
          <a:xfrm rot="5400000">
            <a:off x="3910651" y="-252823"/>
            <a:ext cx="1467555" cy="1467555"/>
          </a:xfrm>
          <a:prstGeom prst="arc">
            <a:avLst>
              <a:gd name="adj1" fmla="val 16200000"/>
              <a:gd name="adj2" fmla="val 18479146"/>
            </a:avLst>
          </a:prstGeom>
          <a:noFill/>
          <a:ln w="38100">
            <a:solidFill>
              <a:schemeClr val="accent1">
                <a:lumMod val="60000"/>
                <a:lumOff val="40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de-DE"/>
          </a:p>
        </p:txBody>
      </p:sp>
      <p:sp>
        <p:nvSpPr>
          <p:cNvPr id="35" name="Freihandform 34">
            <a:extLst>
              <a:ext uri="{FF2B5EF4-FFF2-40B4-BE49-F238E27FC236}">
                <a16:creationId xmlns:a16="http://schemas.microsoft.com/office/drawing/2014/main" id="{3A9A7A7A-CE22-23FF-88A7-F6E4F786106C}"/>
              </a:ext>
            </a:extLst>
          </p:cNvPr>
          <p:cNvSpPr/>
          <p:nvPr/>
        </p:nvSpPr>
        <p:spPr>
          <a:xfrm>
            <a:off x="5369975" y="5259211"/>
            <a:ext cx="1077696" cy="656262"/>
          </a:xfrm>
          <a:custGeom>
            <a:avLst/>
            <a:gdLst>
              <a:gd name="connsiteX0" fmla="*/ 364781 w 1077696"/>
              <a:gd name="connsiteY0" fmla="*/ 69145 h 656262"/>
              <a:gd name="connsiteX1" fmla="*/ 884069 w 1077696"/>
              <a:gd name="connsiteY1" fmla="*/ 317500 h 656262"/>
              <a:gd name="connsiteX2" fmla="*/ 1042114 w 1077696"/>
              <a:gd name="connsiteY2" fmla="*/ 452967 h 656262"/>
              <a:gd name="connsiteX3" fmla="*/ 1075981 w 1077696"/>
              <a:gd name="connsiteY3" fmla="*/ 531989 h 656262"/>
              <a:gd name="connsiteX4" fmla="*/ 1008247 w 1077696"/>
              <a:gd name="connsiteY4" fmla="*/ 611011 h 656262"/>
              <a:gd name="connsiteX5" fmla="*/ 793758 w 1077696"/>
              <a:gd name="connsiteY5" fmla="*/ 656167 h 656262"/>
              <a:gd name="connsiteX6" fmla="*/ 556692 w 1077696"/>
              <a:gd name="connsiteY6" fmla="*/ 599722 h 656262"/>
              <a:gd name="connsiteX7" fmla="*/ 172869 w 1077696"/>
              <a:gd name="connsiteY7" fmla="*/ 396522 h 656262"/>
              <a:gd name="connsiteX8" fmla="*/ 37403 w 1077696"/>
              <a:gd name="connsiteY8" fmla="*/ 249767 h 656262"/>
              <a:gd name="connsiteX9" fmla="*/ 3536 w 1077696"/>
              <a:gd name="connsiteY9" fmla="*/ 103011 h 656262"/>
              <a:gd name="connsiteX10" fmla="*/ 105136 w 1077696"/>
              <a:gd name="connsiteY10" fmla="*/ 1411 h 656262"/>
              <a:gd name="connsiteX11" fmla="*/ 364781 w 1077696"/>
              <a:gd name="connsiteY11" fmla="*/ 69145 h 65626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1077696" h="656262">
                <a:moveTo>
                  <a:pt x="364781" y="69145"/>
                </a:moveTo>
                <a:cubicBezTo>
                  <a:pt x="494603" y="121826"/>
                  <a:pt x="771180" y="253530"/>
                  <a:pt x="884069" y="317500"/>
                </a:cubicBezTo>
                <a:cubicBezTo>
                  <a:pt x="996958" y="381470"/>
                  <a:pt x="1010129" y="417219"/>
                  <a:pt x="1042114" y="452967"/>
                </a:cubicBezTo>
                <a:cubicBezTo>
                  <a:pt x="1074099" y="488715"/>
                  <a:pt x="1081625" y="505648"/>
                  <a:pt x="1075981" y="531989"/>
                </a:cubicBezTo>
                <a:cubicBezTo>
                  <a:pt x="1070337" y="558330"/>
                  <a:pt x="1055284" y="590315"/>
                  <a:pt x="1008247" y="611011"/>
                </a:cubicBezTo>
                <a:cubicBezTo>
                  <a:pt x="961210" y="631707"/>
                  <a:pt x="869017" y="658048"/>
                  <a:pt x="793758" y="656167"/>
                </a:cubicBezTo>
                <a:cubicBezTo>
                  <a:pt x="718499" y="654286"/>
                  <a:pt x="660173" y="642996"/>
                  <a:pt x="556692" y="599722"/>
                </a:cubicBezTo>
                <a:cubicBezTo>
                  <a:pt x="453211" y="556448"/>
                  <a:pt x="259417" y="454848"/>
                  <a:pt x="172869" y="396522"/>
                </a:cubicBezTo>
                <a:cubicBezTo>
                  <a:pt x="86321" y="338196"/>
                  <a:pt x="65625" y="298686"/>
                  <a:pt x="37403" y="249767"/>
                </a:cubicBezTo>
                <a:cubicBezTo>
                  <a:pt x="9181" y="200849"/>
                  <a:pt x="-7753" y="144404"/>
                  <a:pt x="3536" y="103011"/>
                </a:cubicBezTo>
                <a:cubicBezTo>
                  <a:pt x="14825" y="61618"/>
                  <a:pt x="43047" y="8937"/>
                  <a:pt x="105136" y="1411"/>
                </a:cubicBezTo>
                <a:cubicBezTo>
                  <a:pt x="167225" y="-6115"/>
                  <a:pt x="234959" y="16464"/>
                  <a:pt x="364781" y="69145"/>
                </a:cubicBezTo>
                <a:close/>
              </a:path>
            </a:pathLst>
          </a:custGeom>
          <a:noFill/>
          <a:ln w="28575">
            <a:solidFill>
              <a:schemeClr val="bg1"/>
            </a:solidFill>
            <a:prstDash val="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6" name="Pfeil nach rechts 35">
            <a:extLst>
              <a:ext uri="{FF2B5EF4-FFF2-40B4-BE49-F238E27FC236}">
                <a16:creationId xmlns:a16="http://schemas.microsoft.com/office/drawing/2014/main" id="{5C19310A-419B-AFF5-43C7-A30BFB92BCD8}"/>
              </a:ext>
            </a:extLst>
          </p:cNvPr>
          <p:cNvSpPr/>
          <p:nvPr/>
        </p:nvSpPr>
        <p:spPr>
          <a:xfrm rot="2145479">
            <a:off x="4810186" y="4931661"/>
            <a:ext cx="521625" cy="244779"/>
          </a:xfrm>
          <a:prstGeom prst="rightArrow">
            <a:avLst>
              <a:gd name="adj1" fmla="val 50000"/>
              <a:gd name="adj2" fmla="val 89079"/>
            </a:avLst>
          </a:prstGeom>
          <a:solidFill>
            <a:schemeClr val="bg1"/>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7" name="Pfeil nach rechts 36">
            <a:extLst>
              <a:ext uri="{FF2B5EF4-FFF2-40B4-BE49-F238E27FC236}">
                <a16:creationId xmlns:a16="http://schemas.microsoft.com/office/drawing/2014/main" id="{18384DDC-24AC-A1BF-BBF4-B10DD733552F}"/>
              </a:ext>
            </a:extLst>
          </p:cNvPr>
          <p:cNvSpPr/>
          <p:nvPr/>
        </p:nvSpPr>
        <p:spPr>
          <a:xfrm rot="18669413">
            <a:off x="7111723" y="1890333"/>
            <a:ext cx="521625" cy="244779"/>
          </a:xfrm>
          <a:prstGeom prst="rightArrow">
            <a:avLst>
              <a:gd name="adj1" fmla="val 50000"/>
              <a:gd name="adj2" fmla="val 89079"/>
            </a:avLst>
          </a:prstGeom>
          <a:solidFill>
            <a:schemeClr val="tx1"/>
          </a:solidFill>
          <a:ln w="28575">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38" name="Textfeld 37">
            <a:extLst>
              <a:ext uri="{FF2B5EF4-FFF2-40B4-BE49-F238E27FC236}">
                <a16:creationId xmlns:a16="http://schemas.microsoft.com/office/drawing/2014/main" id="{F2F101A5-AA68-5751-3ECA-BA5065BD9992}"/>
              </a:ext>
            </a:extLst>
          </p:cNvPr>
          <p:cNvSpPr txBox="1"/>
          <p:nvPr/>
        </p:nvSpPr>
        <p:spPr>
          <a:xfrm>
            <a:off x="4808613" y="368427"/>
            <a:ext cx="399468" cy="523220"/>
          </a:xfrm>
          <a:prstGeom prst="rect">
            <a:avLst/>
          </a:prstGeom>
          <a:noFill/>
        </p:spPr>
        <p:txBody>
          <a:bodyPr wrap="none" rtlCol="0">
            <a:spAutoFit/>
          </a:bodyPr>
          <a:lstStyle/>
          <a:p>
            <a:r>
              <a:rPr lang="de-DE" sz="2800" dirty="0">
                <a:solidFill>
                  <a:schemeClr val="accent6">
                    <a:lumMod val="60000"/>
                    <a:lumOff val="40000"/>
                  </a:schemeClr>
                </a:solidFill>
              </a:rPr>
              <a:t>𝛼</a:t>
            </a:r>
          </a:p>
        </p:txBody>
      </p:sp>
      <p:sp>
        <p:nvSpPr>
          <p:cNvPr id="39" name="Textfeld 38">
            <a:extLst>
              <a:ext uri="{FF2B5EF4-FFF2-40B4-BE49-F238E27FC236}">
                <a16:creationId xmlns:a16="http://schemas.microsoft.com/office/drawing/2014/main" id="{2F331357-40AC-9B62-D64C-BCEC9DD7427C}"/>
              </a:ext>
            </a:extLst>
          </p:cNvPr>
          <p:cNvSpPr txBox="1"/>
          <p:nvPr/>
        </p:nvSpPr>
        <p:spPr>
          <a:xfrm>
            <a:off x="4975532" y="5799092"/>
            <a:ext cx="402674" cy="584775"/>
          </a:xfrm>
          <a:prstGeom prst="rect">
            <a:avLst/>
          </a:prstGeom>
          <a:noFill/>
        </p:spPr>
        <p:txBody>
          <a:bodyPr wrap="none" rtlCol="0">
            <a:spAutoFit/>
          </a:bodyPr>
          <a:lstStyle/>
          <a:p>
            <a:r>
              <a:rPr lang="de-DE" sz="3200" dirty="0">
                <a:solidFill>
                  <a:srgbClr val="FFC000"/>
                </a:solidFill>
              </a:rPr>
              <a:t>β</a:t>
            </a:r>
          </a:p>
        </p:txBody>
      </p:sp>
      <p:sp>
        <p:nvSpPr>
          <p:cNvPr id="31" name="Freihandform 30">
            <a:extLst>
              <a:ext uri="{FF2B5EF4-FFF2-40B4-BE49-F238E27FC236}">
                <a16:creationId xmlns:a16="http://schemas.microsoft.com/office/drawing/2014/main" id="{E662959A-8D45-662A-EDE1-C4D129D95322}"/>
              </a:ext>
            </a:extLst>
          </p:cNvPr>
          <p:cNvSpPr/>
          <p:nvPr/>
        </p:nvSpPr>
        <p:spPr>
          <a:xfrm>
            <a:off x="7300923" y="985721"/>
            <a:ext cx="1163070" cy="823676"/>
          </a:xfrm>
          <a:custGeom>
            <a:avLst/>
            <a:gdLst>
              <a:gd name="connsiteX0" fmla="*/ 82010 w 1163070"/>
              <a:gd name="connsiteY0" fmla="*/ 470546 h 823676"/>
              <a:gd name="connsiteX1" fmla="*/ 431966 w 1163070"/>
              <a:gd name="connsiteY1" fmla="*/ 143168 h 823676"/>
              <a:gd name="connsiteX2" fmla="*/ 556144 w 1163070"/>
              <a:gd name="connsiteY2" fmla="*/ 30279 h 823676"/>
              <a:gd name="connsiteX3" fmla="*/ 702899 w 1163070"/>
              <a:gd name="connsiteY3" fmla="*/ 7701 h 823676"/>
              <a:gd name="connsiteX4" fmla="*/ 883521 w 1163070"/>
              <a:gd name="connsiteY4" fmla="*/ 143168 h 823676"/>
              <a:gd name="connsiteX5" fmla="*/ 1154455 w 1163070"/>
              <a:gd name="connsiteY5" fmla="*/ 346368 h 823676"/>
              <a:gd name="connsiteX6" fmla="*/ 1075433 w 1163070"/>
              <a:gd name="connsiteY6" fmla="*/ 526990 h 823676"/>
              <a:gd name="connsiteX7" fmla="*/ 872233 w 1163070"/>
              <a:gd name="connsiteY7" fmla="*/ 764057 h 823676"/>
              <a:gd name="connsiteX8" fmla="*/ 759344 w 1163070"/>
              <a:gd name="connsiteY8" fmla="*/ 820501 h 823676"/>
              <a:gd name="connsiteX9" fmla="*/ 409388 w 1163070"/>
              <a:gd name="connsiteY9" fmla="*/ 696323 h 823676"/>
              <a:gd name="connsiteX10" fmla="*/ 25566 w 1163070"/>
              <a:gd name="connsiteY10" fmla="*/ 583435 h 823676"/>
              <a:gd name="connsiteX11" fmla="*/ 82010 w 1163070"/>
              <a:gd name="connsiteY11" fmla="*/ 470546 h 82367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1163070" h="823676">
                <a:moveTo>
                  <a:pt x="82010" y="470546"/>
                </a:moveTo>
                <a:cubicBezTo>
                  <a:pt x="149743" y="397168"/>
                  <a:pt x="352944" y="216546"/>
                  <a:pt x="431966" y="143168"/>
                </a:cubicBezTo>
                <a:cubicBezTo>
                  <a:pt x="510988" y="69790"/>
                  <a:pt x="510989" y="52857"/>
                  <a:pt x="556144" y="30279"/>
                </a:cubicBezTo>
                <a:cubicBezTo>
                  <a:pt x="601300" y="7701"/>
                  <a:pt x="648336" y="-11114"/>
                  <a:pt x="702899" y="7701"/>
                </a:cubicBezTo>
                <a:cubicBezTo>
                  <a:pt x="757462" y="26516"/>
                  <a:pt x="883521" y="143168"/>
                  <a:pt x="883521" y="143168"/>
                </a:cubicBezTo>
                <a:cubicBezTo>
                  <a:pt x="958780" y="199612"/>
                  <a:pt x="1122470" y="282398"/>
                  <a:pt x="1154455" y="346368"/>
                </a:cubicBezTo>
                <a:cubicBezTo>
                  <a:pt x="1186440" y="410338"/>
                  <a:pt x="1122470" y="457375"/>
                  <a:pt x="1075433" y="526990"/>
                </a:cubicBezTo>
                <a:cubicBezTo>
                  <a:pt x="1028396" y="596605"/>
                  <a:pt x="924914" y="715139"/>
                  <a:pt x="872233" y="764057"/>
                </a:cubicBezTo>
                <a:cubicBezTo>
                  <a:pt x="819552" y="812975"/>
                  <a:pt x="836485" y="831790"/>
                  <a:pt x="759344" y="820501"/>
                </a:cubicBezTo>
                <a:cubicBezTo>
                  <a:pt x="682203" y="809212"/>
                  <a:pt x="531684" y="735834"/>
                  <a:pt x="409388" y="696323"/>
                </a:cubicBezTo>
                <a:cubicBezTo>
                  <a:pt x="287092" y="656812"/>
                  <a:pt x="82010" y="622946"/>
                  <a:pt x="25566" y="583435"/>
                </a:cubicBezTo>
                <a:cubicBezTo>
                  <a:pt x="-30878" y="543924"/>
                  <a:pt x="14277" y="543924"/>
                  <a:pt x="82010" y="470546"/>
                </a:cubicBezTo>
                <a:close/>
              </a:path>
            </a:pathLst>
          </a:custGeom>
          <a:noFill/>
          <a:ln w="28575">
            <a:solidFill>
              <a:schemeClr val="bg1"/>
            </a:solidFill>
            <a:prstDash val="solid"/>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 name="Freihandform: Form 3">
            <a:extLst>
              <a:ext uri="{FF2B5EF4-FFF2-40B4-BE49-F238E27FC236}">
                <a16:creationId xmlns:a16="http://schemas.microsoft.com/office/drawing/2014/main" id="{F14D6774-A88F-BB41-BC4B-CE2967231ED6}"/>
              </a:ext>
            </a:extLst>
          </p:cNvPr>
          <p:cNvSpPr/>
          <p:nvPr/>
        </p:nvSpPr>
        <p:spPr>
          <a:xfrm>
            <a:off x="8210965" y="1395516"/>
            <a:ext cx="1022488" cy="870606"/>
          </a:xfrm>
          <a:custGeom>
            <a:avLst/>
            <a:gdLst>
              <a:gd name="connsiteX0" fmla="*/ 377698 w 1044240"/>
              <a:gd name="connsiteY0" fmla="*/ 36890 h 861874"/>
              <a:gd name="connsiteX1" fmla="*/ 39767 w 1044240"/>
              <a:gd name="connsiteY1" fmla="*/ 384759 h 861874"/>
              <a:gd name="connsiteX2" fmla="*/ 29828 w 1044240"/>
              <a:gd name="connsiteY2" fmla="*/ 434455 h 861874"/>
              <a:gd name="connsiteX3" fmla="*/ 248489 w 1044240"/>
              <a:gd name="connsiteY3" fmla="*/ 504029 h 861874"/>
              <a:gd name="connsiteX4" fmla="*/ 407515 w 1044240"/>
              <a:gd name="connsiteY4" fmla="*/ 593481 h 861874"/>
              <a:gd name="connsiteX5" fmla="*/ 675871 w 1044240"/>
              <a:gd name="connsiteY5" fmla="*/ 772386 h 861874"/>
              <a:gd name="connsiteX6" fmla="*/ 775263 w 1044240"/>
              <a:gd name="connsiteY6" fmla="*/ 861838 h 861874"/>
              <a:gd name="connsiteX7" fmla="*/ 854776 w 1044240"/>
              <a:gd name="connsiteY7" fmla="*/ 782325 h 861874"/>
              <a:gd name="connsiteX8" fmla="*/ 993924 w 1044240"/>
              <a:gd name="connsiteY8" fmla="*/ 702812 h 861874"/>
              <a:gd name="connsiteX9" fmla="*/ 1033680 w 1044240"/>
              <a:gd name="connsiteY9" fmla="*/ 653116 h 861874"/>
              <a:gd name="connsiteX10" fmla="*/ 815019 w 1044240"/>
              <a:gd name="connsiteY10" fmla="*/ 434455 h 861874"/>
              <a:gd name="connsiteX11" fmla="*/ 715628 w 1044240"/>
              <a:gd name="connsiteY11" fmla="*/ 275429 h 861874"/>
              <a:gd name="connsiteX12" fmla="*/ 636115 w 1044240"/>
              <a:gd name="connsiteY12" fmla="*/ 176038 h 861874"/>
              <a:gd name="connsiteX13" fmla="*/ 437332 w 1044240"/>
              <a:gd name="connsiteY13" fmla="*/ 26951 h 861874"/>
              <a:gd name="connsiteX14" fmla="*/ 377698 w 1044240"/>
              <a:gd name="connsiteY14" fmla="*/ 36890 h 861874"/>
              <a:gd name="connsiteX0" fmla="*/ 377698 w 1044240"/>
              <a:gd name="connsiteY0" fmla="*/ 36890 h 861874"/>
              <a:gd name="connsiteX1" fmla="*/ 39767 w 1044240"/>
              <a:gd name="connsiteY1" fmla="*/ 384759 h 861874"/>
              <a:gd name="connsiteX2" fmla="*/ 29828 w 1044240"/>
              <a:gd name="connsiteY2" fmla="*/ 434455 h 861874"/>
              <a:gd name="connsiteX3" fmla="*/ 248489 w 1044240"/>
              <a:gd name="connsiteY3" fmla="*/ 504029 h 861874"/>
              <a:gd name="connsiteX4" fmla="*/ 407515 w 1044240"/>
              <a:gd name="connsiteY4" fmla="*/ 593481 h 861874"/>
              <a:gd name="connsiteX5" fmla="*/ 675871 w 1044240"/>
              <a:gd name="connsiteY5" fmla="*/ 772386 h 861874"/>
              <a:gd name="connsiteX6" fmla="*/ 775263 w 1044240"/>
              <a:gd name="connsiteY6" fmla="*/ 861838 h 861874"/>
              <a:gd name="connsiteX7" fmla="*/ 854776 w 1044240"/>
              <a:gd name="connsiteY7" fmla="*/ 782325 h 861874"/>
              <a:gd name="connsiteX8" fmla="*/ 993924 w 1044240"/>
              <a:gd name="connsiteY8" fmla="*/ 702812 h 861874"/>
              <a:gd name="connsiteX9" fmla="*/ 1033680 w 1044240"/>
              <a:gd name="connsiteY9" fmla="*/ 653116 h 861874"/>
              <a:gd name="connsiteX10" fmla="*/ 815019 w 1044240"/>
              <a:gd name="connsiteY10" fmla="*/ 434455 h 861874"/>
              <a:gd name="connsiteX11" fmla="*/ 636115 w 1044240"/>
              <a:gd name="connsiteY11" fmla="*/ 176038 h 861874"/>
              <a:gd name="connsiteX12" fmla="*/ 437332 w 1044240"/>
              <a:gd name="connsiteY12" fmla="*/ 26951 h 861874"/>
              <a:gd name="connsiteX13" fmla="*/ 377698 w 1044240"/>
              <a:gd name="connsiteY13" fmla="*/ 36890 h 861874"/>
              <a:gd name="connsiteX0" fmla="*/ 377698 w 1057095"/>
              <a:gd name="connsiteY0" fmla="*/ 36890 h 861874"/>
              <a:gd name="connsiteX1" fmla="*/ 39767 w 1057095"/>
              <a:gd name="connsiteY1" fmla="*/ 384759 h 861874"/>
              <a:gd name="connsiteX2" fmla="*/ 29828 w 1057095"/>
              <a:gd name="connsiteY2" fmla="*/ 434455 h 861874"/>
              <a:gd name="connsiteX3" fmla="*/ 248489 w 1057095"/>
              <a:gd name="connsiteY3" fmla="*/ 504029 h 861874"/>
              <a:gd name="connsiteX4" fmla="*/ 407515 w 1057095"/>
              <a:gd name="connsiteY4" fmla="*/ 593481 h 861874"/>
              <a:gd name="connsiteX5" fmla="*/ 675871 w 1057095"/>
              <a:gd name="connsiteY5" fmla="*/ 772386 h 861874"/>
              <a:gd name="connsiteX6" fmla="*/ 775263 w 1057095"/>
              <a:gd name="connsiteY6" fmla="*/ 861838 h 861874"/>
              <a:gd name="connsiteX7" fmla="*/ 854776 w 1057095"/>
              <a:gd name="connsiteY7" fmla="*/ 782325 h 861874"/>
              <a:gd name="connsiteX8" fmla="*/ 993924 w 1057095"/>
              <a:gd name="connsiteY8" fmla="*/ 702812 h 861874"/>
              <a:gd name="connsiteX9" fmla="*/ 1033680 w 1057095"/>
              <a:gd name="connsiteY9" fmla="*/ 653116 h 861874"/>
              <a:gd name="connsiteX10" fmla="*/ 636115 w 1057095"/>
              <a:gd name="connsiteY10" fmla="*/ 176038 h 861874"/>
              <a:gd name="connsiteX11" fmla="*/ 437332 w 1057095"/>
              <a:gd name="connsiteY11" fmla="*/ 26951 h 861874"/>
              <a:gd name="connsiteX12" fmla="*/ 377698 w 1057095"/>
              <a:gd name="connsiteY12" fmla="*/ 36890 h 861874"/>
              <a:gd name="connsiteX0" fmla="*/ 377698 w 1033680"/>
              <a:gd name="connsiteY0" fmla="*/ 36890 h 861874"/>
              <a:gd name="connsiteX1" fmla="*/ 39767 w 1033680"/>
              <a:gd name="connsiteY1" fmla="*/ 384759 h 861874"/>
              <a:gd name="connsiteX2" fmla="*/ 29828 w 1033680"/>
              <a:gd name="connsiteY2" fmla="*/ 434455 h 861874"/>
              <a:gd name="connsiteX3" fmla="*/ 248489 w 1033680"/>
              <a:gd name="connsiteY3" fmla="*/ 504029 h 861874"/>
              <a:gd name="connsiteX4" fmla="*/ 407515 w 1033680"/>
              <a:gd name="connsiteY4" fmla="*/ 593481 h 861874"/>
              <a:gd name="connsiteX5" fmla="*/ 675871 w 1033680"/>
              <a:gd name="connsiteY5" fmla="*/ 772386 h 861874"/>
              <a:gd name="connsiteX6" fmla="*/ 775263 w 1033680"/>
              <a:gd name="connsiteY6" fmla="*/ 861838 h 861874"/>
              <a:gd name="connsiteX7" fmla="*/ 854776 w 1033680"/>
              <a:gd name="connsiteY7" fmla="*/ 782325 h 861874"/>
              <a:gd name="connsiteX8" fmla="*/ 993924 w 1033680"/>
              <a:gd name="connsiteY8" fmla="*/ 702812 h 861874"/>
              <a:gd name="connsiteX9" fmla="*/ 1033680 w 1033680"/>
              <a:gd name="connsiteY9" fmla="*/ 653116 h 861874"/>
              <a:gd name="connsiteX10" fmla="*/ 636115 w 1033680"/>
              <a:gd name="connsiteY10" fmla="*/ 176038 h 861874"/>
              <a:gd name="connsiteX11" fmla="*/ 437332 w 1033680"/>
              <a:gd name="connsiteY11" fmla="*/ 26951 h 861874"/>
              <a:gd name="connsiteX12" fmla="*/ 377698 w 1033680"/>
              <a:gd name="connsiteY12" fmla="*/ 36890 h 861874"/>
              <a:gd name="connsiteX0" fmla="*/ 377698 w 1038705"/>
              <a:gd name="connsiteY0" fmla="*/ 36890 h 861881"/>
              <a:gd name="connsiteX1" fmla="*/ 39767 w 1038705"/>
              <a:gd name="connsiteY1" fmla="*/ 384759 h 861881"/>
              <a:gd name="connsiteX2" fmla="*/ 29828 w 1038705"/>
              <a:gd name="connsiteY2" fmla="*/ 434455 h 861881"/>
              <a:gd name="connsiteX3" fmla="*/ 248489 w 1038705"/>
              <a:gd name="connsiteY3" fmla="*/ 504029 h 861881"/>
              <a:gd name="connsiteX4" fmla="*/ 407515 w 1038705"/>
              <a:gd name="connsiteY4" fmla="*/ 593481 h 861881"/>
              <a:gd name="connsiteX5" fmla="*/ 675871 w 1038705"/>
              <a:gd name="connsiteY5" fmla="*/ 772386 h 861881"/>
              <a:gd name="connsiteX6" fmla="*/ 775263 w 1038705"/>
              <a:gd name="connsiteY6" fmla="*/ 861838 h 861881"/>
              <a:gd name="connsiteX7" fmla="*/ 854776 w 1038705"/>
              <a:gd name="connsiteY7" fmla="*/ 782325 h 861881"/>
              <a:gd name="connsiteX8" fmla="*/ 1033680 w 1038705"/>
              <a:gd name="connsiteY8" fmla="*/ 653116 h 861881"/>
              <a:gd name="connsiteX9" fmla="*/ 636115 w 1038705"/>
              <a:gd name="connsiteY9" fmla="*/ 176038 h 861881"/>
              <a:gd name="connsiteX10" fmla="*/ 437332 w 1038705"/>
              <a:gd name="connsiteY10" fmla="*/ 26951 h 861881"/>
              <a:gd name="connsiteX11" fmla="*/ 377698 w 1038705"/>
              <a:gd name="connsiteY11" fmla="*/ 36890 h 861881"/>
              <a:gd name="connsiteX0" fmla="*/ 377698 w 1033680"/>
              <a:gd name="connsiteY0" fmla="*/ 36890 h 861881"/>
              <a:gd name="connsiteX1" fmla="*/ 39767 w 1033680"/>
              <a:gd name="connsiteY1" fmla="*/ 384759 h 861881"/>
              <a:gd name="connsiteX2" fmla="*/ 29828 w 1033680"/>
              <a:gd name="connsiteY2" fmla="*/ 434455 h 861881"/>
              <a:gd name="connsiteX3" fmla="*/ 248489 w 1033680"/>
              <a:gd name="connsiteY3" fmla="*/ 504029 h 861881"/>
              <a:gd name="connsiteX4" fmla="*/ 407515 w 1033680"/>
              <a:gd name="connsiteY4" fmla="*/ 593481 h 861881"/>
              <a:gd name="connsiteX5" fmla="*/ 675871 w 1033680"/>
              <a:gd name="connsiteY5" fmla="*/ 772386 h 861881"/>
              <a:gd name="connsiteX6" fmla="*/ 775263 w 1033680"/>
              <a:gd name="connsiteY6" fmla="*/ 861838 h 861881"/>
              <a:gd name="connsiteX7" fmla="*/ 854776 w 1033680"/>
              <a:gd name="connsiteY7" fmla="*/ 782325 h 861881"/>
              <a:gd name="connsiteX8" fmla="*/ 1033680 w 1033680"/>
              <a:gd name="connsiteY8" fmla="*/ 653116 h 861881"/>
              <a:gd name="connsiteX9" fmla="*/ 636115 w 1033680"/>
              <a:gd name="connsiteY9" fmla="*/ 176038 h 861881"/>
              <a:gd name="connsiteX10" fmla="*/ 437332 w 1033680"/>
              <a:gd name="connsiteY10" fmla="*/ 26951 h 861881"/>
              <a:gd name="connsiteX11" fmla="*/ 377698 w 1033680"/>
              <a:gd name="connsiteY11" fmla="*/ 36890 h 861881"/>
              <a:gd name="connsiteX0" fmla="*/ 377698 w 1035371"/>
              <a:gd name="connsiteY0" fmla="*/ 36890 h 865537"/>
              <a:gd name="connsiteX1" fmla="*/ 39767 w 1035371"/>
              <a:gd name="connsiteY1" fmla="*/ 384759 h 865537"/>
              <a:gd name="connsiteX2" fmla="*/ 29828 w 1035371"/>
              <a:gd name="connsiteY2" fmla="*/ 434455 h 865537"/>
              <a:gd name="connsiteX3" fmla="*/ 248489 w 1035371"/>
              <a:gd name="connsiteY3" fmla="*/ 504029 h 865537"/>
              <a:gd name="connsiteX4" fmla="*/ 407515 w 1035371"/>
              <a:gd name="connsiteY4" fmla="*/ 593481 h 865537"/>
              <a:gd name="connsiteX5" fmla="*/ 675871 w 1035371"/>
              <a:gd name="connsiteY5" fmla="*/ 772386 h 865537"/>
              <a:gd name="connsiteX6" fmla="*/ 775263 w 1035371"/>
              <a:gd name="connsiteY6" fmla="*/ 861838 h 865537"/>
              <a:gd name="connsiteX7" fmla="*/ 1033680 w 1035371"/>
              <a:gd name="connsiteY7" fmla="*/ 653116 h 865537"/>
              <a:gd name="connsiteX8" fmla="*/ 636115 w 1035371"/>
              <a:gd name="connsiteY8" fmla="*/ 176038 h 865537"/>
              <a:gd name="connsiteX9" fmla="*/ 437332 w 1035371"/>
              <a:gd name="connsiteY9" fmla="*/ 26951 h 865537"/>
              <a:gd name="connsiteX10" fmla="*/ 377698 w 1035371"/>
              <a:gd name="connsiteY10" fmla="*/ 36890 h 865537"/>
              <a:gd name="connsiteX0" fmla="*/ 377698 w 1035616"/>
              <a:gd name="connsiteY0" fmla="*/ 36890 h 865537"/>
              <a:gd name="connsiteX1" fmla="*/ 39767 w 1035616"/>
              <a:gd name="connsiteY1" fmla="*/ 384759 h 865537"/>
              <a:gd name="connsiteX2" fmla="*/ 29828 w 1035616"/>
              <a:gd name="connsiteY2" fmla="*/ 434455 h 865537"/>
              <a:gd name="connsiteX3" fmla="*/ 248489 w 1035616"/>
              <a:gd name="connsiteY3" fmla="*/ 504029 h 865537"/>
              <a:gd name="connsiteX4" fmla="*/ 407515 w 1035616"/>
              <a:gd name="connsiteY4" fmla="*/ 593481 h 865537"/>
              <a:gd name="connsiteX5" fmla="*/ 675871 w 1035616"/>
              <a:gd name="connsiteY5" fmla="*/ 772386 h 865537"/>
              <a:gd name="connsiteX6" fmla="*/ 775263 w 1035616"/>
              <a:gd name="connsiteY6" fmla="*/ 861838 h 865537"/>
              <a:gd name="connsiteX7" fmla="*/ 1033680 w 1035616"/>
              <a:gd name="connsiteY7" fmla="*/ 653116 h 865537"/>
              <a:gd name="connsiteX8" fmla="*/ 636115 w 1035616"/>
              <a:gd name="connsiteY8" fmla="*/ 176038 h 865537"/>
              <a:gd name="connsiteX9" fmla="*/ 437332 w 1035616"/>
              <a:gd name="connsiteY9" fmla="*/ 26951 h 865537"/>
              <a:gd name="connsiteX10" fmla="*/ 377698 w 1035616"/>
              <a:gd name="connsiteY10" fmla="*/ 36890 h 865537"/>
              <a:gd name="connsiteX0" fmla="*/ 377698 w 1033680"/>
              <a:gd name="connsiteY0" fmla="*/ 36890 h 865537"/>
              <a:gd name="connsiteX1" fmla="*/ 39767 w 1033680"/>
              <a:gd name="connsiteY1" fmla="*/ 384759 h 865537"/>
              <a:gd name="connsiteX2" fmla="*/ 29828 w 1033680"/>
              <a:gd name="connsiteY2" fmla="*/ 434455 h 865537"/>
              <a:gd name="connsiteX3" fmla="*/ 248489 w 1033680"/>
              <a:gd name="connsiteY3" fmla="*/ 504029 h 865537"/>
              <a:gd name="connsiteX4" fmla="*/ 407515 w 1033680"/>
              <a:gd name="connsiteY4" fmla="*/ 593481 h 865537"/>
              <a:gd name="connsiteX5" fmla="*/ 675871 w 1033680"/>
              <a:gd name="connsiteY5" fmla="*/ 772386 h 865537"/>
              <a:gd name="connsiteX6" fmla="*/ 775263 w 1033680"/>
              <a:gd name="connsiteY6" fmla="*/ 861838 h 865537"/>
              <a:gd name="connsiteX7" fmla="*/ 1033680 w 1033680"/>
              <a:gd name="connsiteY7" fmla="*/ 653116 h 865537"/>
              <a:gd name="connsiteX8" fmla="*/ 636115 w 1033680"/>
              <a:gd name="connsiteY8" fmla="*/ 176038 h 865537"/>
              <a:gd name="connsiteX9" fmla="*/ 437332 w 1033680"/>
              <a:gd name="connsiteY9" fmla="*/ 26951 h 865537"/>
              <a:gd name="connsiteX10" fmla="*/ 377698 w 1033680"/>
              <a:gd name="connsiteY10" fmla="*/ 36890 h 865537"/>
              <a:gd name="connsiteX0" fmla="*/ 377698 w 1033680"/>
              <a:gd name="connsiteY0" fmla="*/ 36890 h 861838"/>
              <a:gd name="connsiteX1" fmla="*/ 39767 w 1033680"/>
              <a:gd name="connsiteY1" fmla="*/ 384759 h 861838"/>
              <a:gd name="connsiteX2" fmla="*/ 29828 w 1033680"/>
              <a:gd name="connsiteY2" fmla="*/ 434455 h 861838"/>
              <a:gd name="connsiteX3" fmla="*/ 248489 w 1033680"/>
              <a:gd name="connsiteY3" fmla="*/ 504029 h 861838"/>
              <a:gd name="connsiteX4" fmla="*/ 407515 w 1033680"/>
              <a:gd name="connsiteY4" fmla="*/ 593481 h 861838"/>
              <a:gd name="connsiteX5" fmla="*/ 675871 w 1033680"/>
              <a:gd name="connsiteY5" fmla="*/ 772386 h 861838"/>
              <a:gd name="connsiteX6" fmla="*/ 775263 w 1033680"/>
              <a:gd name="connsiteY6" fmla="*/ 861838 h 861838"/>
              <a:gd name="connsiteX7" fmla="*/ 1033680 w 1033680"/>
              <a:gd name="connsiteY7" fmla="*/ 653116 h 861838"/>
              <a:gd name="connsiteX8" fmla="*/ 636115 w 1033680"/>
              <a:gd name="connsiteY8" fmla="*/ 176038 h 861838"/>
              <a:gd name="connsiteX9" fmla="*/ 437332 w 1033680"/>
              <a:gd name="connsiteY9" fmla="*/ 26951 h 861838"/>
              <a:gd name="connsiteX10" fmla="*/ 377698 w 1033680"/>
              <a:gd name="connsiteY10" fmla="*/ 36890 h 861838"/>
              <a:gd name="connsiteX0" fmla="*/ 377698 w 1033680"/>
              <a:gd name="connsiteY0" fmla="*/ 52580 h 877528"/>
              <a:gd name="connsiteX1" fmla="*/ 39767 w 1033680"/>
              <a:gd name="connsiteY1" fmla="*/ 400449 h 877528"/>
              <a:gd name="connsiteX2" fmla="*/ 29828 w 1033680"/>
              <a:gd name="connsiteY2" fmla="*/ 450145 h 877528"/>
              <a:gd name="connsiteX3" fmla="*/ 248489 w 1033680"/>
              <a:gd name="connsiteY3" fmla="*/ 519719 h 877528"/>
              <a:gd name="connsiteX4" fmla="*/ 407515 w 1033680"/>
              <a:gd name="connsiteY4" fmla="*/ 609171 h 877528"/>
              <a:gd name="connsiteX5" fmla="*/ 675871 w 1033680"/>
              <a:gd name="connsiteY5" fmla="*/ 788076 h 877528"/>
              <a:gd name="connsiteX6" fmla="*/ 775263 w 1033680"/>
              <a:gd name="connsiteY6" fmla="*/ 877528 h 877528"/>
              <a:gd name="connsiteX7" fmla="*/ 1033680 w 1033680"/>
              <a:gd name="connsiteY7" fmla="*/ 668806 h 877528"/>
              <a:gd name="connsiteX8" fmla="*/ 636115 w 1033680"/>
              <a:gd name="connsiteY8" fmla="*/ 191728 h 877528"/>
              <a:gd name="connsiteX9" fmla="*/ 420664 w 1033680"/>
              <a:gd name="connsiteY9" fmla="*/ 16447 h 877528"/>
              <a:gd name="connsiteX10" fmla="*/ 377698 w 1033680"/>
              <a:gd name="connsiteY10" fmla="*/ 52580 h 877528"/>
              <a:gd name="connsiteX0" fmla="*/ 423440 w 1036456"/>
              <a:gd name="connsiteY0" fmla="*/ 0 h 861081"/>
              <a:gd name="connsiteX1" fmla="*/ 42543 w 1036456"/>
              <a:gd name="connsiteY1" fmla="*/ 384002 h 861081"/>
              <a:gd name="connsiteX2" fmla="*/ 32604 w 1036456"/>
              <a:gd name="connsiteY2" fmla="*/ 433698 h 861081"/>
              <a:gd name="connsiteX3" fmla="*/ 251265 w 1036456"/>
              <a:gd name="connsiteY3" fmla="*/ 503272 h 861081"/>
              <a:gd name="connsiteX4" fmla="*/ 410291 w 1036456"/>
              <a:gd name="connsiteY4" fmla="*/ 592724 h 861081"/>
              <a:gd name="connsiteX5" fmla="*/ 678647 w 1036456"/>
              <a:gd name="connsiteY5" fmla="*/ 771629 h 861081"/>
              <a:gd name="connsiteX6" fmla="*/ 778039 w 1036456"/>
              <a:gd name="connsiteY6" fmla="*/ 861081 h 861081"/>
              <a:gd name="connsiteX7" fmla="*/ 1036456 w 1036456"/>
              <a:gd name="connsiteY7" fmla="*/ 652359 h 861081"/>
              <a:gd name="connsiteX8" fmla="*/ 638891 w 1036456"/>
              <a:gd name="connsiteY8" fmla="*/ 175281 h 861081"/>
              <a:gd name="connsiteX9" fmla="*/ 423440 w 1036456"/>
              <a:gd name="connsiteY9" fmla="*/ 0 h 861081"/>
              <a:gd name="connsiteX0" fmla="*/ 423440 w 1036456"/>
              <a:gd name="connsiteY0" fmla="*/ 0 h 870606"/>
              <a:gd name="connsiteX1" fmla="*/ 42543 w 1036456"/>
              <a:gd name="connsiteY1" fmla="*/ 393527 h 870606"/>
              <a:gd name="connsiteX2" fmla="*/ 32604 w 1036456"/>
              <a:gd name="connsiteY2" fmla="*/ 443223 h 870606"/>
              <a:gd name="connsiteX3" fmla="*/ 251265 w 1036456"/>
              <a:gd name="connsiteY3" fmla="*/ 512797 h 870606"/>
              <a:gd name="connsiteX4" fmla="*/ 410291 w 1036456"/>
              <a:gd name="connsiteY4" fmla="*/ 602249 h 870606"/>
              <a:gd name="connsiteX5" fmla="*/ 678647 w 1036456"/>
              <a:gd name="connsiteY5" fmla="*/ 781154 h 870606"/>
              <a:gd name="connsiteX6" fmla="*/ 778039 w 1036456"/>
              <a:gd name="connsiteY6" fmla="*/ 870606 h 870606"/>
              <a:gd name="connsiteX7" fmla="*/ 1036456 w 1036456"/>
              <a:gd name="connsiteY7" fmla="*/ 661884 h 870606"/>
              <a:gd name="connsiteX8" fmla="*/ 638891 w 1036456"/>
              <a:gd name="connsiteY8" fmla="*/ 184806 h 870606"/>
              <a:gd name="connsiteX9" fmla="*/ 423440 w 1036456"/>
              <a:gd name="connsiteY9" fmla="*/ 0 h 870606"/>
              <a:gd name="connsiteX0" fmla="*/ 423440 w 1036456"/>
              <a:gd name="connsiteY0" fmla="*/ 0 h 870606"/>
              <a:gd name="connsiteX1" fmla="*/ 42543 w 1036456"/>
              <a:gd name="connsiteY1" fmla="*/ 393527 h 870606"/>
              <a:gd name="connsiteX2" fmla="*/ 32604 w 1036456"/>
              <a:gd name="connsiteY2" fmla="*/ 443223 h 870606"/>
              <a:gd name="connsiteX3" fmla="*/ 251265 w 1036456"/>
              <a:gd name="connsiteY3" fmla="*/ 512797 h 870606"/>
              <a:gd name="connsiteX4" fmla="*/ 410291 w 1036456"/>
              <a:gd name="connsiteY4" fmla="*/ 602249 h 870606"/>
              <a:gd name="connsiteX5" fmla="*/ 678647 w 1036456"/>
              <a:gd name="connsiteY5" fmla="*/ 781154 h 870606"/>
              <a:gd name="connsiteX6" fmla="*/ 778039 w 1036456"/>
              <a:gd name="connsiteY6" fmla="*/ 870606 h 870606"/>
              <a:gd name="connsiteX7" fmla="*/ 1036456 w 1036456"/>
              <a:gd name="connsiteY7" fmla="*/ 661884 h 870606"/>
              <a:gd name="connsiteX8" fmla="*/ 638891 w 1036456"/>
              <a:gd name="connsiteY8" fmla="*/ 184806 h 870606"/>
              <a:gd name="connsiteX9" fmla="*/ 423440 w 1036456"/>
              <a:gd name="connsiteY9" fmla="*/ 0 h 870606"/>
              <a:gd name="connsiteX0" fmla="*/ 442637 w 1055653"/>
              <a:gd name="connsiteY0" fmla="*/ 0 h 870606"/>
              <a:gd name="connsiteX1" fmla="*/ 33165 w 1055653"/>
              <a:gd name="connsiteY1" fmla="*/ 422102 h 870606"/>
              <a:gd name="connsiteX2" fmla="*/ 51801 w 1055653"/>
              <a:gd name="connsiteY2" fmla="*/ 443223 h 870606"/>
              <a:gd name="connsiteX3" fmla="*/ 270462 w 1055653"/>
              <a:gd name="connsiteY3" fmla="*/ 512797 h 870606"/>
              <a:gd name="connsiteX4" fmla="*/ 429488 w 1055653"/>
              <a:gd name="connsiteY4" fmla="*/ 602249 h 870606"/>
              <a:gd name="connsiteX5" fmla="*/ 697844 w 1055653"/>
              <a:gd name="connsiteY5" fmla="*/ 781154 h 870606"/>
              <a:gd name="connsiteX6" fmla="*/ 797236 w 1055653"/>
              <a:gd name="connsiteY6" fmla="*/ 870606 h 870606"/>
              <a:gd name="connsiteX7" fmla="*/ 1055653 w 1055653"/>
              <a:gd name="connsiteY7" fmla="*/ 661884 h 870606"/>
              <a:gd name="connsiteX8" fmla="*/ 658088 w 1055653"/>
              <a:gd name="connsiteY8" fmla="*/ 184806 h 870606"/>
              <a:gd name="connsiteX9" fmla="*/ 442637 w 1055653"/>
              <a:gd name="connsiteY9" fmla="*/ 0 h 870606"/>
              <a:gd name="connsiteX0" fmla="*/ 412271 w 1025287"/>
              <a:gd name="connsiteY0" fmla="*/ 0 h 870606"/>
              <a:gd name="connsiteX1" fmla="*/ 2799 w 1025287"/>
              <a:gd name="connsiteY1" fmla="*/ 422102 h 870606"/>
              <a:gd name="connsiteX2" fmla="*/ 240096 w 1025287"/>
              <a:gd name="connsiteY2" fmla="*/ 512797 h 870606"/>
              <a:gd name="connsiteX3" fmla="*/ 399122 w 1025287"/>
              <a:gd name="connsiteY3" fmla="*/ 602249 h 870606"/>
              <a:gd name="connsiteX4" fmla="*/ 667478 w 1025287"/>
              <a:gd name="connsiteY4" fmla="*/ 781154 h 870606"/>
              <a:gd name="connsiteX5" fmla="*/ 766870 w 1025287"/>
              <a:gd name="connsiteY5" fmla="*/ 870606 h 870606"/>
              <a:gd name="connsiteX6" fmla="*/ 1025287 w 1025287"/>
              <a:gd name="connsiteY6" fmla="*/ 661884 h 870606"/>
              <a:gd name="connsiteX7" fmla="*/ 627722 w 1025287"/>
              <a:gd name="connsiteY7" fmla="*/ 184806 h 870606"/>
              <a:gd name="connsiteX8" fmla="*/ 412271 w 1025287"/>
              <a:gd name="connsiteY8" fmla="*/ 0 h 870606"/>
              <a:gd name="connsiteX0" fmla="*/ 409472 w 1022488"/>
              <a:gd name="connsiteY0" fmla="*/ 0 h 870606"/>
              <a:gd name="connsiteX1" fmla="*/ 0 w 1022488"/>
              <a:gd name="connsiteY1" fmla="*/ 422102 h 870606"/>
              <a:gd name="connsiteX2" fmla="*/ 237297 w 1022488"/>
              <a:gd name="connsiteY2" fmla="*/ 512797 h 870606"/>
              <a:gd name="connsiteX3" fmla="*/ 396323 w 1022488"/>
              <a:gd name="connsiteY3" fmla="*/ 602249 h 870606"/>
              <a:gd name="connsiteX4" fmla="*/ 664679 w 1022488"/>
              <a:gd name="connsiteY4" fmla="*/ 781154 h 870606"/>
              <a:gd name="connsiteX5" fmla="*/ 764071 w 1022488"/>
              <a:gd name="connsiteY5" fmla="*/ 870606 h 870606"/>
              <a:gd name="connsiteX6" fmla="*/ 1022488 w 1022488"/>
              <a:gd name="connsiteY6" fmla="*/ 661884 h 870606"/>
              <a:gd name="connsiteX7" fmla="*/ 624923 w 1022488"/>
              <a:gd name="connsiteY7" fmla="*/ 184806 h 870606"/>
              <a:gd name="connsiteX8" fmla="*/ 409472 w 1022488"/>
              <a:gd name="connsiteY8" fmla="*/ 0 h 870606"/>
              <a:gd name="connsiteX0" fmla="*/ 409472 w 1022488"/>
              <a:gd name="connsiteY0" fmla="*/ 0 h 870606"/>
              <a:gd name="connsiteX1" fmla="*/ 0 w 1022488"/>
              <a:gd name="connsiteY1" fmla="*/ 422102 h 870606"/>
              <a:gd name="connsiteX2" fmla="*/ 237297 w 1022488"/>
              <a:gd name="connsiteY2" fmla="*/ 512797 h 870606"/>
              <a:gd name="connsiteX3" fmla="*/ 396323 w 1022488"/>
              <a:gd name="connsiteY3" fmla="*/ 602249 h 870606"/>
              <a:gd name="connsiteX4" fmla="*/ 764071 w 1022488"/>
              <a:gd name="connsiteY4" fmla="*/ 870606 h 870606"/>
              <a:gd name="connsiteX5" fmla="*/ 1022488 w 1022488"/>
              <a:gd name="connsiteY5" fmla="*/ 661884 h 870606"/>
              <a:gd name="connsiteX6" fmla="*/ 624923 w 1022488"/>
              <a:gd name="connsiteY6" fmla="*/ 184806 h 870606"/>
              <a:gd name="connsiteX7" fmla="*/ 409472 w 1022488"/>
              <a:gd name="connsiteY7" fmla="*/ 0 h 870606"/>
              <a:gd name="connsiteX0" fmla="*/ 409472 w 1022488"/>
              <a:gd name="connsiteY0" fmla="*/ 0 h 885956"/>
              <a:gd name="connsiteX1" fmla="*/ 0 w 1022488"/>
              <a:gd name="connsiteY1" fmla="*/ 422102 h 885956"/>
              <a:gd name="connsiteX2" fmla="*/ 237297 w 1022488"/>
              <a:gd name="connsiteY2" fmla="*/ 512797 h 885956"/>
              <a:gd name="connsiteX3" fmla="*/ 396323 w 1022488"/>
              <a:gd name="connsiteY3" fmla="*/ 602249 h 885956"/>
              <a:gd name="connsiteX4" fmla="*/ 764071 w 1022488"/>
              <a:gd name="connsiteY4" fmla="*/ 870606 h 885956"/>
              <a:gd name="connsiteX5" fmla="*/ 1022488 w 1022488"/>
              <a:gd name="connsiteY5" fmla="*/ 661884 h 885956"/>
              <a:gd name="connsiteX6" fmla="*/ 624923 w 1022488"/>
              <a:gd name="connsiteY6" fmla="*/ 184806 h 885956"/>
              <a:gd name="connsiteX7" fmla="*/ 409472 w 1022488"/>
              <a:gd name="connsiteY7" fmla="*/ 0 h 885956"/>
              <a:gd name="connsiteX0" fmla="*/ 409472 w 1022488"/>
              <a:gd name="connsiteY0" fmla="*/ 0 h 870606"/>
              <a:gd name="connsiteX1" fmla="*/ 0 w 1022488"/>
              <a:gd name="connsiteY1" fmla="*/ 422102 h 870606"/>
              <a:gd name="connsiteX2" fmla="*/ 237297 w 1022488"/>
              <a:gd name="connsiteY2" fmla="*/ 512797 h 870606"/>
              <a:gd name="connsiteX3" fmla="*/ 396323 w 1022488"/>
              <a:gd name="connsiteY3" fmla="*/ 602249 h 870606"/>
              <a:gd name="connsiteX4" fmla="*/ 764071 w 1022488"/>
              <a:gd name="connsiteY4" fmla="*/ 870606 h 870606"/>
              <a:gd name="connsiteX5" fmla="*/ 1022488 w 1022488"/>
              <a:gd name="connsiteY5" fmla="*/ 661884 h 870606"/>
              <a:gd name="connsiteX6" fmla="*/ 624923 w 1022488"/>
              <a:gd name="connsiteY6" fmla="*/ 184806 h 870606"/>
              <a:gd name="connsiteX7" fmla="*/ 409472 w 1022488"/>
              <a:gd name="connsiteY7" fmla="*/ 0 h 87060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1022488" h="870606">
                <a:moveTo>
                  <a:pt x="409472" y="0"/>
                </a:moveTo>
                <a:cubicBezTo>
                  <a:pt x="321987" y="77649"/>
                  <a:pt x="28696" y="336636"/>
                  <a:pt x="0" y="422102"/>
                </a:cubicBezTo>
                <a:cubicBezTo>
                  <a:pt x="104654" y="462324"/>
                  <a:pt x="171243" y="482773"/>
                  <a:pt x="237297" y="512797"/>
                </a:cubicBezTo>
                <a:cubicBezTo>
                  <a:pt x="303351" y="542821"/>
                  <a:pt x="308527" y="542614"/>
                  <a:pt x="396323" y="602249"/>
                </a:cubicBezTo>
                <a:cubicBezTo>
                  <a:pt x="484119" y="661884"/>
                  <a:pt x="621610" y="770179"/>
                  <a:pt x="764071" y="870606"/>
                </a:cubicBezTo>
                <a:cubicBezTo>
                  <a:pt x="895732" y="771551"/>
                  <a:pt x="917092" y="766659"/>
                  <a:pt x="1022488" y="661884"/>
                </a:cubicBezTo>
                <a:cubicBezTo>
                  <a:pt x="962853" y="574088"/>
                  <a:pt x="724314" y="289167"/>
                  <a:pt x="624923" y="184806"/>
                </a:cubicBezTo>
                <a:cubicBezTo>
                  <a:pt x="578540" y="143393"/>
                  <a:pt x="409472" y="0"/>
                  <a:pt x="409472" y="0"/>
                </a:cubicBezTo>
                <a:close/>
              </a:path>
            </a:pathLst>
          </a:custGeom>
          <a:noFill/>
          <a:ln w="28575">
            <a:solidFill>
              <a:schemeClr val="bg1"/>
            </a:solidFill>
            <a:prstDash val="sys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CH" dirty="0"/>
          </a:p>
        </p:txBody>
      </p:sp>
      <p:sp>
        <p:nvSpPr>
          <p:cNvPr id="5" name="Rechteck 4">
            <a:extLst>
              <a:ext uri="{FF2B5EF4-FFF2-40B4-BE49-F238E27FC236}">
                <a16:creationId xmlns:a16="http://schemas.microsoft.com/office/drawing/2014/main" id="{A5741CBB-9619-AE00-5A05-EE3C8DBE1D3F}"/>
              </a:ext>
            </a:extLst>
          </p:cNvPr>
          <p:cNvSpPr/>
          <p:nvPr/>
        </p:nvSpPr>
        <p:spPr>
          <a:xfrm>
            <a:off x="8260161" y="691601"/>
            <a:ext cx="1727811" cy="465079"/>
          </a:xfrm>
          <a:prstGeom prst="rect">
            <a:avLst/>
          </a:prstGeom>
          <a:solidFill>
            <a:schemeClr val="tx1">
              <a:lumMod val="65000"/>
              <a:lumOff val="3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CH" dirty="0"/>
          </a:p>
        </p:txBody>
      </p:sp>
      <p:sp>
        <p:nvSpPr>
          <p:cNvPr id="6" name="Rechteck 5">
            <a:extLst>
              <a:ext uri="{FF2B5EF4-FFF2-40B4-BE49-F238E27FC236}">
                <a16:creationId xmlns:a16="http://schemas.microsoft.com/office/drawing/2014/main" id="{28B4CE37-DBB5-E7F7-836C-CF18EDFDCAB6}"/>
              </a:ext>
            </a:extLst>
          </p:cNvPr>
          <p:cNvSpPr/>
          <p:nvPr/>
        </p:nvSpPr>
        <p:spPr>
          <a:xfrm>
            <a:off x="8207944" y="5586241"/>
            <a:ext cx="1727811" cy="514560"/>
          </a:xfrm>
          <a:prstGeom prst="rect">
            <a:avLst/>
          </a:prstGeom>
          <a:solidFill>
            <a:schemeClr val="tx1">
              <a:lumMod val="65000"/>
              <a:lumOff val="3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CH"/>
          </a:p>
        </p:txBody>
      </p:sp>
      <p:sp>
        <p:nvSpPr>
          <p:cNvPr id="21" name="Textfeld 1">
            <a:extLst>
              <a:ext uri="{FF2B5EF4-FFF2-40B4-BE49-F238E27FC236}">
                <a16:creationId xmlns:a16="http://schemas.microsoft.com/office/drawing/2014/main" id="{D348ED7A-25B7-B846-831D-9B10784C9778}"/>
              </a:ext>
            </a:extLst>
          </p:cNvPr>
          <p:cNvSpPr txBox="1"/>
          <p:nvPr/>
        </p:nvSpPr>
        <p:spPr>
          <a:xfrm>
            <a:off x="228601" y="444500"/>
            <a:ext cx="1307838" cy="646331"/>
          </a:xfrm>
          <a:prstGeom prst="rect">
            <a:avLst/>
          </a:prstGeom>
          <a:noFill/>
        </p:spPr>
        <p:txBody>
          <a:bodyPr wrap="square" rtlCol="0">
            <a:spAutoFit/>
          </a:bodyPr>
          <a:lstStyle/>
          <a:p>
            <a:r>
              <a:rPr lang="de-CH" dirty="0"/>
              <a:t>Appendix 2, </a:t>
            </a:r>
            <a:r>
              <a:rPr lang="de-CH" dirty="0" err="1"/>
              <a:t>figure</a:t>
            </a:r>
            <a:r>
              <a:rPr lang="de-CH" dirty="0"/>
              <a:t> 4 D</a:t>
            </a:r>
          </a:p>
        </p:txBody>
      </p:sp>
    </p:spTree>
    <p:extLst>
      <p:ext uri="{BB962C8B-B14F-4D97-AF65-F5344CB8AC3E}">
        <p14:creationId xmlns:p14="http://schemas.microsoft.com/office/powerpoint/2010/main" val="149673487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lcf76f155ced4ddcb4097134ff3c332f xmlns="cc04e1e6-71af-4351-a84c-6bf991172af3">
      <Terms xmlns="http://schemas.microsoft.com/office/infopath/2007/PartnerControls"/>
    </lcf76f155ced4ddcb4097134ff3c332f>
    <TaxCatchAll xmlns="92dd3154-eeee-4010-9448-7d129f33e12f" xsi:nil="true"/>
  </documentManagement>
</p:properties>
</file>

<file path=customXml/item2.xml><?xml version="1.0" encoding="utf-8"?>
<ct:contentTypeSchema xmlns:ct="http://schemas.microsoft.com/office/2006/metadata/contentType" xmlns:ma="http://schemas.microsoft.com/office/2006/metadata/properties/metaAttributes" ct:_="" ma:_="" ma:contentTypeName="Dokument" ma:contentTypeID="0x010100F6F64F3A035C784E83AB0500D5A4703A" ma:contentTypeVersion="13" ma:contentTypeDescription="Ein neues Dokument erstellen." ma:contentTypeScope="" ma:versionID="2043bf6bfdf551cd299d7c80f58a1577">
  <xsd:schema xmlns:xsd="http://www.w3.org/2001/XMLSchema" xmlns:xs="http://www.w3.org/2001/XMLSchema" xmlns:p="http://schemas.microsoft.com/office/2006/metadata/properties" xmlns:ns2="cc04e1e6-71af-4351-a84c-6bf991172af3" xmlns:ns3="92dd3154-eeee-4010-9448-7d129f33e12f" targetNamespace="http://schemas.microsoft.com/office/2006/metadata/properties" ma:root="true" ma:fieldsID="85f44a0ef4355ad6ccb6b1351b3ffbe0" ns2:_="" ns3:_="">
    <xsd:import namespace="cc04e1e6-71af-4351-a84c-6bf991172af3"/>
    <xsd:import namespace="92dd3154-eeee-4010-9448-7d129f33e12f"/>
    <xsd:element name="properties">
      <xsd:complexType>
        <xsd:sequence>
          <xsd:element name="documentManagement">
            <xsd:complexType>
              <xsd:all>
                <xsd:element ref="ns2:MediaServiceMetadata" minOccurs="0"/>
                <xsd:element ref="ns2:MediaServiceFastMetadata" minOccurs="0"/>
                <xsd:element ref="ns2:MediaServiceSearchProperties" minOccurs="0"/>
                <xsd:element ref="ns2:MediaServiceDateTaken" minOccurs="0"/>
                <xsd:element ref="ns2:MediaServiceObjectDetectorVersions" minOccurs="0"/>
                <xsd:element ref="ns2:MediaServiceGenerationTime" minOccurs="0"/>
                <xsd:element ref="ns2:MediaServiceEventHashCode" minOccurs="0"/>
                <xsd:element ref="ns2:MediaLengthInSeconds" minOccurs="0"/>
                <xsd:element ref="ns2:lcf76f155ced4ddcb4097134ff3c332f" minOccurs="0"/>
                <xsd:element ref="ns3:TaxCatchAll" minOccurs="0"/>
                <xsd:element ref="ns2:MediaServiceOCR" minOccurs="0"/>
                <xsd:element ref="ns2:MediaServiceLocation"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cc04e1e6-71af-4351-a84c-6bf991172af3"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SearchProperties" ma:index="10" nillable="true" ma:displayName="MediaServiceSearchProperties" ma:hidden="true" ma:internalName="MediaServiceSearchProperties" ma:readOnly="true">
      <xsd:simpleType>
        <xsd:restriction base="dms:Note"/>
      </xsd:simpleType>
    </xsd:element>
    <xsd:element name="MediaServiceDateTaken" ma:index="11" nillable="true" ma:displayName="MediaServiceDateTaken" ma:description="" ma:hidden="true" ma:indexed="true" ma:internalName="MediaServiceDateTaken" ma:readOnly="true">
      <xsd:simpleType>
        <xsd:restriction base="dms:Text"/>
      </xsd:simpleType>
    </xsd:element>
    <xsd:element name="MediaServiceObjectDetectorVersions" ma:index="12" nillable="true" ma:displayName="MediaServiceObjectDetectorVersions" ma:description="" ma:hidden="true" ma:indexed="true" ma:internalName="MediaServiceObjectDetectorVersions" ma:readOnly="true">
      <xsd:simpleType>
        <xsd:restriction base="dms:Text"/>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EventHashCode" ma:index="14" nillable="true" ma:displayName="MediaServiceEventHashCode" ma:hidden="true" ma:internalName="MediaServiceEventHashCode" ma:readOnly="true">
      <xsd:simpleType>
        <xsd:restriction base="dms:Text"/>
      </xsd:simpleType>
    </xsd:element>
    <xsd:element name="MediaLengthInSeconds" ma:index="15" nillable="true" ma:displayName="MediaLengthInSeconds" ma:hidden="true" ma:internalName="MediaLengthInSeconds" ma:readOnly="true">
      <xsd:simpleType>
        <xsd:restriction base="dms:Unknown"/>
      </xsd:simpleType>
    </xsd:element>
    <xsd:element name="lcf76f155ced4ddcb4097134ff3c332f" ma:index="17" nillable="true" ma:taxonomy="true" ma:internalName="lcf76f155ced4ddcb4097134ff3c332f" ma:taxonomyFieldName="MediaServiceImageTags" ma:displayName="Bildmarkierungen" ma:readOnly="false" ma:fieldId="{5cf76f15-5ced-4ddc-b409-7134ff3c332f}" ma:taxonomyMulti="true" ma:sspId="4fb58666-e629-4e5a-b780-b8dcc15b318b" ma:termSetId="09814cd3-568e-fe90-9814-8d621ff8fb84" ma:anchorId="fba54fb3-c3e1-fe81-a776-ca4b69148c4d" ma:open="true" ma:isKeyword="false">
      <xsd:complexType>
        <xsd:sequence>
          <xsd:element ref="pc:Terms" minOccurs="0" maxOccurs="1"/>
        </xsd:sequence>
      </xsd:complexType>
    </xsd:element>
    <xsd:element name="MediaServiceOCR" ma:index="19" nillable="true" ma:displayName="Extracted Text" ma:internalName="MediaServiceOCR" ma:readOnly="true">
      <xsd:simpleType>
        <xsd:restriction base="dms:Note">
          <xsd:maxLength value="255"/>
        </xsd:restriction>
      </xsd:simpleType>
    </xsd:element>
    <xsd:element name="MediaServiceLocation" ma:index="20" nillable="true" ma:displayName="Location" ma:description="" ma:indexed="true" ma:internalName="MediaServiceLocation"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92dd3154-eeee-4010-9448-7d129f33e12f" elementFormDefault="qualified">
    <xsd:import namespace="http://schemas.microsoft.com/office/2006/documentManagement/types"/>
    <xsd:import namespace="http://schemas.microsoft.com/office/infopath/2007/PartnerControls"/>
    <xsd:element name="TaxCatchAll" ma:index="18" nillable="true" ma:displayName="Taxonomy Catch All Column" ma:hidden="true" ma:list="{ebfa340f-9147-47bc-9ea0-03d44da477a8}" ma:internalName="TaxCatchAll" ma:showField="CatchAllData" ma:web="92dd3154-eeee-4010-9448-7d129f33e12f">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Inhaltstyp"/>
        <xsd:element ref="dc:title" minOccurs="0" maxOccurs="1" ma:index="4" ma:displayName="Titel"/>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957FDB92-867E-4A34-B5A8-DD2EEE2B7BC7}">
  <ds:schemaRefs>
    <ds:schemaRef ds:uri="http://purl.org/dc/dcmitype/"/>
    <ds:schemaRef ds:uri="cc04e1e6-71af-4351-a84c-6bf991172af3"/>
    <ds:schemaRef ds:uri="http://schemas.openxmlformats.org/package/2006/metadata/core-properties"/>
    <ds:schemaRef ds:uri="http://schemas.microsoft.com/office/infopath/2007/PartnerControls"/>
    <ds:schemaRef ds:uri="http://purl.org/dc/terms/"/>
    <ds:schemaRef ds:uri="92dd3154-eeee-4010-9448-7d129f33e12f"/>
    <ds:schemaRef ds:uri="http://www.w3.org/XML/1998/namespace"/>
    <ds:schemaRef ds:uri="http://schemas.microsoft.com/office/2006/documentManagement/types"/>
    <ds:schemaRef ds:uri="http://schemas.microsoft.com/office/2006/metadata/properties"/>
    <ds:schemaRef ds:uri="http://purl.org/dc/elements/1.1/"/>
  </ds:schemaRefs>
</ds:datastoreItem>
</file>

<file path=customXml/itemProps2.xml><?xml version="1.0" encoding="utf-8"?>
<ds:datastoreItem xmlns:ds="http://schemas.openxmlformats.org/officeDocument/2006/customXml" ds:itemID="{B01C468F-9539-4D35-95C9-33BE95795970}">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cc04e1e6-71af-4351-a84c-6bf991172af3"/>
    <ds:schemaRef ds:uri="92dd3154-eeee-4010-9448-7d129f33e12f"/>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568888B0-7F7F-4A0D-B96F-45D7D0E75E30}">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0</TotalTime>
  <Words>658</Words>
  <Application>Microsoft Office PowerPoint</Application>
  <PresentationFormat>Breitbild</PresentationFormat>
  <Paragraphs>26</Paragraphs>
  <Slides>8</Slides>
  <Notes>2</Notes>
  <HiddenSlides>0</HiddenSlides>
  <MMClips>0</MMClips>
  <ScaleCrop>false</ScaleCrop>
  <HeadingPairs>
    <vt:vector size="6" baseType="variant">
      <vt:variant>
        <vt:lpstr>Verwendete Schriftarten</vt:lpstr>
      </vt:variant>
      <vt:variant>
        <vt:i4>4</vt:i4>
      </vt:variant>
      <vt:variant>
        <vt:lpstr>Design</vt:lpstr>
      </vt:variant>
      <vt:variant>
        <vt:i4>1</vt:i4>
      </vt:variant>
      <vt:variant>
        <vt:lpstr>Folientitel</vt:lpstr>
      </vt:variant>
      <vt:variant>
        <vt:i4>8</vt:i4>
      </vt:variant>
    </vt:vector>
  </HeadingPairs>
  <TitlesOfParts>
    <vt:vector size="13" baseType="lpstr">
      <vt:lpstr>Arial</vt:lpstr>
      <vt:lpstr>Calibri</vt:lpstr>
      <vt:lpstr>Calibri Light</vt:lpstr>
      <vt:lpstr>Times New Roman</vt:lpstr>
      <vt:lpstr>Office Theme</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lisabeth Althaus</dc:creator>
  <cp:lastModifiedBy>Haveman Roelien</cp:lastModifiedBy>
  <cp:revision>3</cp:revision>
  <cp:lastPrinted>2024-10-16T10:30:55Z</cp:lastPrinted>
  <dcterms:created xsi:type="dcterms:W3CDTF">2024-08-08T19:19:40Z</dcterms:created>
  <dcterms:modified xsi:type="dcterms:W3CDTF">2024-11-11T12:38:3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F6F64F3A035C784E83AB0500D5A4703A</vt:lpwstr>
  </property>
  <property fmtid="{D5CDD505-2E9C-101B-9397-08002B2CF9AE}" pid="3" name="MediaServiceImageTags">
    <vt:lpwstr/>
  </property>
</Properties>
</file>